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1"/>
  </p:notesMasterIdLst>
  <p:sldIdLst>
    <p:sldId id="256" r:id="rId2"/>
    <p:sldId id="278" r:id="rId3"/>
    <p:sldId id="297" r:id="rId4"/>
    <p:sldId id="303" r:id="rId5"/>
    <p:sldId id="302" r:id="rId6"/>
    <p:sldId id="294" r:id="rId7"/>
    <p:sldId id="299" r:id="rId8"/>
    <p:sldId id="300" r:id="rId9"/>
    <p:sldId id="305" r:id="rId10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AAD161-3FB8-4B00-ABEB-A402EB296163}" v="9" dt="2022-07-20T13:51:27.72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1411" autoAdjust="0"/>
  </p:normalViewPr>
  <p:slideViewPr>
    <p:cSldViewPr snapToGrid="0">
      <p:cViewPr varScale="1">
        <p:scale>
          <a:sx n="42" d="100"/>
          <a:sy n="42" d="100"/>
        </p:scale>
        <p:origin x="2837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ene Clark" userId="e32ce294cf8df570" providerId="LiveId" clId="{E0AAD161-3FB8-4B00-ABEB-A402EB296163}"/>
    <pc:docChg chg="undo custSel modSld">
      <pc:chgData name="Gene Clark" userId="e32ce294cf8df570" providerId="LiveId" clId="{E0AAD161-3FB8-4B00-ABEB-A402EB296163}" dt="2022-07-20T15:06:28.388" v="183" actId="478"/>
      <pc:docMkLst>
        <pc:docMk/>
      </pc:docMkLst>
      <pc:sldChg chg="addSp delSp modSp mod modNotesTx">
        <pc:chgData name="Gene Clark" userId="e32ce294cf8df570" providerId="LiveId" clId="{E0AAD161-3FB8-4B00-ABEB-A402EB296163}" dt="2022-07-20T15:06:28.388" v="183" actId="478"/>
        <pc:sldMkLst>
          <pc:docMk/>
          <pc:sldMk cId="1676650102" sldId="278"/>
        </pc:sldMkLst>
        <pc:spChg chg="mod">
          <ac:chgData name="Gene Clark" userId="e32ce294cf8df570" providerId="LiveId" clId="{E0AAD161-3FB8-4B00-ABEB-A402EB296163}" dt="2022-07-20T13:33:35.685" v="7" actId="1076"/>
          <ac:spMkLst>
            <pc:docMk/>
            <pc:sldMk cId="1676650102" sldId="278"/>
            <ac:spMk id="32" creationId="{1B9B53B2-3F38-4CE2-A486-3A8DF5810933}"/>
          </ac:spMkLst>
        </pc:spChg>
        <pc:spChg chg="add mod">
          <ac:chgData name="Gene Clark" userId="e32ce294cf8df570" providerId="LiveId" clId="{E0AAD161-3FB8-4B00-ABEB-A402EB296163}" dt="2022-07-20T13:52:01.963" v="169" actId="1076"/>
          <ac:spMkLst>
            <pc:docMk/>
            <pc:sldMk cId="1676650102" sldId="278"/>
            <ac:spMk id="33" creationId="{9974A79C-31A6-8B90-86BC-35243A83CA98}"/>
          </ac:spMkLst>
        </pc:spChg>
        <pc:spChg chg="add del mod">
          <ac:chgData name="Gene Clark" userId="e32ce294cf8df570" providerId="LiveId" clId="{E0AAD161-3FB8-4B00-ABEB-A402EB296163}" dt="2022-07-20T15:06:28.388" v="183" actId="478"/>
          <ac:spMkLst>
            <pc:docMk/>
            <pc:sldMk cId="1676650102" sldId="278"/>
            <ac:spMk id="36" creationId="{A49E19F2-5FC7-AC08-F4D1-0EEDDC8018DD}"/>
          </ac:spMkLst>
        </pc:spChg>
        <pc:spChg chg="add mod">
          <ac:chgData name="Gene Clark" userId="e32ce294cf8df570" providerId="LiveId" clId="{E0AAD161-3FB8-4B00-ABEB-A402EB296163}" dt="2022-07-20T13:52:16.285" v="181" actId="14100"/>
          <ac:spMkLst>
            <pc:docMk/>
            <pc:sldMk cId="1676650102" sldId="278"/>
            <ac:spMk id="37" creationId="{46805250-06B1-F93A-7DC2-6EC66D96B0BE}"/>
          </ac:spMkLst>
        </pc:spChg>
        <pc:grpChg chg="add mod">
          <ac:chgData name="Gene Clark" userId="e32ce294cf8df570" providerId="LiveId" clId="{E0AAD161-3FB8-4B00-ABEB-A402EB296163}" dt="2022-07-20T13:49:47.107" v="151" actId="1076"/>
          <ac:grpSpMkLst>
            <pc:docMk/>
            <pc:sldMk cId="1676650102" sldId="278"/>
            <ac:grpSpMk id="10" creationId="{DA840772-C41F-15FE-0EFA-0E634CE9120F}"/>
          </ac:grpSpMkLst>
        </pc:grpChg>
        <pc:grpChg chg="add del mod">
          <ac:chgData name="Gene Clark" userId="e32ce294cf8df570" providerId="LiveId" clId="{E0AAD161-3FB8-4B00-ABEB-A402EB296163}" dt="2022-07-20T15:04:46.447" v="182" actId="21"/>
          <ac:grpSpMkLst>
            <pc:docMk/>
            <pc:sldMk cId="1676650102" sldId="278"/>
            <ac:grpSpMk id="11" creationId="{1D307F97-98AE-1DE4-1730-6F4C1588496D}"/>
          </ac:grpSpMkLst>
        </pc:grpChg>
        <pc:graphicFrameChg chg="add mod">
          <ac:chgData name="Gene Clark" userId="e32ce294cf8df570" providerId="LiveId" clId="{E0AAD161-3FB8-4B00-ABEB-A402EB296163}" dt="2022-07-20T13:33:50.859" v="13" actId="164"/>
          <ac:graphicFrameMkLst>
            <pc:docMk/>
            <pc:sldMk cId="1676650102" sldId="278"/>
            <ac:graphicFrameMk id="9" creationId="{BD7BD74E-F2F8-2662-7702-CF8B8773B1D1}"/>
          </ac:graphicFrameMkLst>
        </pc:graphicFrameChg>
        <pc:graphicFrameChg chg="add del mod">
          <ac:chgData name="Gene Clark" userId="e32ce294cf8df570" providerId="LiveId" clId="{E0AAD161-3FB8-4B00-ABEB-A402EB296163}" dt="2022-07-20T15:04:46.447" v="182" actId="21"/>
          <ac:graphicFrameMkLst>
            <pc:docMk/>
            <pc:sldMk cId="1676650102" sldId="278"/>
            <ac:graphicFrameMk id="34" creationId="{2DF64462-1A44-B46A-DD8C-965982462EF4}"/>
          </ac:graphicFrameMkLst>
        </pc:graphicFrameChg>
        <pc:graphicFrameChg chg="add mod">
          <ac:chgData name="Gene Clark" userId="e32ce294cf8df570" providerId="LiveId" clId="{E0AAD161-3FB8-4B00-ABEB-A402EB296163}" dt="2022-07-20T13:51:27.723" v="162" actId="164"/>
          <ac:graphicFrameMkLst>
            <pc:docMk/>
            <pc:sldMk cId="1676650102" sldId="278"/>
            <ac:graphicFrameMk id="35" creationId="{A861D34A-D43F-2101-6FCC-A5F23DDB17D7}"/>
          </ac:graphicFrameMkLst>
        </pc:graphicFrameChg>
      </pc:sldChg>
    </pc:docChg>
  </pc:docChgLst>
  <pc:docChgLst>
    <pc:chgData name="Gene Clark" userId="e32ce294cf8df570" providerId="LiveId" clId="{DAFAFC80-112F-4C9A-B260-4E40DB997CA6}"/>
    <pc:docChg chg="delSld modSld">
      <pc:chgData name="Gene Clark" userId="e32ce294cf8df570" providerId="LiveId" clId="{DAFAFC80-112F-4C9A-B260-4E40DB997CA6}" dt="2022-04-05T14:40:24.410" v="37" actId="47"/>
      <pc:docMkLst>
        <pc:docMk/>
      </pc:docMkLst>
      <pc:sldChg chg="modSp mod">
        <pc:chgData name="Gene Clark" userId="e32ce294cf8df570" providerId="LiveId" clId="{DAFAFC80-112F-4C9A-B260-4E40DB997CA6}" dt="2022-04-05T14:40:17.274" v="31" actId="20577"/>
        <pc:sldMkLst>
          <pc:docMk/>
          <pc:sldMk cId="4162750292" sldId="256"/>
        </pc:sldMkLst>
        <pc:spChg chg="mod">
          <ac:chgData name="Gene Clark" userId="e32ce294cf8df570" providerId="LiveId" clId="{DAFAFC80-112F-4C9A-B260-4E40DB997CA6}" dt="2022-04-05T14:40:17.274" v="31" actId="20577"/>
          <ac:spMkLst>
            <pc:docMk/>
            <pc:sldMk cId="4162750292" sldId="256"/>
            <ac:spMk id="2" creationId="{0279B0EC-AC63-4B00-BDC6-8E1E7C3747FD}"/>
          </ac:spMkLst>
        </pc:spChg>
      </pc:sldChg>
      <pc:sldChg chg="del">
        <pc:chgData name="Gene Clark" userId="e32ce294cf8df570" providerId="LiveId" clId="{DAFAFC80-112F-4C9A-B260-4E40DB997CA6}" dt="2022-04-05T14:40:24.410" v="37" actId="47"/>
        <pc:sldMkLst>
          <pc:docMk/>
          <pc:sldMk cId="885037656" sldId="258"/>
        </pc:sldMkLst>
      </pc:sldChg>
      <pc:sldChg chg="del">
        <pc:chgData name="Gene Clark" userId="e32ce294cf8df570" providerId="LiveId" clId="{DAFAFC80-112F-4C9A-B260-4E40DB997CA6}" dt="2022-04-05T14:40:22.600" v="35" actId="47"/>
        <pc:sldMkLst>
          <pc:docMk/>
          <pc:sldMk cId="2203712765" sldId="279"/>
        </pc:sldMkLst>
      </pc:sldChg>
      <pc:sldChg chg="del">
        <pc:chgData name="Gene Clark" userId="e32ce294cf8df570" providerId="LiveId" clId="{DAFAFC80-112F-4C9A-B260-4E40DB997CA6}" dt="2022-04-05T14:40:23.262" v="36" actId="47"/>
        <pc:sldMkLst>
          <pc:docMk/>
          <pc:sldMk cId="1492030556" sldId="286"/>
        </pc:sldMkLst>
      </pc:sldChg>
      <pc:sldChg chg="del">
        <pc:chgData name="Gene Clark" userId="e32ce294cf8df570" providerId="LiveId" clId="{DAFAFC80-112F-4C9A-B260-4E40DB997CA6}" dt="2022-04-05T14:40:21.250" v="33" actId="47"/>
        <pc:sldMkLst>
          <pc:docMk/>
          <pc:sldMk cId="3281502727" sldId="287"/>
        </pc:sldMkLst>
      </pc:sldChg>
      <pc:sldChg chg="del">
        <pc:chgData name="Gene Clark" userId="e32ce294cf8df570" providerId="LiveId" clId="{DAFAFC80-112F-4C9A-B260-4E40DB997CA6}" dt="2022-04-05T14:40:21.911" v="34" actId="47"/>
        <pc:sldMkLst>
          <pc:docMk/>
          <pc:sldMk cId="3744993024" sldId="306"/>
        </pc:sldMkLst>
      </pc:sldChg>
      <pc:sldChg chg="del">
        <pc:chgData name="Gene Clark" userId="e32ce294cf8df570" providerId="LiveId" clId="{DAFAFC80-112F-4C9A-B260-4E40DB997CA6}" dt="2022-04-05T14:40:20.138" v="32" actId="47"/>
        <pc:sldMkLst>
          <pc:docMk/>
          <pc:sldMk cId="2757525022" sldId="30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7AD4E3-C88F-4837-97F3-E63C82B53040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7D7BDF-E733-4678-8E4F-725E559BEB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222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1pPr>
    <a:lvl2pPr marL="286527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2pPr>
    <a:lvl3pPr marL="573054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3pPr>
    <a:lvl4pPr marL="859582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4pPr>
    <a:lvl5pPr marL="1146109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5pPr>
    <a:lvl6pPr marL="1432636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6pPr>
    <a:lvl7pPr marL="1719163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7pPr>
    <a:lvl8pPr marL="2005691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8pPr>
    <a:lvl9pPr marL="2292218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dirty="0"/>
              <a:t>Supplemental Figure 1: (A) </a:t>
            </a:r>
            <a:r>
              <a:rPr lang="en-US" sz="800" dirty="0"/>
              <a:t>MDA-MB-231 cells were cultured with or without fibroblasts.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800" dirty="0"/>
              <a:t>Cell death was assessed via flow cytometry. 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DA-MB-231 cocultured with MRC5 cells with or without anti-IL-6 antibody or JSI-124. </a:t>
            </a:r>
            <a:r>
              <a:rPr lang="en-US" sz="800" dirty="0"/>
              <a:t>Cell death was assessed via flow cytometry. </a:t>
            </a:r>
            <a:r>
              <a:rPr lang="en-US" sz="800" b="1" dirty="0"/>
              <a:t>(C-E)</a:t>
            </a:r>
            <a:r>
              <a:rPr lang="en-US" sz="800" dirty="0"/>
              <a:t> MDA-MB-231 cells were cocultured with fibroblasts with or without 1 </a:t>
            </a:r>
            <a:r>
              <a:rPr lang="en-US" sz="800" dirty="0" err="1"/>
              <a:t>uM</a:t>
            </a:r>
            <a:r>
              <a:rPr lang="en-US" sz="800" dirty="0"/>
              <a:t> H151. IL-6 expression was assessed via ELISA (C) and surface marker (D) and cell death (E) were quantified via flow cytometry. Statistical significance assessed with ANOVA * = P &lt; 0.05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P-1 cells were incubated with tEVs collected from MDA-MB-231 and IL-6 levels were measured via ELIS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MDM cells were incubated with E0771 tEVs and IL-6 levels were measured via ELIS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DA-MB-231 were exposed to fresh media containing FCM and plating efficiency was assessed via clonogenic assay. X axis indicates what kind of FCM from was used in each group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I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DA-MB-231 were exposed to fresh media containing FCM and plating efficiency was assessed via clonogenic assay. X axis indicates what inhibitors were used in each group. </a:t>
            </a:r>
            <a:r>
              <a:rPr lang="en-US" sz="800" dirty="0"/>
              <a:t>Data points represent biological replicates. </a:t>
            </a:r>
            <a:r>
              <a:rPr lang="en-US" sz="800" b="1" dirty="0"/>
              <a:t>(J)</a:t>
            </a:r>
            <a:r>
              <a:rPr lang="en-US" sz="800" b="0" dirty="0"/>
              <a:t> MDA-MB-231 cells were exposed to 4 Gy gamma radiation and after 7 days of incubation, cell death was assessed via </a:t>
            </a:r>
            <a:r>
              <a:rPr lang="en-US" sz="800" b="0"/>
              <a:t>flow cytometry.</a:t>
            </a:r>
            <a:endParaRPr lang="en-US" sz="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7787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2: 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EV production was assessed in both WT and CD44KO MDA-MB-231 cells with th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Particle Tracker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AG levels were assessed via blyscan assay for WT, DNase1 treated, CD44 KO, and Xylt1/2 KO MDA-MB-231 cell derived tEVs. </a:t>
            </a:r>
            <a:r>
              <a:rPr lang="en-US" sz="700" dirty="0"/>
              <a:t>Statistical significance assessed with ANOVA * = P &lt; 0.05. 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ize distribution of particles from CD44 KO and Xylt1/2 KO MDA-MB-231 cells was assessed with the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700" b="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from (C). </a:t>
            </a:r>
            <a:r>
              <a:rPr lang="en-US" sz="700" b="1" dirty="0"/>
              <a:t>(E) </a:t>
            </a:r>
            <a:r>
              <a:rPr lang="en-US" sz="700" dirty="0"/>
              <a:t>Expression of the small vesicle markers CD81 was assessed via bead assisted flow cytometry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700" b="0" dirty="0">
                <a:latin typeface="Arial" panose="020B0604020202020204" pitchFamily="34" charset="0"/>
                <a:cs typeface="Arial" panose="020B0604020202020204" pitchFamily="34" charset="0"/>
              </a:rPr>
              <a:t>CD44 KO was assessed via flow cytometry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G-H) </a:t>
            </a:r>
            <a:r>
              <a:rPr lang="en-US" sz="700" b="0" dirty="0">
                <a:latin typeface="Arial" panose="020B0604020202020204" pitchFamily="34" charset="0"/>
                <a:cs typeface="Arial" panose="020B0604020202020204" pitchFamily="34" charset="0"/>
              </a:rPr>
              <a:t>CD44 expression was measured for tEVs collected from MDA-MB-231 (G) and BT-549 (H) cells via flow cytometry. Statistical significance assessed via unpaired students T test. </a:t>
            </a:r>
            <a:r>
              <a:rPr lang="en-US" sz="700" dirty="0"/>
              <a:t>* = P &lt; 0.05.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a,b,g,h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) Data points represent technical replicates. </a:t>
            </a:r>
            <a:r>
              <a:rPr lang="en-US" sz="700" b="1" dirty="0"/>
              <a:t>(I)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EVs derived from breast cancer patient sera tEVs were bound to sulfoxide beads and CD44 expression was measured via flow cytometry. </a:t>
            </a:r>
            <a:r>
              <a:rPr lang="en-US" sz="800" b="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assessed via paired T test. </a:t>
            </a:r>
            <a:r>
              <a:rPr lang="en-US" sz="800" dirty="0"/>
              <a:t>* = P &lt; 0.05. Data points represent biological replicates.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1716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3: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EV production was assessed in both WT and CD44KO E0771 cells with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AG levels were assessed via blyscan assay for WT, heparanase treated, and CD44 KO E0771 derived tEVs via blyscan assay. (A-B) Data points represent technical replicates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ze distribution of particles from CD44 KO E0771 cells was assessed with th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C). </a:t>
            </a:r>
            <a:r>
              <a:rPr lang="en-US" sz="800" b="1" dirty="0"/>
              <a:t>(E) </a:t>
            </a:r>
            <a:r>
              <a:rPr lang="en-US" sz="800" b="0" dirty="0"/>
              <a:t>Primary lung fibroblast</a:t>
            </a:r>
            <a:r>
              <a:rPr lang="en-US" sz="800" dirty="0"/>
              <a:t>s were incubated with E0771 tEVs treated with heparanase and IL-6 levels were measured via ELISA</a:t>
            </a:r>
            <a:r>
              <a:rPr lang="en-US" sz="800" b="1" dirty="0"/>
              <a:t> </a:t>
            </a:r>
            <a:r>
              <a:rPr lang="en-US" sz="800" dirty="0"/>
              <a:t>Data points represent biological replicates.</a:t>
            </a:r>
            <a:r>
              <a:rPr lang="en-US" sz="8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800" b="0" dirty="0">
                <a:latin typeface="Arial" panose="020B0604020202020204" pitchFamily="34" charset="0"/>
                <a:cs typeface="Arial" panose="020B0604020202020204" pitchFamily="34" charset="0"/>
              </a:rPr>
              <a:t>CD44 KO was assessed via flow cytometry. </a:t>
            </a:r>
            <a:r>
              <a:rPr lang="en-US" sz="700" b="1" dirty="0"/>
              <a:t>(G) </a:t>
            </a:r>
            <a:r>
              <a:rPr lang="en-US" sz="700" dirty="0"/>
              <a:t>Expression of the small vesicle CD81 was assessed via bead assisted flow cytometry. Statistical significance assessed with ANOVA * = P &lt; 0.05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MDA-MB-231 were exposed to fresh media containing FCM and plating efficiency was assessed via clonogenic assay. X axis indicates what kind of FCM from was used in each group.</a:t>
            </a:r>
            <a:endParaRPr lang="en-US" sz="700" dirty="0"/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700" dirty="0"/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614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4: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A-B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Vs were collected from the sera of C57bl/6 E0771 tumor bearing mice with or without a single 10 Gy dose of radiation delivered directly to the tumor using the SARRP. tEVs were also collected from non-tumor bearing mice that had either received no treatment or a single 10 Gy dose to the left hind leg. Particle count was assessed using th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Particle Tracker A and GAG levels were assessed via blyscan assay B. Data points represent technical replicates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ze distribution of particles from CD44 KO E0771 cells was assessed with th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C). </a:t>
            </a:r>
            <a:r>
              <a:rPr lang="en-US" sz="700" b="1" dirty="0"/>
              <a:t>(E) </a:t>
            </a:r>
            <a:r>
              <a:rPr lang="en-US" sz="700" dirty="0"/>
              <a:t>Expression of the small vesicle marker CD81 was assessed via bead assisted flow cytometry. Statistical significance assessed with ANOVA * = P &lt; 0.0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7634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700" b="1" dirty="0"/>
              <a:t>Supplemental Figure 5: </a:t>
            </a:r>
            <a:r>
              <a:rPr lang="en-US" sz="700" dirty="0"/>
              <a:t>IR tEV activity is dependent upon the ESCRT pathway. </a:t>
            </a:r>
            <a:r>
              <a:rPr lang="en-US" sz="700" b="1" dirty="0"/>
              <a:t>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EV production was assessed in both WT and </a:t>
            </a:r>
            <a:r>
              <a:rPr lang="en-US" sz="800" dirty="0"/>
              <a:t>SDC1 </a:t>
            </a:r>
            <a:r>
              <a:rPr lang="en-US" sz="800" dirty="0" err="1"/>
              <a:t>kD</a:t>
            </a:r>
            <a:r>
              <a:rPr lang="en-US" sz="800" dirty="0"/>
              <a:t>, SDC2 </a:t>
            </a:r>
            <a:r>
              <a:rPr lang="en-US" sz="800" dirty="0" err="1"/>
              <a:t>kD</a:t>
            </a:r>
            <a:r>
              <a:rPr lang="en-US" sz="800" dirty="0"/>
              <a:t>, SDC4 </a:t>
            </a:r>
            <a:r>
              <a:rPr lang="en-US" sz="800" dirty="0" err="1"/>
              <a:t>kD</a:t>
            </a:r>
            <a:r>
              <a:rPr lang="en-US" sz="800" dirty="0"/>
              <a:t> MDA-MB-23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ells with th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b="1" dirty="0"/>
              <a:t>B) </a:t>
            </a:r>
            <a:r>
              <a:rPr lang="en-US" sz="700" dirty="0"/>
              <a:t>tEVs were collected from WT and SDC </a:t>
            </a:r>
            <a:r>
              <a:rPr lang="en-US" sz="700" dirty="0" err="1"/>
              <a:t>kD</a:t>
            </a:r>
            <a:r>
              <a:rPr lang="en-US" sz="700" dirty="0"/>
              <a:t> MDA-MB-231 cells and GAG levels were assessed via blyscan assay. </a:t>
            </a:r>
            <a:r>
              <a:rPr lang="en-US" sz="700" b="1" dirty="0"/>
              <a:t>(C) </a:t>
            </a:r>
            <a:r>
              <a:rPr lang="en-US" sz="700" dirty="0"/>
              <a:t>The size range of SDC1 </a:t>
            </a:r>
            <a:r>
              <a:rPr lang="en-US" sz="700" dirty="0" err="1"/>
              <a:t>kD</a:t>
            </a:r>
            <a:r>
              <a:rPr lang="en-US" sz="700" dirty="0"/>
              <a:t>, SDC2 </a:t>
            </a:r>
            <a:r>
              <a:rPr lang="en-US" sz="700" dirty="0" err="1"/>
              <a:t>kD</a:t>
            </a:r>
            <a:r>
              <a:rPr lang="en-US" sz="700" dirty="0"/>
              <a:t>, SDC4 </a:t>
            </a:r>
            <a:r>
              <a:rPr lang="en-US" sz="700" dirty="0" err="1"/>
              <a:t>kD</a:t>
            </a:r>
            <a:r>
              <a:rPr lang="en-US" sz="700" dirty="0"/>
              <a:t>, and PDZ1i treated MDA-MB-231 derived tEVs was measured via </a:t>
            </a:r>
            <a:r>
              <a:rPr lang="en-US" sz="700" dirty="0" err="1"/>
              <a:t>zetaview</a:t>
            </a:r>
            <a:r>
              <a:rPr lang="en-US" sz="700" dirty="0"/>
              <a:t>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C).</a:t>
            </a:r>
            <a:r>
              <a:rPr lang="en-US" sz="700" dirty="0"/>
              <a:t> </a:t>
            </a:r>
            <a:r>
              <a:rPr lang="en-US" sz="700" b="1" dirty="0"/>
              <a:t>(E) </a:t>
            </a:r>
            <a:r>
              <a:rPr lang="en-US" sz="700" dirty="0"/>
              <a:t>tEVs were collected from UT and 5 </a:t>
            </a:r>
            <a:r>
              <a:rPr lang="en-US" sz="700" dirty="0" err="1"/>
              <a:t>uM</a:t>
            </a:r>
            <a:r>
              <a:rPr lang="en-US" sz="700" dirty="0"/>
              <a:t> PDZ1i treated MDA-MB-231 cells and GAG levels were assessed via blyscan assay.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ata points represent technical replicates. </a:t>
            </a:r>
            <a:r>
              <a:rPr lang="en-US" sz="700" b="1" dirty="0"/>
              <a:t>(F) </a:t>
            </a:r>
            <a:r>
              <a:rPr lang="en-US" sz="700" dirty="0"/>
              <a:t>Expression of the small vesicle marker CD81 was assessed via bead assisted flow cytometry. </a:t>
            </a:r>
            <a:r>
              <a:rPr lang="en-US" sz="700" b="1" dirty="0"/>
              <a:t>(G) </a:t>
            </a:r>
            <a:r>
              <a:rPr lang="en-US" sz="700" dirty="0"/>
              <a:t>SDC1 </a:t>
            </a:r>
            <a:r>
              <a:rPr lang="en-US" sz="700" dirty="0" err="1"/>
              <a:t>kd</a:t>
            </a:r>
            <a:r>
              <a:rPr lang="en-US" sz="700" dirty="0"/>
              <a:t> MDA-MB-231 cells were cocultured with MRC5 cells and IL-6 expression was measured via ELISA. Data points represent biological replicat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21242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: </a:t>
            </a:r>
            <a:r>
              <a:rPr lang="en-US" sz="700" b="1" dirty="0"/>
              <a:t>(A-B) </a:t>
            </a:r>
            <a:r>
              <a:rPr lang="en-US" sz="700" b="0" dirty="0"/>
              <a:t>tEVs were collected from </a:t>
            </a:r>
            <a:r>
              <a:rPr lang="en-US" sz="700" dirty="0"/>
              <a:t>WT and SDC1 </a:t>
            </a:r>
            <a:r>
              <a:rPr lang="en-US" sz="700" dirty="0" err="1"/>
              <a:t>Kd</a:t>
            </a:r>
            <a:r>
              <a:rPr lang="en-US" sz="700" dirty="0"/>
              <a:t> BT-549 cells</a:t>
            </a:r>
            <a:r>
              <a:rPr lang="en-US" sz="700" b="0" dirty="0"/>
              <a:t> </a:t>
            </a:r>
            <a:r>
              <a:rPr lang="en-US" sz="700" dirty="0"/>
              <a:t>and CD44v3 (A) and HS (B) levels were assessed via bead assisted flow cytometry. </a:t>
            </a:r>
            <a:r>
              <a:rPr lang="en-US" sz="800" b="1" dirty="0"/>
              <a:t>(C) </a:t>
            </a:r>
            <a:r>
              <a:rPr lang="en-US" sz="800" dirty="0"/>
              <a:t>The concentration of small EVs produced by irradiated WT and SDC1 </a:t>
            </a:r>
            <a:r>
              <a:rPr lang="en-US" sz="800" dirty="0" err="1"/>
              <a:t>Kd</a:t>
            </a:r>
            <a:r>
              <a:rPr lang="en-US" sz="800" dirty="0"/>
              <a:t> BT-549 cells was assessed via </a:t>
            </a:r>
            <a:r>
              <a:rPr lang="en-US" sz="800" dirty="0" err="1"/>
              <a:t>zetaview</a:t>
            </a:r>
            <a:r>
              <a:rPr lang="en-US" sz="800" dirty="0"/>
              <a:t>. </a:t>
            </a:r>
            <a:r>
              <a:rPr lang="en-US" sz="800" b="1" dirty="0"/>
              <a:t>(D) </a:t>
            </a:r>
            <a:r>
              <a:rPr lang="en-US" sz="800" dirty="0"/>
              <a:t>tEVs were collected form WT and SDC1 </a:t>
            </a:r>
            <a:r>
              <a:rPr lang="en-US" sz="800" dirty="0" err="1"/>
              <a:t>Kd</a:t>
            </a:r>
            <a:r>
              <a:rPr lang="en-US" sz="800" dirty="0"/>
              <a:t> BT-549 cells and GAG levels were assessed via blyscan assay. </a:t>
            </a:r>
            <a:r>
              <a:rPr lang="en-US" sz="800" b="1" dirty="0"/>
              <a:t>(E) </a:t>
            </a:r>
            <a:r>
              <a:rPr lang="en-US" sz="800" dirty="0"/>
              <a:t>The size range of WT and SDC1 </a:t>
            </a:r>
            <a:r>
              <a:rPr lang="en-US" sz="800" dirty="0" err="1"/>
              <a:t>kD</a:t>
            </a:r>
            <a:r>
              <a:rPr lang="en-US" sz="800" dirty="0"/>
              <a:t> BT-549 derived tEVs was assessed via </a:t>
            </a:r>
            <a:r>
              <a:rPr lang="en-US" sz="800" dirty="0" err="1"/>
              <a:t>zetaview</a:t>
            </a:r>
            <a:r>
              <a:rPr lang="en-US" sz="800" dirty="0"/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E).</a:t>
            </a:r>
            <a:r>
              <a:rPr lang="en-US" sz="800" dirty="0"/>
              <a:t> </a:t>
            </a:r>
            <a:r>
              <a:rPr lang="en-US" sz="800" b="1" dirty="0"/>
              <a:t>(G)</a:t>
            </a:r>
            <a:r>
              <a:rPr lang="en-US" sz="700" b="1" dirty="0"/>
              <a:t> </a:t>
            </a:r>
            <a:r>
              <a:rPr lang="en-US" sz="700" dirty="0"/>
              <a:t>Expression of the small vesicle markers CD81 was assessed via bead assisted flow cytometry. Statistical significance assessed with ANOVA P &lt; 0.05.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ata points represent technical replicates. </a:t>
            </a:r>
            <a:endParaRPr lang="en-US" sz="7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76358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: (A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EVs were collected from WT, SDC1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, and 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DZ1i treated E0771 cells in vitro and tEV concentration was assessed via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b="1" dirty="0"/>
              <a:t>B) </a:t>
            </a:r>
            <a:r>
              <a:rPr lang="en-US" sz="700" dirty="0"/>
              <a:t>GAG levels were assessed via blyscan assay.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ata points represent technical replicates. </a:t>
            </a:r>
            <a:r>
              <a:rPr lang="en-US" sz="700" b="1" dirty="0"/>
              <a:t>(C) </a:t>
            </a:r>
            <a:r>
              <a:rPr lang="en-US" sz="700" dirty="0"/>
              <a:t>The size range of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WT, SDC1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, and 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PDZ1i treated E0771 cell </a:t>
            </a:r>
            <a:r>
              <a:rPr lang="en-US" sz="700" dirty="0"/>
              <a:t>derived tEVs was assessed via </a:t>
            </a:r>
            <a:r>
              <a:rPr lang="en-US" sz="700" dirty="0" err="1"/>
              <a:t>zetaview</a:t>
            </a:r>
            <a:r>
              <a:rPr lang="en-US" sz="700" dirty="0"/>
              <a:t>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C).</a:t>
            </a:r>
            <a:r>
              <a:rPr lang="en-US" sz="700" dirty="0"/>
              <a:t> </a:t>
            </a:r>
            <a:r>
              <a:rPr lang="en-US" sz="700" b="1" dirty="0"/>
              <a:t>(E</a:t>
            </a:r>
            <a:r>
              <a:rPr lang="en-US" sz="600" b="1" dirty="0"/>
              <a:t>) </a:t>
            </a:r>
            <a:r>
              <a:rPr lang="en-US" sz="600" dirty="0"/>
              <a:t>Expression of the small vesicle markers CD81 was assessed via bead assisted flow cytometry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DC1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was confirmed via flow cytometry.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MDA-MB-231 were exposed to fresh media containing FCM and plating efficiency was assessed via clonogenic assay. X axis indicates what kind of FCM from was used in each group. </a:t>
            </a:r>
            <a:r>
              <a:rPr lang="en-US" sz="700" dirty="0"/>
              <a:t>Data points represent biological replicates.</a:t>
            </a:r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700" dirty="0"/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73020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8: (a-b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EVs were collected from LLC cells in vitro before or after exposure to 10 Gy radiation. tEV concentration A was assessed via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zetaview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while GAG levels were assessed via blyscan assay B. </a:t>
            </a:r>
            <a:r>
              <a:rPr lang="en-US" sz="800" dirty="0"/>
              <a:t>Statistical significance for A assessed via students t test and for B with ANOVA * = P &lt; 0.05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ta points represent technical replicates. </a:t>
            </a:r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dirty="0"/>
              <a:t> </a:t>
            </a:r>
            <a:r>
              <a:rPr lang="en-US" sz="800" b="1" dirty="0"/>
              <a:t>(C) </a:t>
            </a:r>
            <a:r>
              <a:rPr lang="en-US" sz="800" dirty="0"/>
              <a:t>The size range of LLC tEVs was assessed via </a:t>
            </a:r>
            <a:r>
              <a:rPr lang="en-US" sz="800" dirty="0" err="1"/>
              <a:t>zetaview</a:t>
            </a:r>
            <a:r>
              <a:rPr lang="en-US" sz="800" dirty="0"/>
              <a:t>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from (C).</a:t>
            </a:r>
            <a:r>
              <a:rPr lang="en-US" sz="800" dirty="0"/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800" b="1" dirty="0"/>
              <a:t> </a:t>
            </a:r>
            <a:r>
              <a:rPr lang="en-US" sz="800" dirty="0"/>
              <a:t>Expression of the small vesicle marker CD81 was assessed via bead assisted flow cytometry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f-g)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DA-MB-231 were exposed to fresh media containing FCM and plating efficiency was assessed via clonogenic assay. X axis indicates what kind of FCM from was used in each group. (f-g) </a:t>
            </a:r>
            <a:r>
              <a:rPr lang="en-US" sz="800" dirty="0"/>
              <a:t>Data points represent biological replicates. Statistical significance assessed via ANOVA * = P &lt; 0.05. </a:t>
            </a:r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800" dirty="0"/>
          </a:p>
          <a:p>
            <a:pPr marL="0" marR="0" lvl="0" indent="0" algn="l" defTabSz="5730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D7BDF-E733-4678-8E4F-725E559BEBE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324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415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54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63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45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401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7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774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343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331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541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49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A8FB3-A876-4D10-A7C1-89B16E6AC05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46677-9332-4871-B6E0-8978176CC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260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0.emf"/><Relationship Id="rId18" Type="http://schemas.openxmlformats.org/officeDocument/2006/relationships/oleObject" Target="../embeddings/oleObject14.bin"/><Relationship Id="rId3" Type="http://schemas.openxmlformats.org/officeDocument/2006/relationships/image" Target="../media/image11.png"/><Relationship Id="rId21" Type="http://schemas.openxmlformats.org/officeDocument/2006/relationships/image" Target="../media/image24.emf"/><Relationship Id="rId7" Type="http://schemas.openxmlformats.org/officeDocument/2006/relationships/image" Target="../media/image15.png"/><Relationship Id="rId12" Type="http://schemas.openxmlformats.org/officeDocument/2006/relationships/oleObject" Target="../embeddings/oleObject11.bin"/><Relationship Id="rId17" Type="http://schemas.openxmlformats.org/officeDocument/2006/relationships/image" Target="../media/image22.emf"/><Relationship Id="rId2" Type="http://schemas.openxmlformats.org/officeDocument/2006/relationships/notesSlide" Target="../notesSlides/notesSlide2.xml"/><Relationship Id="rId16" Type="http://schemas.openxmlformats.org/officeDocument/2006/relationships/oleObject" Target="../embeddings/oleObject13.bin"/><Relationship Id="rId20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5" Type="http://schemas.openxmlformats.org/officeDocument/2006/relationships/image" Target="../media/image21.emf"/><Relationship Id="rId10" Type="http://schemas.openxmlformats.org/officeDocument/2006/relationships/image" Target="../media/image18.png"/><Relationship Id="rId19" Type="http://schemas.openxmlformats.org/officeDocument/2006/relationships/image" Target="../media/image23.emf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oleObject" Target="../embeddings/oleObject1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1.emf"/><Relationship Id="rId3" Type="http://schemas.openxmlformats.org/officeDocument/2006/relationships/oleObject" Target="../embeddings/oleObject16.bin"/><Relationship Id="rId7" Type="http://schemas.openxmlformats.org/officeDocument/2006/relationships/image" Target="../media/image27.png"/><Relationship Id="rId12" Type="http://schemas.openxmlformats.org/officeDocument/2006/relationships/oleObject" Target="../embeddings/oleObject19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11" Type="http://schemas.openxmlformats.org/officeDocument/2006/relationships/image" Target="../media/image30.emf"/><Relationship Id="rId5" Type="http://schemas.openxmlformats.org/officeDocument/2006/relationships/oleObject" Target="../embeddings/oleObject17.bin"/><Relationship Id="rId15" Type="http://schemas.openxmlformats.org/officeDocument/2006/relationships/image" Target="../media/image33.png"/><Relationship Id="rId10" Type="http://schemas.openxmlformats.org/officeDocument/2006/relationships/oleObject" Target="../embeddings/oleObject18.bin"/><Relationship Id="rId4" Type="http://schemas.openxmlformats.org/officeDocument/2006/relationships/image" Target="../media/image25.emf"/><Relationship Id="rId9" Type="http://schemas.openxmlformats.org/officeDocument/2006/relationships/image" Target="../media/image29.png"/><Relationship Id="rId14" Type="http://schemas.openxmlformats.org/officeDocument/2006/relationships/image" Target="../media/image3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18" Type="http://schemas.openxmlformats.org/officeDocument/2006/relationships/image" Target="../media/image47.png"/><Relationship Id="rId3" Type="http://schemas.openxmlformats.org/officeDocument/2006/relationships/oleObject" Target="../embeddings/oleObject20.bin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17" Type="http://schemas.openxmlformats.org/officeDocument/2006/relationships/image" Target="../media/image46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emf"/><Relationship Id="rId11" Type="http://schemas.openxmlformats.org/officeDocument/2006/relationships/image" Target="../media/image40.png"/><Relationship Id="rId5" Type="http://schemas.openxmlformats.org/officeDocument/2006/relationships/oleObject" Target="../embeddings/oleObject21.bin"/><Relationship Id="rId15" Type="http://schemas.openxmlformats.org/officeDocument/2006/relationships/image" Target="../media/image44.png"/><Relationship Id="rId10" Type="http://schemas.openxmlformats.org/officeDocument/2006/relationships/image" Target="../media/image39.png"/><Relationship Id="rId4" Type="http://schemas.openxmlformats.org/officeDocument/2006/relationships/image" Target="../media/image34.emf"/><Relationship Id="rId9" Type="http://schemas.openxmlformats.org/officeDocument/2006/relationships/image" Target="../media/image38.png"/><Relationship Id="rId14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13" Type="http://schemas.openxmlformats.org/officeDocument/2006/relationships/image" Target="../media/image56.emf"/><Relationship Id="rId18" Type="http://schemas.openxmlformats.org/officeDocument/2006/relationships/image" Target="../media/image59.png"/><Relationship Id="rId3" Type="http://schemas.openxmlformats.org/officeDocument/2006/relationships/image" Target="../media/image48.png"/><Relationship Id="rId21" Type="http://schemas.openxmlformats.org/officeDocument/2006/relationships/image" Target="../media/image62.png"/><Relationship Id="rId7" Type="http://schemas.openxmlformats.org/officeDocument/2006/relationships/image" Target="../media/image52.png"/><Relationship Id="rId12" Type="http://schemas.openxmlformats.org/officeDocument/2006/relationships/oleObject" Target="../embeddings/oleObject23.bin"/><Relationship Id="rId17" Type="http://schemas.openxmlformats.org/officeDocument/2006/relationships/image" Target="../media/image58.emf"/><Relationship Id="rId25" Type="http://schemas.openxmlformats.org/officeDocument/2006/relationships/image" Target="../media/image66.png"/><Relationship Id="rId2" Type="http://schemas.openxmlformats.org/officeDocument/2006/relationships/notesSlide" Target="../notesSlides/notesSlide5.xml"/><Relationship Id="rId16" Type="http://schemas.openxmlformats.org/officeDocument/2006/relationships/oleObject" Target="../embeddings/oleObject25.bin"/><Relationship Id="rId20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11" Type="http://schemas.openxmlformats.org/officeDocument/2006/relationships/image" Target="../media/image55.emf"/><Relationship Id="rId24" Type="http://schemas.openxmlformats.org/officeDocument/2006/relationships/image" Target="../media/image65.png"/><Relationship Id="rId5" Type="http://schemas.openxmlformats.org/officeDocument/2006/relationships/image" Target="../media/image50.png"/><Relationship Id="rId15" Type="http://schemas.openxmlformats.org/officeDocument/2006/relationships/image" Target="../media/image57.emf"/><Relationship Id="rId23" Type="http://schemas.openxmlformats.org/officeDocument/2006/relationships/image" Target="../media/image64.png"/><Relationship Id="rId10" Type="http://schemas.openxmlformats.org/officeDocument/2006/relationships/oleObject" Target="../embeddings/oleObject22.bin"/><Relationship Id="rId19" Type="http://schemas.openxmlformats.org/officeDocument/2006/relationships/image" Target="../media/image60.png"/><Relationship Id="rId4" Type="http://schemas.openxmlformats.org/officeDocument/2006/relationships/image" Target="../media/image49.png"/><Relationship Id="rId9" Type="http://schemas.openxmlformats.org/officeDocument/2006/relationships/image" Target="../media/image54.png"/><Relationship Id="rId14" Type="http://schemas.openxmlformats.org/officeDocument/2006/relationships/oleObject" Target="../embeddings/oleObject24.bin"/><Relationship Id="rId22" Type="http://schemas.openxmlformats.org/officeDocument/2006/relationships/image" Target="../media/image6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13" Type="http://schemas.openxmlformats.org/officeDocument/2006/relationships/oleObject" Target="../embeddings/oleObject29.bin"/><Relationship Id="rId3" Type="http://schemas.openxmlformats.org/officeDocument/2006/relationships/oleObject" Target="../embeddings/oleObject26.bin"/><Relationship Id="rId7" Type="http://schemas.openxmlformats.org/officeDocument/2006/relationships/image" Target="../media/image69.png"/><Relationship Id="rId12" Type="http://schemas.openxmlformats.org/officeDocument/2006/relationships/image" Target="../media/image73.emf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emf"/><Relationship Id="rId11" Type="http://schemas.openxmlformats.org/officeDocument/2006/relationships/oleObject" Target="../embeddings/oleObject28.bin"/><Relationship Id="rId5" Type="http://schemas.openxmlformats.org/officeDocument/2006/relationships/oleObject" Target="../embeddings/oleObject27.bin"/><Relationship Id="rId15" Type="http://schemas.openxmlformats.org/officeDocument/2006/relationships/image" Target="../media/image75.png"/><Relationship Id="rId10" Type="http://schemas.openxmlformats.org/officeDocument/2006/relationships/image" Target="../media/image72.png"/><Relationship Id="rId4" Type="http://schemas.openxmlformats.org/officeDocument/2006/relationships/image" Target="../media/image67.emf"/><Relationship Id="rId9" Type="http://schemas.openxmlformats.org/officeDocument/2006/relationships/image" Target="../media/image71.png"/><Relationship Id="rId14" Type="http://schemas.openxmlformats.org/officeDocument/2006/relationships/image" Target="../media/image74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13" Type="http://schemas.openxmlformats.org/officeDocument/2006/relationships/image" Target="../media/image49.png"/><Relationship Id="rId18" Type="http://schemas.openxmlformats.org/officeDocument/2006/relationships/image" Target="../media/image87.png"/><Relationship Id="rId3" Type="http://schemas.openxmlformats.org/officeDocument/2006/relationships/image" Target="../media/image77.png"/><Relationship Id="rId7" Type="http://schemas.openxmlformats.org/officeDocument/2006/relationships/image" Target="../media/image79.emf"/><Relationship Id="rId12" Type="http://schemas.openxmlformats.org/officeDocument/2006/relationships/image" Target="../media/image48.png"/><Relationship Id="rId17" Type="http://schemas.openxmlformats.org/officeDocument/2006/relationships/image" Target="../media/image86.png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85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1.bin"/><Relationship Id="rId11" Type="http://schemas.openxmlformats.org/officeDocument/2006/relationships/image" Target="../media/image83.png"/><Relationship Id="rId5" Type="http://schemas.openxmlformats.org/officeDocument/2006/relationships/image" Target="../media/image78.emf"/><Relationship Id="rId15" Type="http://schemas.openxmlformats.org/officeDocument/2006/relationships/image" Target="../media/image84.emf"/><Relationship Id="rId10" Type="http://schemas.openxmlformats.org/officeDocument/2006/relationships/image" Target="../media/image82.png"/><Relationship Id="rId19" Type="http://schemas.openxmlformats.org/officeDocument/2006/relationships/image" Target="../media/image88.png"/><Relationship Id="rId4" Type="http://schemas.openxmlformats.org/officeDocument/2006/relationships/oleObject" Target="../embeddings/oleObject30.bin"/><Relationship Id="rId9" Type="http://schemas.openxmlformats.org/officeDocument/2006/relationships/image" Target="../media/image81.png"/><Relationship Id="rId14" Type="http://schemas.openxmlformats.org/officeDocument/2006/relationships/oleObject" Target="../embeddings/oleObject32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emf"/><Relationship Id="rId13" Type="http://schemas.openxmlformats.org/officeDocument/2006/relationships/image" Target="../media/image95.png"/><Relationship Id="rId3" Type="http://schemas.openxmlformats.org/officeDocument/2006/relationships/oleObject" Target="../embeddings/oleObject33.bin"/><Relationship Id="rId7" Type="http://schemas.openxmlformats.org/officeDocument/2006/relationships/oleObject" Target="../embeddings/oleObject34.bin"/><Relationship Id="rId12" Type="http://schemas.openxmlformats.org/officeDocument/2006/relationships/image" Target="../media/image94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1.png"/><Relationship Id="rId11" Type="http://schemas.openxmlformats.org/officeDocument/2006/relationships/oleObject" Target="../embeddings/oleObject36.bin"/><Relationship Id="rId5" Type="http://schemas.openxmlformats.org/officeDocument/2006/relationships/image" Target="../media/image90.png"/><Relationship Id="rId10" Type="http://schemas.openxmlformats.org/officeDocument/2006/relationships/image" Target="../media/image93.emf"/><Relationship Id="rId4" Type="http://schemas.openxmlformats.org/officeDocument/2006/relationships/image" Target="../media/image89.emf"/><Relationship Id="rId9" Type="http://schemas.openxmlformats.org/officeDocument/2006/relationships/oleObject" Target="../embeddings/oleObject35.bin"/><Relationship Id="rId14" Type="http://schemas.openxmlformats.org/officeDocument/2006/relationships/image" Target="../media/image9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9B0EC-AC63-4B00-BDC6-8E1E7C3747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1646133"/>
            <a:ext cx="7631084" cy="3501813"/>
          </a:xfrm>
        </p:spPr>
        <p:txBody>
          <a:bodyPr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diation Induces ESCRT-pathway Mediated CD44v3</a:t>
            </a:r>
            <a:r>
              <a:rPr lang="en-US" sz="2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2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tracellular Vesicle Production Stimulating Pro-Tumor Fibroblast Activity in Breast Cancer- Supplement</a:t>
            </a:r>
            <a:endParaRPr lang="en-US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929FCA-1D18-4CCC-B927-8C4E06F5AA7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Gene Clark</a:t>
            </a:r>
          </a:p>
        </p:txBody>
      </p:sp>
    </p:spTree>
    <p:extLst>
      <p:ext uri="{BB962C8B-B14F-4D97-AF65-F5344CB8AC3E}">
        <p14:creationId xmlns:p14="http://schemas.microsoft.com/office/powerpoint/2010/main" val="4162750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5B873741-64B6-41D2-AEE9-54D4EBBC3F46}"/>
              </a:ext>
            </a:extLst>
          </p:cNvPr>
          <p:cNvGrpSpPr/>
          <p:nvPr/>
        </p:nvGrpSpPr>
        <p:grpSpPr>
          <a:xfrm>
            <a:off x="72798" y="140661"/>
            <a:ext cx="2043178" cy="2285162"/>
            <a:chOff x="4915634" y="-114796"/>
            <a:chExt cx="2565610" cy="2620370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9FCA14C1-7C5A-4919-ABED-C128AEECA1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16953207"/>
                </p:ext>
              </p:extLst>
            </p:nvPr>
          </p:nvGraphicFramePr>
          <p:xfrm>
            <a:off x="5190166" y="261427"/>
            <a:ext cx="2291078" cy="22441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965303" imgH="2903090" progId="Prism9.Document">
                    <p:embed/>
                  </p:oleObj>
                </mc:Choice>
                <mc:Fallback>
                  <p:oleObj name="Prism 9" r:id="rId3" imgW="2965303" imgH="2903090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9FCA14C1-7C5A-4919-ABED-C128AEECA1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190166" y="261427"/>
                          <a:ext cx="2291078" cy="224414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C639CE0-3AA3-4294-80B4-2146E8876CBC}"/>
                </a:ext>
              </a:extLst>
            </p:cNvPr>
            <p:cNvSpPr txBox="1"/>
            <p:nvPr/>
          </p:nvSpPr>
          <p:spPr>
            <a:xfrm>
              <a:off x="4915634" y="-114796"/>
              <a:ext cx="685025" cy="3662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E929752-A1FD-49D7-A35C-BFB7C3DE5564}"/>
              </a:ext>
            </a:extLst>
          </p:cNvPr>
          <p:cNvGrpSpPr/>
          <p:nvPr/>
        </p:nvGrpSpPr>
        <p:grpSpPr>
          <a:xfrm>
            <a:off x="2205147" y="141537"/>
            <a:ext cx="2333865" cy="1956139"/>
            <a:chOff x="2955367" y="2740607"/>
            <a:chExt cx="3195666" cy="2327666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EF552DAF-7044-4A1A-A2D4-4EE6284F52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05605407"/>
                </p:ext>
              </p:extLst>
            </p:nvPr>
          </p:nvGraphicFramePr>
          <p:xfrm>
            <a:off x="3292617" y="3154703"/>
            <a:ext cx="2858416" cy="19135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658575" imgH="2448819" progId="Prism9.Document">
                    <p:embed/>
                  </p:oleObj>
                </mc:Choice>
                <mc:Fallback>
                  <p:oleObj name="Prism 9" r:id="rId5" imgW="3658575" imgH="2448819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EF552DAF-7044-4A1A-A2D4-4EE6284F52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292617" y="3154703"/>
                          <a:ext cx="2858416" cy="19135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B52C817-8666-4C7E-B625-A2A1D8145598}"/>
                </a:ext>
              </a:extLst>
            </p:cNvPr>
            <p:cNvSpPr txBox="1"/>
            <p:nvPr/>
          </p:nvSpPr>
          <p:spPr>
            <a:xfrm>
              <a:off x="2955367" y="2740607"/>
              <a:ext cx="685025" cy="3662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0766B82-4D99-46D1-A021-8D2025590179}"/>
              </a:ext>
            </a:extLst>
          </p:cNvPr>
          <p:cNvGrpSpPr/>
          <p:nvPr/>
        </p:nvGrpSpPr>
        <p:grpSpPr>
          <a:xfrm>
            <a:off x="2763642" y="2470007"/>
            <a:ext cx="2278883" cy="2033827"/>
            <a:chOff x="196768" y="4791468"/>
            <a:chExt cx="2930326" cy="2433085"/>
          </a:xfrm>
        </p:grpSpPr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D66075FD-2756-4024-BD75-5622AD0CF2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31364088"/>
                </p:ext>
              </p:extLst>
            </p:nvPr>
          </p:nvGraphicFramePr>
          <p:xfrm>
            <a:off x="426448" y="5224759"/>
            <a:ext cx="2700646" cy="19997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654256" imgH="2701872" progId="Prism9.Document">
                    <p:embed/>
                  </p:oleObj>
                </mc:Choice>
                <mc:Fallback>
                  <p:oleObj name="Prism 9" r:id="rId7" imgW="3654256" imgH="2701872" progId="Prism9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D66075FD-2756-4024-BD75-5622AD0CF2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26448" y="5224759"/>
                          <a:ext cx="2700646" cy="19997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E6D5C0B-2F07-4E84-8440-5E86070613B7}"/>
                </a:ext>
              </a:extLst>
            </p:cNvPr>
            <p:cNvSpPr txBox="1"/>
            <p:nvPr/>
          </p:nvSpPr>
          <p:spPr>
            <a:xfrm>
              <a:off x="196768" y="4791468"/>
              <a:ext cx="685026" cy="368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C46999BE-8AF0-4E6E-BC01-2719C60D861C}"/>
              </a:ext>
            </a:extLst>
          </p:cNvPr>
          <p:cNvGrpSpPr/>
          <p:nvPr/>
        </p:nvGrpSpPr>
        <p:grpSpPr>
          <a:xfrm>
            <a:off x="5058634" y="2451425"/>
            <a:ext cx="2353392" cy="2056509"/>
            <a:chOff x="3016471" y="4791051"/>
            <a:chExt cx="3026134" cy="2460222"/>
          </a:xfrm>
        </p:grpSpPr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B2CCCAF5-24B2-4348-9660-1FE3D3781C6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8709881"/>
                </p:ext>
              </p:extLst>
            </p:nvPr>
          </p:nvGraphicFramePr>
          <p:xfrm>
            <a:off x="3215400" y="5166016"/>
            <a:ext cx="2827205" cy="20852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3658575" imgH="2701872" progId="Prism9.Document">
                    <p:embed/>
                  </p:oleObj>
                </mc:Choice>
                <mc:Fallback>
                  <p:oleObj name="Prism 9" r:id="rId9" imgW="3658575" imgH="2701872" progId="Prism9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B2CCCAF5-24B2-4348-9660-1FE3D3781C6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215400" y="5166016"/>
                          <a:ext cx="2827205" cy="20852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CC30A6-2B3F-4C43-BF66-DA00296296F7}"/>
                </a:ext>
              </a:extLst>
            </p:cNvPr>
            <p:cNvSpPr txBox="1"/>
            <p:nvPr/>
          </p:nvSpPr>
          <p:spPr>
            <a:xfrm>
              <a:off x="3016471" y="4791051"/>
              <a:ext cx="685026" cy="368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52B39CE-D0D0-4BB6-889D-620331AA44AF}"/>
              </a:ext>
            </a:extLst>
          </p:cNvPr>
          <p:cNvGrpSpPr/>
          <p:nvPr/>
        </p:nvGrpSpPr>
        <p:grpSpPr>
          <a:xfrm>
            <a:off x="72798" y="2475425"/>
            <a:ext cx="2760393" cy="1886189"/>
            <a:chOff x="4818472" y="2361022"/>
            <a:chExt cx="2953333" cy="2054370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96130B51-9F73-4F53-8A78-4F437236172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63222801"/>
                </p:ext>
              </p:extLst>
            </p:nvPr>
          </p:nvGraphicFramePr>
          <p:xfrm>
            <a:off x="4991427" y="2634472"/>
            <a:ext cx="2780378" cy="17809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4103479" imgH="2625560" progId="Prism9.Document">
                    <p:embed/>
                  </p:oleObj>
                </mc:Choice>
                <mc:Fallback>
                  <p:oleObj name="Prism 9" r:id="rId11" imgW="4103479" imgH="2625560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96130B51-9F73-4F53-8A78-4F43723617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991427" y="2634472"/>
                          <a:ext cx="2780378" cy="17809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9789D05-EBB8-4C5D-BC88-EE48F139D5C8}"/>
                </a:ext>
              </a:extLst>
            </p:cNvPr>
            <p:cNvSpPr txBox="1"/>
            <p:nvPr/>
          </p:nvSpPr>
          <p:spPr>
            <a:xfrm>
              <a:off x="4818472" y="2361022"/>
              <a:ext cx="569973" cy="335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853E280-425E-480B-B1BF-C12B55337CAD}"/>
              </a:ext>
            </a:extLst>
          </p:cNvPr>
          <p:cNvGrpSpPr/>
          <p:nvPr/>
        </p:nvGrpSpPr>
        <p:grpSpPr>
          <a:xfrm>
            <a:off x="148796" y="4681300"/>
            <a:ext cx="1763178" cy="2274150"/>
            <a:chOff x="1864617" y="221293"/>
            <a:chExt cx="1574560" cy="2611720"/>
          </a:xfrm>
        </p:grpSpPr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764B9AEB-0763-4BAD-98DB-56026A9BD88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0738696"/>
                </p:ext>
              </p:extLst>
            </p:nvPr>
          </p:nvGraphicFramePr>
          <p:xfrm>
            <a:off x="1902417" y="326188"/>
            <a:ext cx="1536760" cy="2506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288589" imgH="3739641" progId="Prism9.Document">
                    <p:embed/>
                  </p:oleObj>
                </mc:Choice>
                <mc:Fallback>
                  <p:oleObj name="Prism 9" r:id="rId13" imgW="2288589" imgH="3739641" progId="Prism9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764B9AEB-0763-4BAD-98DB-56026A9BD88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902417" y="326188"/>
                          <a:ext cx="1536760" cy="2506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A93C888-C4D1-4E8D-A94A-18F7A1494E82}"/>
                </a:ext>
              </a:extLst>
            </p:cNvPr>
            <p:cNvSpPr txBox="1"/>
            <p:nvPr/>
          </p:nvSpPr>
          <p:spPr>
            <a:xfrm>
              <a:off x="1864617" y="221293"/>
              <a:ext cx="369065" cy="353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D1D11AE-45DF-4C77-9893-C6D159B16866}"/>
              </a:ext>
            </a:extLst>
          </p:cNvPr>
          <p:cNvGrpSpPr/>
          <p:nvPr/>
        </p:nvGrpSpPr>
        <p:grpSpPr>
          <a:xfrm>
            <a:off x="1830413" y="4662280"/>
            <a:ext cx="1518737" cy="2199141"/>
            <a:chOff x="5000742" y="230059"/>
            <a:chExt cx="1129670" cy="2098774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EAB155B-DA40-43C4-9588-3D81AADFA744}"/>
                </a:ext>
              </a:extLst>
            </p:cNvPr>
            <p:cNvSpPr txBox="1"/>
            <p:nvPr/>
          </p:nvSpPr>
          <p:spPr>
            <a:xfrm>
              <a:off x="5000742" y="230059"/>
              <a:ext cx="570131" cy="293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C01C0A48-1B72-4B08-9EB8-1BBC3EB8249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14895335"/>
                </p:ext>
              </p:extLst>
            </p:nvPr>
          </p:nvGraphicFramePr>
          <p:xfrm>
            <a:off x="5022805" y="356241"/>
            <a:ext cx="1107607" cy="19725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116531" imgH="3773118" progId="Prism9.Document">
                    <p:embed/>
                  </p:oleObj>
                </mc:Choice>
                <mc:Fallback>
                  <p:oleObj name="Prism 9" r:id="rId15" imgW="2116531" imgH="3773118" progId="Prism9.Document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C01C0A48-1B72-4B08-9EB8-1BBC3EB8249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022805" y="356241"/>
                          <a:ext cx="1107607" cy="19725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5F73D976-D144-445E-A888-4F01971873CA}"/>
              </a:ext>
            </a:extLst>
          </p:cNvPr>
          <p:cNvGrpSpPr/>
          <p:nvPr/>
        </p:nvGrpSpPr>
        <p:grpSpPr>
          <a:xfrm>
            <a:off x="3828658" y="4664403"/>
            <a:ext cx="1581042" cy="2153469"/>
            <a:chOff x="307112" y="6829776"/>
            <a:chExt cx="1691551" cy="2345481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7BDE1983-509B-44A3-B1D2-91BE79B284E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23804097"/>
                </p:ext>
              </p:extLst>
            </p:nvPr>
          </p:nvGraphicFramePr>
          <p:xfrm>
            <a:off x="454595" y="6972923"/>
            <a:ext cx="1544068" cy="22023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2617948" imgH="3733522" progId="Prism9.Document">
                    <p:embed/>
                  </p:oleObj>
                </mc:Choice>
                <mc:Fallback>
                  <p:oleObj name="Prism 9" r:id="rId17" imgW="2617948" imgH="3733522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7BDE1983-509B-44A3-B1D2-91BE79B284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454595" y="6972923"/>
                          <a:ext cx="1544068" cy="22023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C8B751C-5B02-4578-AA5D-93B0F9199611}"/>
                </a:ext>
              </a:extLst>
            </p:cNvPr>
            <p:cNvSpPr txBox="1"/>
            <p:nvPr/>
          </p:nvSpPr>
          <p:spPr>
            <a:xfrm>
              <a:off x="307112" y="6829776"/>
              <a:ext cx="820062" cy="335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BE68D072-2974-451E-BA30-B95BA6C97DBB}"/>
              </a:ext>
            </a:extLst>
          </p:cNvPr>
          <p:cNvGrpSpPr/>
          <p:nvPr/>
        </p:nvGrpSpPr>
        <p:grpSpPr>
          <a:xfrm>
            <a:off x="5608944" y="4662280"/>
            <a:ext cx="1703333" cy="2198300"/>
            <a:chOff x="2227300" y="6913137"/>
            <a:chExt cx="1822388" cy="2394309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E7E0992E-60E0-4811-9BB2-0F56D055F33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0429038"/>
                </p:ext>
              </p:extLst>
            </p:nvPr>
          </p:nvGraphicFramePr>
          <p:xfrm>
            <a:off x="2289078" y="7056790"/>
            <a:ext cx="1760610" cy="22506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2674460" imgH="3419635" progId="Prism9.Document">
                    <p:embed/>
                  </p:oleObj>
                </mc:Choice>
                <mc:Fallback>
                  <p:oleObj name="Prism 9" r:id="rId19" imgW="2674460" imgH="3419635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E7E0992E-60E0-4811-9BB2-0F56D055F33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289078" y="7056790"/>
                          <a:ext cx="1760610" cy="22506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B9B53B2-3F38-4CE2-A486-3A8DF5810933}"/>
                </a:ext>
              </a:extLst>
            </p:cNvPr>
            <p:cNvSpPr txBox="1"/>
            <p:nvPr/>
          </p:nvSpPr>
          <p:spPr>
            <a:xfrm>
              <a:off x="2227300" y="6913137"/>
              <a:ext cx="820063" cy="335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DA840772-C41F-15FE-0EFA-0E634CE9120F}"/>
              </a:ext>
            </a:extLst>
          </p:cNvPr>
          <p:cNvGrpSpPr/>
          <p:nvPr/>
        </p:nvGrpSpPr>
        <p:grpSpPr>
          <a:xfrm>
            <a:off x="51220" y="7160574"/>
            <a:ext cx="2584376" cy="2198224"/>
            <a:chOff x="110165" y="6792288"/>
            <a:chExt cx="2584376" cy="2198224"/>
          </a:xfrm>
        </p:grpSpPr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BD7BD74E-F2F8-2662-7702-CF8B8773B1D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253087"/>
                </p:ext>
              </p:extLst>
            </p:nvPr>
          </p:nvGraphicFramePr>
          <p:xfrm>
            <a:off x="209705" y="7246112"/>
            <a:ext cx="2484836" cy="1744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1" imgW="4012050" imgH="2815980" progId="Prism9.Document">
                    <p:embed/>
                  </p:oleObj>
                </mc:Choice>
                <mc:Fallback>
                  <p:oleObj name="Prism 9" r:id="rId21" imgW="4012050" imgH="2815980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BD7BD74E-F2F8-2662-7702-CF8B8773B1D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09705" y="7246112"/>
                          <a:ext cx="2484836" cy="1744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974A79C-31A6-8B90-86BC-35243A83CA98}"/>
                </a:ext>
              </a:extLst>
            </p:cNvPr>
            <p:cNvSpPr txBox="1"/>
            <p:nvPr/>
          </p:nvSpPr>
          <p:spPr>
            <a:xfrm>
              <a:off x="110165" y="6792288"/>
              <a:ext cx="7664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76650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88">
            <a:extLst>
              <a:ext uri="{FF2B5EF4-FFF2-40B4-BE49-F238E27FC236}">
                <a16:creationId xmlns:a16="http://schemas.microsoft.com/office/drawing/2014/main" id="{C16B1A39-7803-4B2F-A559-98980E35FAE8}"/>
              </a:ext>
            </a:extLst>
          </p:cNvPr>
          <p:cNvGrpSpPr/>
          <p:nvPr/>
        </p:nvGrpSpPr>
        <p:grpSpPr>
          <a:xfrm>
            <a:off x="684530" y="4525051"/>
            <a:ext cx="2720594" cy="2765931"/>
            <a:chOff x="-13648" y="4942398"/>
            <a:chExt cx="3638362" cy="3766488"/>
          </a:xfrm>
        </p:grpSpPr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00A2D1C9-303A-4B6F-850C-C7638096E1FB}"/>
                </a:ext>
              </a:extLst>
            </p:cNvPr>
            <p:cNvGrpSpPr/>
            <p:nvPr/>
          </p:nvGrpSpPr>
          <p:grpSpPr>
            <a:xfrm>
              <a:off x="-13648" y="5438336"/>
              <a:ext cx="3638362" cy="3270550"/>
              <a:chOff x="82346" y="3284413"/>
              <a:chExt cx="3150711" cy="2879023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93C2877-6BEA-483A-B4F4-163AA990D5D1}"/>
                  </a:ext>
                </a:extLst>
              </p:cNvPr>
              <p:cNvSpPr txBox="1"/>
              <p:nvPr/>
            </p:nvSpPr>
            <p:spPr>
              <a:xfrm>
                <a:off x="1152645" y="3286813"/>
                <a:ext cx="699530" cy="405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D9ACAE00-7058-4274-9115-D9A483E1ED69}"/>
                  </a:ext>
                </a:extLst>
              </p:cNvPr>
              <p:cNvSpPr txBox="1"/>
              <p:nvPr/>
            </p:nvSpPr>
            <p:spPr>
              <a:xfrm>
                <a:off x="2275758" y="3284413"/>
                <a:ext cx="816776" cy="2582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ylt1/2 KO</a:t>
                </a:r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D0103C81-6AA2-4DEF-BC11-0DEDF18CE33C}"/>
                  </a:ext>
                </a:extLst>
              </p:cNvPr>
              <p:cNvGrpSpPr/>
              <p:nvPr/>
            </p:nvGrpSpPr>
            <p:grpSpPr>
              <a:xfrm>
                <a:off x="82346" y="3397564"/>
                <a:ext cx="3150711" cy="2765872"/>
                <a:chOff x="82346" y="3397564"/>
                <a:chExt cx="3150711" cy="2765872"/>
              </a:xfrm>
            </p:grpSpPr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8A35A26F-F227-4C90-BAF1-AEE32D42FE72}"/>
                    </a:ext>
                  </a:extLst>
                </p:cNvPr>
                <p:cNvGrpSpPr/>
                <p:nvPr/>
              </p:nvGrpSpPr>
              <p:grpSpPr>
                <a:xfrm>
                  <a:off x="82346" y="3468774"/>
                  <a:ext cx="3150711" cy="2694662"/>
                  <a:chOff x="82346" y="3468774"/>
                  <a:chExt cx="3150711" cy="2694662"/>
                </a:xfrm>
              </p:grpSpPr>
              <p:grpSp>
                <p:nvGrpSpPr>
                  <p:cNvPr id="77" name="Group 76">
                    <a:extLst>
                      <a:ext uri="{FF2B5EF4-FFF2-40B4-BE49-F238E27FC236}">
                        <a16:creationId xmlns:a16="http://schemas.microsoft.com/office/drawing/2014/main" id="{448942C5-84D3-428F-A5D5-E2975E10C9DC}"/>
                      </a:ext>
                    </a:extLst>
                  </p:cNvPr>
                  <p:cNvGrpSpPr/>
                  <p:nvPr/>
                </p:nvGrpSpPr>
                <p:grpSpPr>
                  <a:xfrm>
                    <a:off x="82346" y="3468774"/>
                    <a:ext cx="3150711" cy="2693900"/>
                    <a:chOff x="82346" y="3468774"/>
                    <a:chExt cx="3150711" cy="2693900"/>
                  </a:xfrm>
                </p:grpSpPr>
                <p:grpSp>
                  <p:nvGrpSpPr>
                    <p:cNvPr id="76" name="Group 75">
                      <a:extLst>
                        <a:ext uri="{FF2B5EF4-FFF2-40B4-BE49-F238E27FC236}">
                          <a16:creationId xmlns:a16="http://schemas.microsoft.com/office/drawing/2014/main" id="{CA661F70-F308-4E7D-BE81-7A055360A9A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95499" y="3468775"/>
                      <a:ext cx="1337558" cy="2693899"/>
                      <a:chOff x="2594362" y="3514468"/>
                      <a:chExt cx="1305521" cy="2633976"/>
                    </a:xfrm>
                  </p:grpSpPr>
                  <p:pic>
                    <p:nvPicPr>
                      <p:cNvPr id="51" name="Picture 50">
                        <a:extLst>
                          <a:ext uri="{FF2B5EF4-FFF2-40B4-BE49-F238E27FC236}">
                            <a16:creationId xmlns:a16="http://schemas.microsoft.com/office/drawing/2014/main" id="{ABC0696D-4AAC-4C80-8984-BF9A3ACAD801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94362" y="3514468"/>
                        <a:ext cx="1305521" cy="1285657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54" name="Picture 53">
                        <a:extLst>
                          <a:ext uri="{FF2B5EF4-FFF2-40B4-BE49-F238E27FC236}">
                            <a16:creationId xmlns:a16="http://schemas.microsoft.com/office/drawing/2014/main" id="{FCCCD10F-107A-43B6-93C0-FD937A527CFC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94362" y="4710653"/>
                        <a:ext cx="1305521" cy="128565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3" name="TextBox 62">
                        <a:extLst>
                          <a:ext uri="{FF2B5EF4-FFF2-40B4-BE49-F238E27FC236}">
                            <a16:creationId xmlns:a16="http://schemas.microsoft.com/office/drawing/2014/main" id="{78119261-0096-4780-918A-06331C544C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89844" y="5895930"/>
                        <a:ext cx="1010039" cy="252514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iameter (nm)</a:t>
                        </a:r>
                      </a:p>
                    </p:txBody>
                  </p:sp>
                </p:grpSp>
                <p:grpSp>
                  <p:nvGrpSpPr>
                    <p:cNvPr id="75" name="Group 74">
                      <a:extLst>
                        <a:ext uri="{FF2B5EF4-FFF2-40B4-BE49-F238E27FC236}">
                          <a16:creationId xmlns:a16="http://schemas.microsoft.com/office/drawing/2014/main" id="{BE51E7A4-7603-48FF-AE82-43D39DDE4DB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346" y="3468774"/>
                      <a:ext cx="1913322" cy="2549439"/>
                      <a:chOff x="82346" y="3468774"/>
                      <a:chExt cx="1913322" cy="2549439"/>
                    </a:xfrm>
                  </p:grpSpPr>
                  <p:grpSp>
                    <p:nvGrpSpPr>
                      <p:cNvPr id="35" name="Group 34">
                        <a:extLst>
                          <a:ext uri="{FF2B5EF4-FFF2-40B4-BE49-F238E27FC236}">
                            <a16:creationId xmlns:a16="http://schemas.microsoft.com/office/drawing/2014/main" id="{5D565AA9-9685-42BE-A35A-8B996935061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6687" y="3468774"/>
                        <a:ext cx="1758981" cy="1322045"/>
                        <a:chOff x="416593" y="4005806"/>
                        <a:chExt cx="4090319" cy="3000375"/>
                      </a:xfrm>
                    </p:grpSpPr>
                    <p:pic>
                      <p:nvPicPr>
                        <p:cNvPr id="36" name="Picture 35">
                          <a:extLst>
                            <a:ext uri="{FF2B5EF4-FFF2-40B4-BE49-F238E27FC236}">
                              <a16:creationId xmlns:a16="http://schemas.microsoft.com/office/drawing/2014/main" id="{E2B641D3-8717-4951-8D67-89A35378015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516062" y="4005806"/>
                          <a:ext cx="2990850" cy="3000375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37" name="TextBox 36">
                          <a:extLst>
                            <a:ext uri="{FF2B5EF4-FFF2-40B4-BE49-F238E27FC236}">
                              <a16:creationId xmlns:a16="http://schemas.microsoft.com/office/drawing/2014/main" id="{E3709B3B-3DDD-4D6F-A390-4266599CC00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16593" y="5137872"/>
                          <a:ext cx="1426150" cy="58611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8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EV</a:t>
                          </a:r>
                          <a:endPara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34" name="Group 33">
                        <a:extLst>
                          <a:ext uri="{FF2B5EF4-FFF2-40B4-BE49-F238E27FC236}">
                            <a16:creationId xmlns:a16="http://schemas.microsoft.com/office/drawing/2014/main" id="{BAE40A94-574F-481F-BE22-261C782F078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2346" y="4696169"/>
                        <a:ext cx="1899464" cy="1322044"/>
                        <a:chOff x="2838256" y="6773068"/>
                        <a:chExt cx="4417002" cy="3000374"/>
                      </a:xfrm>
                    </p:grpSpPr>
                    <p:sp>
                      <p:nvSpPr>
                        <p:cNvPr id="38" name="TextBox 37">
                          <a:extLst>
                            <a:ext uri="{FF2B5EF4-FFF2-40B4-BE49-F238E27FC236}">
                              <a16:creationId xmlns:a16="http://schemas.microsoft.com/office/drawing/2014/main" id="{77A4464E-4F97-4547-8A8E-59BCCCE464A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38256" y="7803923"/>
                          <a:ext cx="1436498" cy="58611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8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R-</a:t>
                          </a:r>
                          <a:r>
                            <a:rPr lang="en-US" sz="8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EV</a:t>
                          </a:r>
                          <a:endPara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pic>
                      <p:nvPicPr>
                        <p:cNvPr id="39" name="Picture 38">
                          <a:extLst>
                            <a:ext uri="{FF2B5EF4-FFF2-40B4-BE49-F238E27FC236}">
                              <a16:creationId xmlns:a16="http://schemas.microsoft.com/office/drawing/2014/main" id="{30BD6D33-356D-492A-B2DF-E9E76258860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264408" y="6773068"/>
                          <a:ext cx="2990850" cy="3000374"/>
                        </a:xfrm>
                        <a:prstGeom prst="rect">
                          <a:avLst/>
                        </a:prstGeom>
                      </p:spPr>
                    </p:pic>
                  </p:grpSp>
                </p:grpSp>
              </p:grp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5356F229-98A5-47EA-B4BF-3CA906AED4B8}"/>
                      </a:ext>
                    </a:extLst>
                  </p:cNvPr>
                  <p:cNvSpPr txBox="1"/>
                  <p:nvPr/>
                </p:nvSpPr>
                <p:spPr>
                  <a:xfrm>
                    <a:off x="1004259" y="5905178"/>
                    <a:ext cx="1043092" cy="258258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ameter (nm)</a:t>
                    </a:r>
                  </a:p>
                </p:txBody>
              </p: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1D1B5FC6-7E69-4BA7-904B-E1E578493BA5}"/>
                    </a:ext>
                  </a:extLst>
                </p:cNvPr>
                <p:cNvSpPr txBox="1"/>
                <p:nvPr/>
              </p:nvSpPr>
              <p:spPr>
                <a:xfrm rot="16200000">
                  <a:off x="47355" y="3924317"/>
                  <a:ext cx="1303011" cy="24950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ticles/mL (10</a:t>
                  </a:r>
                  <a:r>
                    <a:rPr lang="en-US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7E547CBA-890D-4BE3-8ECE-7F084574C22F}"/>
                  </a:ext>
                </a:extLst>
              </p:cNvPr>
              <p:cNvSpPr txBox="1"/>
              <p:nvPr/>
            </p:nvSpPr>
            <p:spPr>
              <a:xfrm rot="16200000">
                <a:off x="54379" y="5134365"/>
                <a:ext cx="1322043" cy="24950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ticles/mL (10</a:t>
                </a:r>
                <a:r>
                  <a:rPr lang="en-US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DE4FFA2-4AE1-4226-81DE-7293A6A6599E}"/>
                </a:ext>
              </a:extLst>
            </p:cNvPr>
            <p:cNvSpPr txBox="1"/>
            <p:nvPr/>
          </p:nvSpPr>
          <p:spPr>
            <a:xfrm>
              <a:off x="182294" y="4942398"/>
              <a:ext cx="539659" cy="4191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7BFED1E9-ED9B-4E24-B980-1ADAF7AAF876}"/>
              </a:ext>
            </a:extLst>
          </p:cNvPr>
          <p:cNvGrpSpPr/>
          <p:nvPr/>
        </p:nvGrpSpPr>
        <p:grpSpPr>
          <a:xfrm>
            <a:off x="849450" y="7867616"/>
            <a:ext cx="1962036" cy="1890360"/>
            <a:chOff x="3971510" y="5252760"/>
            <a:chExt cx="2059202" cy="1961664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BA44FDF8-B788-4450-901E-5EABDBC85C61}"/>
                </a:ext>
              </a:extLst>
            </p:cNvPr>
            <p:cNvGrpSpPr/>
            <p:nvPr/>
          </p:nvGrpSpPr>
          <p:grpSpPr>
            <a:xfrm>
              <a:off x="4147688" y="5474279"/>
              <a:ext cx="1883024" cy="1740145"/>
              <a:chOff x="1054100" y="1357765"/>
              <a:chExt cx="3822559" cy="3304722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50C51FE6-EC5B-4991-9D83-4E803515CF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54100" y="1662112"/>
                <a:ext cx="3048000" cy="3000375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C0A72FC-D097-4234-BD4B-741B10A46C2D}"/>
                  </a:ext>
                </a:extLst>
              </p:cNvPr>
              <p:cNvSpPr txBox="1"/>
              <p:nvPr/>
            </p:nvSpPr>
            <p:spPr>
              <a:xfrm>
                <a:off x="1979672" y="1357765"/>
                <a:ext cx="2896987" cy="4549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DA CD44</a:t>
                </a:r>
              </a:p>
            </p:txBody>
          </p:sp>
        </p:grp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63F77F1-1A53-483D-B3E3-5C1CC0DD3A2A}"/>
                </a:ext>
              </a:extLst>
            </p:cNvPr>
            <p:cNvSpPr txBox="1"/>
            <p:nvPr/>
          </p:nvSpPr>
          <p:spPr>
            <a:xfrm>
              <a:off x="3971510" y="5252760"/>
              <a:ext cx="539658" cy="319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F6DE18B7-92EF-43A4-9E24-DC6B05141FD8}"/>
              </a:ext>
            </a:extLst>
          </p:cNvPr>
          <p:cNvGrpSpPr/>
          <p:nvPr/>
        </p:nvGrpSpPr>
        <p:grpSpPr>
          <a:xfrm>
            <a:off x="3658324" y="4453006"/>
            <a:ext cx="2768618" cy="2886014"/>
            <a:chOff x="3357092" y="4808453"/>
            <a:chExt cx="3177825" cy="3271151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C4F425C-2CC7-46C3-B33F-5A6FF560A916}"/>
                </a:ext>
              </a:extLst>
            </p:cNvPr>
            <p:cNvGrpSpPr/>
            <p:nvPr/>
          </p:nvGrpSpPr>
          <p:grpSpPr>
            <a:xfrm>
              <a:off x="3862722" y="5347431"/>
              <a:ext cx="2672195" cy="2615918"/>
              <a:chOff x="3862722" y="5347431"/>
              <a:chExt cx="2672195" cy="2615918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38B7DA01-D6E9-4987-93FB-591A3EDBA5CB}"/>
                  </a:ext>
                </a:extLst>
              </p:cNvPr>
              <p:cNvGrpSpPr/>
              <p:nvPr/>
            </p:nvGrpSpPr>
            <p:grpSpPr>
              <a:xfrm>
                <a:off x="5160575" y="5347431"/>
                <a:ext cx="1374342" cy="2607265"/>
                <a:chOff x="5160575" y="5365015"/>
                <a:chExt cx="1374342" cy="2607265"/>
              </a:xfrm>
            </p:grpSpPr>
            <p:pic>
              <p:nvPicPr>
                <p:cNvPr id="78" name="Picture 77">
                  <a:extLst>
                    <a:ext uri="{FF2B5EF4-FFF2-40B4-BE49-F238E27FC236}">
                      <a16:creationId xmlns:a16="http://schemas.microsoft.com/office/drawing/2014/main" id="{2C476843-B0AC-4937-B51A-F43F95545A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5161640" y="5365015"/>
                  <a:ext cx="1373277" cy="1351820"/>
                </a:xfrm>
                <a:prstGeom prst="rect">
                  <a:avLst/>
                </a:prstGeom>
              </p:spPr>
            </p:pic>
            <p:pic>
              <p:nvPicPr>
                <p:cNvPr id="93" name="Picture 92">
                  <a:extLst>
                    <a:ext uri="{FF2B5EF4-FFF2-40B4-BE49-F238E27FC236}">
                      <a16:creationId xmlns:a16="http://schemas.microsoft.com/office/drawing/2014/main" id="{345F6C7C-937A-4194-A757-8730809686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5160575" y="6620460"/>
                  <a:ext cx="1373277" cy="1351820"/>
                </a:xfrm>
                <a:prstGeom prst="rect">
                  <a:avLst/>
                </a:prstGeom>
              </p:spPr>
            </p:pic>
          </p:grp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D35047E0-C18D-4611-AF84-9A3F36FC6A40}"/>
                  </a:ext>
                </a:extLst>
              </p:cNvPr>
              <p:cNvGrpSpPr/>
              <p:nvPr/>
            </p:nvGrpSpPr>
            <p:grpSpPr>
              <a:xfrm>
                <a:off x="3862722" y="5354524"/>
                <a:ext cx="1373277" cy="2608825"/>
                <a:chOff x="3862722" y="5354524"/>
                <a:chExt cx="1373277" cy="2608825"/>
              </a:xfrm>
            </p:grpSpPr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6DFEBAF6-F7B5-4577-AE59-20C0991EAC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862722" y="5354524"/>
                  <a:ext cx="1373277" cy="1351820"/>
                </a:xfrm>
                <a:prstGeom prst="rect">
                  <a:avLst/>
                </a:prstGeom>
              </p:spPr>
            </p:pic>
            <p:pic>
              <p:nvPicPr>
                <p:cNvPr id="74" name="Picture 73">
                  <a:extLst>
                    <a:ext uri="{FF2B5EF4-FFF2-40B4-BE49-F238E27FC236}">
                      <a16:creationId xmlns:a16="http://schemas.microsoft.com/office/drawing/2014/main" id="{A078A374-E259-4D0A-A4F2-172C199FFD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3862722" y="6611529"/>
                  <a:ext cx="1373277" cy="135182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9B437B4-8ABD-4E94-B7D1-3042EC733272}"/>
                </a:ext>
              </a:extLst>
            </p:cNvPr>
            <p:cNvGrpSpPr/>
            <p:nvPr/>
          </p:nvGrpSpPr>
          <p:grpSpPr>
            <a:xfrm>
              <a:off x="3357092" y="4808453"/>
              <a:ext cx="3137621" cy="3271151"/>
              <a:chOff x="3357092" y="4808453"/>
              <a:chExt cx="3137621" cy="3271151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938093D4-AAF9-4C32-A1D0-5FB3D6C00AF0}"/>
                  </a:ext>
                </a:extLst>
              </p:cNvPr>
              <p:cNvGrpSpPr/>
              <p:nvPr/>
            </p:nvGrpSpPr>
            <p:grpSpPr>
              <a:xfrm>
                <a:off x="3357092" y="4808453"/>
                <a:ext cx="3137621" cy="3271151"/>
                <a:chOff x="241478" y="5029343"/>
                <a:chExt cx="2584911" cy="2719069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F7C20C50-1752-4006-965A-DEC6290A63AE}"/>
                    </a:ext>
                  </a:extLst>
                </p:cNvPr>
                <p:cNvSpPr txBox="1"/>
                <p:nvPr/>
              </p:nvSpPr>
              <p:spPr>
                <a:xfrm>
                  <a:off x="443077" y="5029343"/>
                  <a:ext cx="556675" cy="2899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grpSp>
              <p:nvGrpSpPr>
                <p:cNvPr id="52" name="Group 51">
                  <a:extLst>
                    <a:ext uri="{FF2B5EF4-FFF2-40B4-BE49-F238E27FC236}">
                      <a16:creationId xmlns:a16="http://schemas.microsoft.com/office/drawing/2014/main" id="{AADC7FC2-B3D3-4FDA-AFFE-514F0A5DDB35}"/>
                    </a:ext>
                  </a:extLst>
                </p:cNvPr>
                <p:cNvGrpSpPr/>
                <p:nvPr/>
              </p:nvGrpSpPr>
              <p:grpSpPr>
                <a:xfrm>
                  <a:off x="241478" y="5785016"/>
                  <a:ext cx="2584911" cy="1963396"/>
                  <a:chOff x="3406324" y="5502409"/>
                  <a:chExt cx="2361674" cy="1751348"/>
                </a:xfrm>
              </p:grpSpPr>
              <p:grpSp>
                <p:nvGrpSpPr>
                  <p:cNvPr id="53" name="Group 52">
                    <a:extLst>
                      <a:ext uri="{FF2B5EF4-FFF2-40B4-BE49-F238E27FC236}">
                        <a16:creationId xmlns:a16="http://schemas.microsoft.com/office/drawing/2014/main" id="{CCCA29C4-4A12-4564-8B13-EBDFA2053791}"/>
                      </a:ext>
                    </a:extLst>
                  </p:cNvPr>
                  <p:cNvGrpSpPr/>
                  <p:nvPr/>
                </p:nvGrpSpPr>
                <p:grpSpPr>
                  <a:xfrm>
                    <a:off x="3406324" y="6470698"/>
                    <a:ext cx="2361674" cy="783059"/>
                    <a:chOff x="3406324" y="6414711"/>
                    <a:chExt cx="2361674" cy="783059"/>
                  </a:xfrm>
                </p:grpSpPr>
                <p:grpSp>
                  <p:nvGrpSpPr>
                    <p:cNvPr id="56" name="Group 55">
                      <a:extLst>
                        <a:ext uri="{FF2B5EF4-FFF2-40B4-BE49-F238E27FC236}">
                          <a16:creationId xmlns:a16="http://schemas.microsoft.com/office/drawing/2014/main" id="{BBAB3092-2B81-4A88-B045-53C39E3F21A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38320" y="7042577"/>
                      <a:ext cx="1729678" cy="155193"/>
                      <a:chOff x="4038320" y="7042577"/>
                      <a:chExt cx="1729678" cy="155193"/>
                    </a:xfrm>
                  </p:grpSpPr>
                  <p:sp>
                    <p:nvSpPr>
                      <p:cNvPr id="62" name="TextBox 61">
                        <a:extLst>
                          <a:ext uri="{FF2B5EF4-FFF2-40B4-BE49-F238E27FC236}">
                            <a16:creationId xmlns:a16="http://schemas.microsoft.com/office/drawing/2014/main" id="{5042FABA-95CD-4453-A4A6-75567999755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253097" y="7042577"/>
                        <a:ext cx="1514901" cy="15519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                  CD81</a:t>
                        </a:r>
                      </a:p>
                    </p:txBody>
                  </p:sp>
                  <p:cxnSp>
                    <p:nvCxnSpPr>
                      <p:cNvPr id="59" name="Straight Arrow Connector 58">
                        <a:extLst>
                          <a:ext uri="{FF2B5EF4-FFF2-40B4-BE49-F238E27FC236}">
                            <a16:creationId xmlns:a16="http://schemas.microsoft.com/office/drawing/2014/main" id="{C23EEEDA-6B26-42EE-BC72-347E594FF68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038320" y="7042914"/>
                        <a:ext cx="1729678" cy="0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7" name="TextBox 56">
                      <a:extLst>
                        <a:ext uri="{FF2B5EF4-FFF2-40B4-BE49-F238E27FC236}">
                          <a16:creationId xmlns:a16="http://schemas.microsoft.com/office/drawing/2014/main" id="{9B6F2B24-B619-4AF6-9749-E74E5AA625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06324" y="6414711"/>
                      <a:ext cx="508600" cy="38798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-</a:t>
                      </a:r>
                      <a:r>
                        <a:rPr lang="en-US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V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51129607-51AD-41B5-A453-9776CCC7F9C5}"/>
                      </a:ext>
                    </a:extLst>
                  </p:cNvPr>
                  <p:cNvSpPr txBox="1"/>
                  <p:nvPr/>
                </p:nvSpPr>
                <p:spPr>
                  <a:xfrm>
                    <a:off x="3449905" y="5502409"/>
                    <a:ext cx="458172" cy="594908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V</a:t>
                    </a:r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endPara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D1AC3F08-B12C-48B7-9F5F-5693826813BE}"/>
                  </a:ext>
                </a:extLst>
              </p:cNvPr>
              <p:cNvSpPr txBox="1"/>
              <p:nvPr/>
            </p:nvSpPr>
            <p:spPr>
              <a:xfrm>
                <a:off x="4321077" y="5193161"/>
                <a:ext cx="745914" cy="2465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6C3EC2EF-E6BA-4F8A-9DE1-0D20A35550D6}"/>
                  </a:ext>
                </a:extLst>
              </p:cNvPr>
              <p:cNvSpPr txBox="1"/>
              <p:nvPr/>
            </p:nvSpPr>
            <p:spPr>
              <a:xfrm>
                <a:off x="5518661" y="5190692"/>
                <a:ext cx="870934" cy="2465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ylt1/2 KO</a:t>
                </a:r>
              </a:p>
            </p:txBody>
          </p:sp>
        </p:grp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7AEE3D5-834E-4E33-BFD7-6242158DAE56}"/>
              </a:ext>
            </a:extLst>
          </p:cNvPr>
          <p:cNvGrpSpPr/>
          <p:nvPr/>
        </p:nvGrpSpPr>
        <p:grpSpPr>
          <a:xfrm>
            <a:off x="5261133" y="7851939"/>
            <a:ext cx="2058887" cy="2380472"/>
            <a:chOff x="3541915" y="7927496"/>
            <a:chExt cx="2058887" cy="2380472"/>
          </a:xfrm>
        </p:grpSpPr>
        <p:graphicFrame>
          <p:nvGraphicFramePr>
            <p:cNvPr id="97" name="Object 96">
              <a:extLst>
                <a:ext uri="{FF2B5EF4-FFF2-40B4-BE49-F238E27FC236}">
                  <a16:creationId xmlns:a16="http://schemas.microsoft.com/office/drawing/2014/main" id="{4F92CE3C-9FC1-4EBE-A7A3-73F73BB5775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91732493"/>
                </p:ext>
              </p:extLst>
            </p:nvPr>
          </p:nvGraphicFramePr>
          <p:xfrm>
            <a:off x="3659992" y="8310515"/>
            <a:ext cx="1940810" cy="199745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3715088" imgH="3547422" progId="Prism9.Document">
                    <p:embed/>
                  </p:oleObj>
                </mc:Choice>
                <mc:Fallback>
                  <p:oleObj name="Prism 9" r:id="rId12" imgW="3715088" imgH="3547422" progId="Prism9.Document">
                    <p:embed/>
                    <p:pic>
                      <p:nvPicPr>
                        <p:cNvPr id="97" name="Object 96">
                          <a:extLst>
                            <a:ext uri="{FF2B5EF4-FFF2-40B4-BE49-F238E27FC236}">
                              <a16:creationId xmlns:a16="http://schemas.microsoft.com/office/drawing/2014/main" id="{4F92CE3C-9FC1-4EBE-A7A3-73F73BB5775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659992" y="8310515"/>
                          <a:ext cx="1940810" cy="199745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736B97B-E4A5-43EB-8127-EE11E6611164}"/>
                </a:ext>
              </a:extLst>
            </p:cNvPr>
            <p:cNvSpPr txBox="1"/>
            <p:nvPr/>
          </p:nvSpPr>
          <p:spPr>
            <a:xfrm>
              <a:off x="3541915" y="7927496"/>
              <a:ext cx="6443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013A9DE1-3747-463B-8963-7B6AD1CCE29B}"/>
              </a:ext>
            </a:extLst>
          </p:cNvPr>
          <p:cNvGrpSpPr/>
          <p:nvPr/>
        </p:nvGrpSpPr>
        <p:grpSpPr>
          <a:xfrm>
            <a:off x="724093" y="581691"/>
            <a:ext cx="6468953" cy="3804622"/>
            <a:chOff x="-136119" y="216579"/>
            <a:chExt cx="7988432" cy="4688735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7152458-09D4-4F13-96C0-8252B5EF6399}"/>
                </a:ext>
              </a:extLst>
            </p:cNvPr>
            <p:cNvGrpSpPr/>
            <p:nvPr/>
          </p:nvGrpSpPr>
          <p:grpSpPr>
            <a:xfrm>
              <a:off x="-136119" y="216579"/>
              <a:ext cx="7988432" cy="4688735"/>
              <a:chOff x="-144420" y="148013"/>
              <a:chExt cx="7988432" cy="4688735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E1D10B61-C475-4946-B1D9-79A19C3C5B7D}"/>
                  </a:ext>
                </a:extLst>
              </p:cNvPr>
              <p:cNvGrpSpPr/>
              <p:nvPr/>
            </p:nvGrpSpPr>
            <p:grpSpPr>
              <a:xfrm>
                <a:off x="3885405" y="148013"/>
                <a:ext cx="3958607" cy="3295650"/>
                <a:chOff x="3892693" y="3902103"/>
                <a:chExt cx="2956582" cy="2008188"/>
              </a:xfrm>
            </p:grpSpPr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3268C10B-C92F-407B-851A-8A9359E75EB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66235429"/>
                    </p:ext>
                  </p:extLst>
                </p:nvPr>
              </p:nvGraphicFramePr>
              <p:xfrm>
                <a:off x="3994198" y="3902103"/>
                <a:ext cx="2855077" cy="20081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4" imgW="4664288" imgH="3596377" progId="Prism9.Document">
                        <p:embed/>
                      </p:oleObj>
                    </mc:Choice>
                    <mc:Fallback>
                      <p:oleObj name="Prism 9" r:id="rId14" imgW="4664288" imgH="3596377" progId="Prism9.Document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3268C10B-C92F-407B-851A-8A9359E75EB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994198" y="3902103"/>
                              <a:ext cx="2855077" cy="200818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F050EB4E-2DE3-4E5B-A250-01CD53D57236}"/>
                    </a:ext>
                  </a:extLst>
                </p:cNvPr>
                <p:cNvSpPr txBox="1"/>
                <p:nvPr/>
              </p:nvSpPr>
              <p:spPr>
                <a:xfrm>
                  <a:off x="3892693" y="3973846"/>
                  <a:ext cx="403057" cy="2311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833F56B5-B0C5-48C6-B1EB-DA18CFB0115A}"/>
                  </a:ext>
                </a:extLst>
              </p:cNvPr>
              <p:cNvSpPr txBox="1"/>
              <p:nvPr/>
            </p:nvSpPr>
            <p:spPr>
              <a:xfrm>
                <a:off x="-144420" y="294708"/>
                <a:ext cx="539658" cy="3792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aphicFrame>
            <p:nvGraphicFramePr>
              <p:cNvPr id="11" name="Object 10">
                <a:extLst>
                  <a:ext uri="{FF2B5EF4-FFF2-40B4-BE49-F238E27FC236}">
                    <a16:creationId xmlns:a16="http://schemas.microsoft.com/office/drawing/2014/main" id="{136FD37B-14C9-49B9-AD19-F11EECCB19C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27779730"/>
                  </p:ext>
                </p:extLst>
              </p:nvPr>
            </p:nvGraphicFramePr>
            <p:xfrm>
              <a:off x="0" y="742586"/>
              <a:ext cx="7770811" cy="40941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6" imgW="7771413" imgH="4094563" progId="Prism9.Document">
                      <p:embed/>
                    </p:oleObj>
                  </mc:Choice>
                  <mc:Fallback>
                    <p:oleObj name="Prism 9" r:id="rId16" imgW="7771413" imgH="4094563" progId="Prism9.Document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136FD37B-14C9-49B9-AD19-F11EECCB19C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0" y="742586"/>
                            <a:ext cx="7770811" cy="40941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FEFFEE1-99D9-4E2A-936D-585001742FCD}"/>
                </a:ext>
              </a:extLst>
            </p:cNvPr>
            <p:cNvSpPr txBox="1"/>
            <p:nvPr/>
          </p:nvSpPr>
          <p:spPr>
            <a:xfrm>
              <a:off x="-100849" y="3359034"/>
              <a:ext cx="498316" cy="379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11288D71-BF50-47BE-82C5-8CAF920AE6C9}"/>
              </a:ext>
            </a:extLst>
          </p:cNvPr>
          <p:cNvGrpSpPr/>
          <p:nvPr/>
        </p:nvGrpSpPr>
        <p:grpSpPr>
          <a:xfrm>
            <a:off x="2511568" y="7840412"/>
            <a:ext cx="1404928" cy="1890207"/>
            <a:chOff x="2628386" y="6994034"/>
            <a:chExt cx="1404928" cy="1890207"/>
          </a:xfrm>
        </p:grpSpPr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D70D2B23-9355-4F1F-B1EF-A07DDC6F0F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4591360"/>
                </p:ext>
              </p:extLst>
            </p:nvPr>
          </p:nvGraphicFramePr>
          <p:xfrm>
            <a:off x="2682574" y="7375059"/>
            <a:ext cx="1350740" cy="15091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8" imgW="2422852" imgH="2706191" progId="Prism9.Document">
                    <p:embed/>
                  </p:oleObj>
                </mc:Choice>
                <mc:Fallback>
                  <p:oleObj name="Prism 9" r:id="rId18" imgW="2422852" imgH="2706191" progId="Prism9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D70D2B23-9355-4F1F-B1EF-A07DDC6F0F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2682574" y="7375059"/>
                          <a:ext cx="1350740" cy="15091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7A2CD74-1790-4FA8-BE6C-E06CD50DE590}"/>
                </a:ext>
              </a:extLst>
            </p:cNvPr>
            <p:cNvSpPr txBox="1"/>
            <p:nvPr/>
          </p:nvSpPr>
          <p:spPr>
            <a:xfrm>
              <a:off x="2628386" y="6994034"/>
              <a:ext cx="6443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B32AB84E-1290-491F-9E16-79F8F3362E4D}"/>
              </a:ext>
            </a:extLst>
          </p:cNvPr>
          <p:cNvGrpSpPr/>
          <p:nvPr/>
        </p:nvGrpSpPr>
        <p:grpSpPr>
          <a:xfrm>
            <a:off x="3843691" y="7853441"/>
            <a:ext cx="1423546" cy="1880935"/>
            <a:chOff x="3960509" y="6977567"/>
            <a:chExt cx="1423546" cy="1880935"/>
          </a:xfrm>
        </p:grpSpPr>
        <p:graphicFrame>
          <p:nvGraphicFramePr>
            <p:cNvPr id="17" name="Object 16">
              <a:extLst>
                <a:ext uri="{FF2B5EF4-FFF2-40B4-BE49-F238E27FC236}">
                  <a16:creationId xmlns:a16="http://schemas.microsoft.com/office/drawing/2014/main" id="{F40E1E4E-842A-4874-B9DA-9521FC6C263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6564365"/>
                </p:ext>
              </p:extLst>
            </p:nvPr>
          </p:nvGraphicFramePr>
          <p:xfrm>
            <a:off x="4033314" y="7336042"/>
            <a:ext cx="1350741" cy="15224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0" imgW="2422852" imgH="2730669" progId="Prism9.Document">
                    <p:embed/>
                  </p:oleObj>
                </mc:Choice>
                <mc:Fallback>
                  <p:oleObj name="Prism 9" r:id="rId20" imgW="2422852" imgH="2730669" progId="Prism9.Document">
                    <p:embed/>
                    <p:pic>
                      <p:nvPicPr>
                        <p:cNvPr id="17" name="Object 16">
                          <a:extLst>
                            <a:ext uri="{FF2B5EF4-FFF2-40B4-BE49-F238E27FC236}">
                              <a16:creationId xmlns:a16="http://schemas.microsoft.com/office/drawing/2014/main" id="{F40E1E4E-842A-4874-B9DA-9521FC6C263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033314" y="7336042"/>
                          <a:ext cx="1350741" cy="152246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B13CFCB9-4F41-40AC-BA72-CC4D75581CFB}"/>
                </a:ext>
              </a:extLst>
            </p:cNvPr>
            <p:cNvSpPr txBox="1"/>
            <p:nvPr/>
          </p:nvSpPr>
          <p:spPr>
            <a:xfrm>
              <a:off x="3960509" y="6977567"/>
              <a:ext cx="6443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497553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22DB9442-62D6-47B1-9722-6BDBF022A8B0}"/>
              </a:ext>
            </a:extLst>
          </p:cNvPr>
          <p:cNvGrpSpPr/>
          <p:nvPr/>
        </p:nvGrpSpPr>
        <p:grpSpPr>
          <a:xfrm>
            <a:off x="3505719" y="534982"/>
            <a:ext cx="2957713" cy="2233579"/>
            <a:chOff x="-850913" y="4480990"/>
            <a:chExt cx="3730168" cy="3181240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DDD9340-88D1-45B7-B9BA-6F1E9A30855D}"/>
                </a:ext>
              </a:extLst>
            </p:cNvPr>
            <p:cNvSpPr txBox="1"/>
            <p:nvPr/>
          </p:nvSpPr>
          <p:spPr>
            <a:xfrm>
              <a:off x="1915515" y="5946909"/>
              <a:ext cx="491478" cy="526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736BBD08-F1F8-4D9E-A73E-BB7DAE629789}"/>
                </a:ext>
              </a:extLst>
            </p:cNvPr>
            <p:cNvGrpSpPr/>
            <p:nvPr/>
          </p:nvGrpSpPr>
          <p:grpSpPr>
            <a:xfrm>
              <a:off x="-850913" y="4480990"/>
              <a:ext cx="3730168" cy="3181240"/>
              <a:chOff x="-901132" y="4184032"/>
              <a:chExt cx="3730168" cy="3181240"/>
            </a:xfrm>
          </p:grpSpPr>
          <p:graphicFrame>
            <p:nvGraphicFramePr>
              <p:cNvPr id="23" name="Object 22">
                <a:extLst>
                  <a:ext uri="{FF2B5EF4-FFF2-40B4-BE49-F238E27FC236}">
                    <a16:creationId xmlns:a16="http://schemas.microsoft.com/office/drawing/2014/main" id="{AC4511D4-3870-4148-B1BE-B7BC93C4451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58948725"/>
                  </p:ext>
                </p:extLst>
              </p:nvPr>
            </p:nvGraphicFramePr>
            <p:xfrm>
              <a:off x="-799883" y="4430623"/>
              <a:ext cx="3628919" cy="293464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3666134" imgH="2971483" progId="Prism9.Document">
                      <p:embed/>
                    </p:oleObj>
                  </mc:Choice>
                  <mc:Fallback>
                    <p:oleObj name="Prism 9" r:id="rId3" imgW="3666134" imgH="2971483" progId="Prism9.Document">
                      <p:embed/>
                      <p:pic>
                        <p:nvPicPr>
                          <p:cNvPr id="23" name="Object 22">
                            <a:extLst>
                              <a:ext uri="{FF2B5EF4-FFF2-40B4-BE49-F238E27FC236}">
                                <a16:creationId xmlns:a16="http://schemas.microsoft.com/office/drawing/2014/main" id="{AC4511D4-3870-4148-B1BE-B7BC93C445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-799883" y="4430623"/>
                            <a:ext cx="3628919" cy="293464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84AF33E-C20E-48BA-B609-00E99861CAEC}"/>
                  </a:ext>
                </a:extLst>
              </p:cNvPr>
              <p:cNvSpPr txBox="1"/>
              <p:nvPr/>
            </p:nvSpPr>
            <p:spPr>
              <a:xfrm>
                <a:off x="-901132" y="4184032"/>
                <a:ext cx="704099" cy="4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EEB943CE-0648-4AB0-982B-9DC712EE69FE}"/>
              </a:ext>
            </a:extLst>
          </p:cNvPr>
          <p:cNvGrpSpPr/>
          <p:nvPr/>
        </p:nvGrpSpPr>
        <p:grpSpPr>
          <a:xfrm>
            <a:off x="550664" y="4803175"/>
            <a:ext cx="1896121" cy="2442847"/>
            <a:chOff x="-38159" y="5747451"/>
            <a:chExt cx="2593469" cy="3233605"/>
          </a:xfrm>
        </p:grpSpPr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76224AD5-9C39-4DEE-A58D-89C0C8AD86B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32033"/>
                </p:ext>
              </p:extLst>
            </p:nvPr>
          </p:nvGraphicFramePr>
          <p:xfrm>
            <a:off x="131908" y="5970347"/>
            <a:ext cx="2423402" cy="301070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857317" imgH="3844750" progId="Prism9.Document">
                    <p:embed/>
                  </p:oleObj>
                </mc:Choice>
                <mc:Fallback>
                  <p:oleObj name="Prism 9" r:id="rId5" imgW="2857317" imgH="3844750" progId="Prism9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76224AD5-9C39-4DEE-A58D-89C0C8AD86B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1908" y="5970347"/>
                          <a:ext cx="2423402" cy="301070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0737619-DC08-4194-80D3-56695C2AEB3F}"/>
                </a:ext>
              </a:extLst>
            </p:cNvPr>
            <p:cNvSpPr txBox="1"/>
            <p:nvPr/>
          </p:nvSpPr>
          <p:spPr>
            <a:xfrm>
              <a:off x="-38159" y="5747451"/>
              <a:ext cx="539657" cy="407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928F69F1-7BF8-4730-977F-7B18E07046B4}"/>
              </a:ext>
            </a:extLst>
          </p:cNvPr>
          <p:cNvGrpSpPr/>
          <p:nvPr/>
        </p:nvGrpSpPr>
        <p:grpSpPr>
          <a:xfrm>
            <a:off x="2656329" y="4803175"/>
            <a:ext cx="1461802" cy="1812152"/>
            <a:chOff x="28706" y="7865105"/>
            <a:chExt cx="1999417" cy="2398753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D996E7F-F0CC-4CE2-BB96-1FED91FF7D81}"/>
                </a:ext>
              </a:extLst>
            </p:cNvPr>
            <p:cNvGrpSpPr/>
            <p:nvPr/>
          </p:nvGrpSpPr>
          <p:grpSpPr>
            <a:xfrm>
              <a:off x="28706" y="7865105"/>
              <a:ext cx="1999417" cy="2078817"/>
              <a:chOff x="2388173" y="5887542"/>
              <a:chExt cx="1999417" cy="2078817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D39B6C19-2316-4AB2-A42C-86DBD3386C40}"/>
                  </a:ext>
                </a:extLst>
              </p:cNvPr>
              <p:cNvGrpSpPr/>
              <p:nvPr/>
            </p:nvGrpSpPr>
            <p:grpSpPr>
              <a:xfrm>
                <a:off x="2658544" y="6091246"/>
                <a:ext cx="1729046" cy="1875113"/>
                <a:chOff x="1707041" y="2160010"/>
                <a:chExt cx="1729046" cy="1875113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D5BD9DEF-4E5D-4F01-B458-73A7E5C591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1707041" y="2455236"/>
                  <a:ext cx="1604965" cy="1579887"/>
                </a:xfrm>
                <a:prstGeom prst="rect">
                  <a:avLst/>
                </a:prstGeom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D52F90A2-A750-4599-B5D9-1D275434FB0C}"/>
                    </a:ext>
                  </a:extLst>
                </p:cNvPr>
                <p:cNvSpPr txBox="1"/>
                <p:nvPr/>
              </p:nvSpPr>
              <p:spPr>
                <a:xfrm>
                  <a:off x="2283971" y="2160010"/>
                  <a:ext cx="1152116" cy="366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0771</a:t>
                  </a:r>
                </a:p>
              </p:txBody>
            </p:sp>
          </p:grp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90A9FBF-0887-41D0-A689-13394EB1D01A}"/>
                  </a:ext>
                </a:extLst>
              </p:cNvPr>
              <p:cNvSpPr txBox="1"/>
              <p:nvPr/>
            </p:nvSpPr>
            <p:spPr>
              <a:xfrm>
                <a:off x="2388173" y="5887542"/>
                <a:ext cx="883463" cy="407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</p:grp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E67D6470-611C-4D2F-B312-041B23E3CAA1}"/>
                </a:ext>
              </a:extLst>
            </p:cNvPr>
            <p:cNvCxnSpPr>
              <a:cxnSpLocks/>
            </p:cNvCxnSpPr>
            <p:nvPr/>
          </p:nvCxnSpPr>
          <p:spPr>
            <a:xfrm>
              <a:off x="693019" y="9848545"/>
              <a:ext cx="115526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FD3D525-02C3-4AF1-8892-6587F619B60B}"/>
                </a:ext>
              </a:extLst>
            </p:cNvPr>
            <p:cNvSpPr txBox="1"/>
            <p:nvPr/>
          </p:nvSpPr>
          <p:spPr>
            <a:xfrm>
              <a:off x="815296" y="9897193"/>
              <a:ext cx="901147" cy="366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5A69C194-9F2A-4431-A9AD-72BED969102F}"/>
              </a:ext>
            </a:extLst>
          </p:cNvPr>
          <p:cNvGrpSpPr/>
          <p:nvPr/>
        </p:nvGrpSpPr>
        <p:grpSpPr>
          <a:xfrm>
            <a:off x="3475556" y="2744827"/>
            <a:ext cx="2703229" cy="1679455"/>
            <a:chOff x="3570026" y="2998641"/>
            <a:chExt cx="3697416" cy="2223103"/>
          </a:xfrm>
        </p:grpSpPr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BEAC884E-DAE8-40FF-AAEE-1A06B9A40166}"/>
                </a:ext>
              </a:extLst>
            </p:cNvPr>
            <p:cNvGrpSpPr/>
            <p:nvPr/>
          </p:nvGrpSpPr>
          <p:grpSpPr>
            <a:xfrm>
              <a:off x="3863818" y="3309996"/>
              <a:ext cx="3403624" cy="1911748"/>
              <a:chOff x="3863818" y="3551296"/>
              <a:chExt cx="3403624" cy="1911748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3F37E8BC-DCB8-477C-8831-CE2D6637AFDD}"/>
                  </a:ext>
                </a:extLst>
              </p:cNvPr>
              <p:cNvGrpSpPr/>
              <p:nvPr/>
            </p:nvGrpSpPr>
            <p:grpSpPr>
              <a:xfrm>
                <a:off x="3863818" y="3605067"/>
                <a:ext cx="3216083" cy="1857977"/>
                <a:chOff x="3863818" y="3605067"/>
                <a:chExt cx="3216083" cy="1857977"/>
              </a:xfrm>
            </p:grpSpPr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964287F1-6580-432B-A28D-959393C4AAED}"/>
                    </a:ext>
                  </a:extLst>
                </p:cNvPr>
                <p:cNvGrpSpPr/>
                <p:nvPr/>
              </p:nvGrpSpPr>
              <p:grpSpPr>
                <a:xfrm>
                  <a:off x="3863818" y="3605067"/>
                  <a:ext cx="3216083" cy="1833402"/>
                  <a:chOff x="3863818" y="3605067"/>
                  <a:chExt cx="3216083" cy="1833402"/>
                </a:xfrm>
              </p:grpSpPr>
              <p:grpSp>
                <p:nvGrpSpPr>
                  <p:cNvPr id="52" name="Group 51">
                    <a:extLst>
                      <a:ext uri="{FF2B5EF4-FFF2-40B4-BE49-F238E27FC236}">
                        <a16:creationId xmlns:a16="http://schemas.microsoft.com/office/drawing/2014/main" id="{12CFE560-EE83-45A1-BC1E-2BDC72513B4E}"/>
                      </a:ext>
                    </a:extLst>
                  </p:cNvPr>
                  <p:cNvGrpSpPr/>
                  <p:nvPr/>
                </p:nvGrpSpPr>
                <p:grpSpPr>
                  <a:xfrm>
                    <a:off x="3967478" y="3711188"/>
                    <a:ext cx="3112423" cy="1621385"/>
                    <a:chOff x="3967478" y="3711188"/>
                    <a:chExt cx="3112423" cy="1621385"/>
                  </a:xfrm>
                </p:grpSpPr>
                <p:pic>
                  <p:nvPicPr>
                    <p:cNvPr id="51" name="Picture 50">
                      <a:extLst>
                        <a:ext uri="{FF2B5EF4-FFF2-40B4-BE49-F238E27FC236}">
                          <a16:creationId xmlns:a16="http://schemas.microsoft.com/office/drawing/2014/main" id="{7834DF25-C297-49E3-A68D-B8C1F454346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5474936" y="3722497"/>
                      <a:ext cx="1604965" cy="16100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0" name="Picture 49">
                      <a:extLst>
                        <a:ext uri="{FF2B5EF4-FFF2-40B4-BE49-F238E27FC236}">
                          <a16:creationId xmlns:a16="http://schemas.microsoft.com/office/drawing/2014/main" id="{E88357B3-3D96-4991-B76A-93DB03EAFDF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3967478" y="3711188"/>
                      <a:ext cx="1604965" cy="1610076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8C42017F-2F53-42AD-A58C-D9467FB17568}"/>
                      </a:ext>
                    </a:extLst>
                  </p:cNvPr>
                  <p:cNvSpPr txBox="1"/>
                  <p:nvPr/>
                </p:nvSpPr>
                <p:spPr>
                  <a:xfrm>
                    <a:off x="4374603" y="5173655"/>
                    <a:ext cx="1112258" cy="26481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ameter (nm)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CC73B7D0-E108-4B52-A701-FF98FC555B2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282902" y="4185983"/>
                    <a:ext cx="1435461" cy="27363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ticles/mL (10</a:t>
                    </a:r>
                    <a:r>
                      <a:rPr lang="en-US" sz="7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</p:grp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7393F38F-B784-4A4F-B990-399D54F08B51}"/>
                    </a:ext>
                  </a:extLst>
                </p:cNvPr>
                <p:cNvSpPr txBox="1"/>
                <p:nvPr/>
              </p:nvSpPr>
              <p:spPr>
                <a:xfrm>
                  <a:off x="5916228" y="5198230"/>
                  <a:ext cx="1112258" cy="26481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45B1B982-C5F9-473D-BE3F-8615EB9D871D}"/>
                  </a:ext>
                </a:extLst>
              </p:cNvPr>
              <p:cNvSpPr txBox="1"/>
              <p:nvPr/>
            </p:nvSpPr>
            <p:spPr>
              <a:xfrm>
                <a:off x="4302869" y="3554115"/>
                <a:ext cx="1509068" cy="2851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EV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6E0673C-EC71-4B26-A073-F3D487BEEF0B}"/>
                  </a:ext>
                </a:extLst>
              </p:cNvPr>
              <p:cNvSpPr txBox="1"/>
              <p:nvPr/>
            </p:nvSpPr>
            <p:spPr>
              <a:xfrm>
                <a:off x="5758375" y="3551296"/>
                <a:ext cx="1509067" cy="2851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 IR-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EV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6F27526-EC7C-45AF-83D7-FA7CA5BA6EA2}"/>
                </a:ext>
              </a:extLst>
            </p:cNvPr>
            <p:cNvSpPr txBox="1"/>
            <p:nvPr/>
          </p:nvSpPr>
          <p:spPr>
            <a:xfrm>
              <a:off x="3570026" y="2998641"/>
              <a:ext cx="763619" cy="407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570D8183-2707-409A-A432-1B91E2912A93}"/>
              </a:ext>
            </a:extLst>
          </p:cNvPr>
          <p:cNvGrpSpPr/>
          <p:nvPr/>
        </p:nvGrpSpPr>
        <p:grpSpPr>
          <a:xfrm>
            <a:off x="503409" y="522156"/>
            <a:ext cx="2868234" cy="3640707"/>
            <a:chOff x="503409" y="522156"/>
            <a:chExt cx="2868234" cy="364070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FB7E7DF-4FB9-4793-9EB2-6957BAA84ABF}"/>
                </a:ext>
              </a:extLst>
            </p:cNvPr>
            <p:cNvSpPr txBox="1"/>
            <p:nvPr/>
          </p:nvSpPr>
          <p:spPr>
            <a:xfrm>
              <a:off x="503409" y="522156"/>
              <a:ext cx="5396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99A7704-9464-4A90-835F-8D4A30F1389B}"/>
                </a:ext>
              </a:extLst>
            </p:cNvPr>
            <p:cNvGrpSpPr/>
            <p:nvPr/>
          </p:nvGrpSpPr>
          <p:grpSpPr>
            <a:xfrm>
              <a:off x="550664" y="628564"/>
              <a:ext cx="2820979" cy="3534299"/>
              <a:chOff x="70594" y="311150"/>
              <a:chExt cx="3858469" cy="4678363"/>
            </a:xfrm>
          </p:grpSpPr>
          <p:graphicFrame>
            <p:nvGraphicFramePr>
              <p:cNvPr id="49" name="Object 48">
                <a:extLst>
                  <a:ext uri="{FF2B5EF4-FFF2-40B4-BE49-F238E27FC236}">
                    <a16:creationId xmlns:a16="http://schemas.microsoft.com/office/drawing/2014/main" id="{A5085856-BFB8-47E1-8BCA-5832ED18C34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71940165"/>
                  </p:ext>
                </p:extLst>
              </p:nvPr>
            </p:nvGraphicFramePr>
            <p:xfrm>
              <a:off x="212725" y="311150"/>
              <a:ext cx="3716338" cy="46783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0" imgW="3716528" imgH="4678061" progId="Prism9.Document">
                      <p:embed/>
                    </p:oleObj>
                  </mc:Choice>
                  <mc:Fallback>
                    <p:oleObj name="Prism 9" r:id="rId10" imgW="3716528" imgH="4678061" progId="Prism9.Document">
                      <p:embed/>
                      <p:pic>
                        <p:nvPicPr>
                          <p:cNvPr id="49" name="Object 48">
                            <a:extLst>
                              <a:ext uri="{FF2B5EF4-FFF2-40B4-BE49-F238E27FC236}">
                                <a16:creationId xmlns:a16="http://schemas.microsoft.com/office/drawing/2014/main" id="{A5085856-BFB8-47E1-8BCA-5832ED18C34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212725" y="311150"/>
                            <a:ext cx="3716338" cy="46783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64CF88B-1917-4529-A862-1205E5566491}"/>
                  </a:ext>
                </a:extLst>
              </p:cNvPr>
              <p:cNvSpPr txBox="1"/>
              <p:nvPr/>
            </p:nvSpPr>
            <p:spPr>
              <a:xfrm>
                <a:off x="70594" y="3199187"/>
                <a:ext cx="763619" cy="407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5D96272-F56C-461B-82B3-4A2AEE6B700D}"/>
              </a:ext>
            </a:extLst>
          </p:cNvPr>
          <p:cNvGrpSpPr/>
          <p:nvPr/>
        </p:nvGrpSpPr>
        <p:grpSpPr>
          <a:xfrm>
            <a:off x="503409" y="7078960"/>
            <a:ext cx="1869487" cy="2364830"/>
            <a:chOff x="4341685" y="7967825"/>
            <a:chExt cx="1638288" cy="2114674"/>
          </a:xfrm>
        </p:grpSpPr>
        <p:graphicFrame>
          <p:nvGraphicFramePr>
            <p:cNvPr id="48" name="Object 47">
              <a:extLst>
                <a:ext uri="{FF2B5EF4-FFF2-40B4-BE49-F238E27FC236}">
                  <a16:creationId xmlns:a16="http://schemas.microsoft.com/office/drawing/2014/main" id="{7215F3B9-55DE-4157-802E-97E8C0576B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8524507"/>
                </p:ext>
              </p:extLst>
            </p:nvPr>
          </p:nvGraphicFramePr>
          <p:xfrm>
            <a:off x="4468878" y="8228777"/>
            <a:ext cx="1511095" cy="185372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2849398" imgH="3495587" progId="Prism9.Document">
                    <p:embed/>
                  </p:oleObj>
                </mc:Choice>
                <mc:Fallback>
                  <p:oleObj name="Prism 9" r:id="rId12" imgW="2849398" imgH="3495587" progId="Prism9.Document">
                    <p:embed/>
                    <p:pic>
                      <p:nvPicPr>
                        <p:cNvPr id="48" name="Object 47">
                          <a:extLst>
                            <a:ext uri="{FF2B5EF4-FFF2-40B4-BE49-F238E27FC236}">
                              <a16:creationId xmlns:a16="http://schemas.microsoft.com/office/drawing/2014/main" id="{7215F3B9-55DE-4157-802E-97E8C0576BB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468878" y="8228777"/>
                          <a:ext cx="1511095" cy="185372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83B4C97-36C0-40AF-95C0-062A52DF5774}"/>
                </a:ext>
              </a:extLst>
            </p:cNvPr>
            <p:cNvSpPr txBox="1"/>
            <p:nvPr/>
          </p:nvSpPr>
          <p:spPr>
            <a:xfrm>
              <a:off x="4341685" y="7967825"/>
              <a:ext cx="644350" cy="275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2A051EE-F7F3-4BE1-B380-5F63CB041217}"/>
              </a:ext>
            </a:extLst>
          </p:cNvPr>
          <p:cNvGrpSpPr/>
          <p:nvPr/>
        </p:nvGrpSpPr>
        <p:grpSpPr>
          <a:xfrm>
            <a:off x="4606363" y="4775936"/>
            <a:ext cx="2559255" cy="1782019"/>
            <a:chOff x="4606363" y="4775936"/>
            <a:chExt cx="2559255" cy="1782019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C9E2A788-A96F-4535-A71B-B27E093F8632}"/>
                </a:ext>
              </a:extLst>
            </p:cNvPr>
            <p:cNvGrpSpPr/>
            <p:nvPr/>
          </p:nvGrpSpPr>
          <p:grpSpPr>
            <a:xfrm>
              <a:off x="4606363" y="4775936"/>
              <a:ext cx="2559255" cy="1782019"/>
              <a:chOff x="3606611" y="5204455"/>
              <a:chExt cx="3500488" cy="2358864"/>
            </a:xfrm>
          </p:grpSpPr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6A43230B-03B8-4FD9-A8C2-B682FA818ABC}"/>
                  </a:ext>
                </a:extLst>
              </p:cNvPr>
              <p:cNvSpPr txBox="1"/>
              <p:nvPr/>
            </p:nvSpPr>
            <p:spPr>
              <a:xfrm>
                <a:off x="4331103" y="5579499"/>
                <a:ext cx="1257852" cy="611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EV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8943950-517C-4F77-A43A-64C99DFA6D11}"/>
                  </a:ext>
                </a:extLst>
              </p:cNvPr>
              <p:cNvSpPr txBox="1"/>
              <p:nvPr/>
            </p:nvSpPr>
            <p:spPr>
              <a:xfrm>
                <a:off x="5717426" y="5579499"/>
                <a:ext cx="1389673" cy="611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 KO IR-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EV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A3E47F34-76E3-40D8-BBB1-6CFD36D3B02D}"/>
                  </a:ext>
                </a:extLst>
              </p:cNvPr>
              <p:cNvGrpSpPr/>
              <p:nvPr/>
            </p:nvGrpSpPr>
            <p:grpSpPr>
              <a:xfrm>
                <a:off x="3606611" y="5204455"/>
                <a:ext cx="3432993" cy="2358864"/>
                <a:chOff x="3606611" y="5193822"/>
                <a:chExt cx="3432993" cy="2358864"/>
              </a:xfrm>
            </p:grpSpPr>
            <p:pic>
              <p:nvPicPr>
                <p:cNvPr id="62" name="Picture 61">
                  <a:extLst>
                    <a:ext uri="{FF2B5EF4-FFF2-40B4-BE49-F238E27FC236}">
                      <a16:creationId xmlns:a16="http://schemas.microsoft.com/office/drawing/2014/main" id="{680DAEF0-87B1-4419-9527-4593A84F48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5444353" y="5725771"/>
                  <a:ext cx="1595251" cy="1594479"/>
                </a:xfrm>
                <a:prstGeom prst="rect">
                  <a:avLst/>
                </a:prstGeom>
              </p:spPr>
            </p:pic>
            <p:pic>
              <p:nvPicPr>
                <p:cNvPr id="61" name="Picture 60">
                  <a:extLst>
                    <a:ext uri="{FF2B5EF4-FFF2-40B4-BE49-F238E27FC236}">
                      <a16:creationId xmlns:a16="http://schemas.microsoft.com/office/drawing/2014/main" id="{8455A8DD-1FC9-49DD-BB12-BE3E4C6BCA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3931620" y="5718430"/>
                  <a:ext cx="1595251" cy="1594479"/>
                </a:xfrm>
                <a:prstGeom prst="rect">
                  <a:avLst/>
                </a:prstGeom>
              </p:spPr>
            </p:pic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A3093D0B-064B-466F-B2AB-0F6A876EC2C6}"/>
                    </a:ext>
                  </a:extLst>
                </p:cNvPr>
                <p:cNvGrpSpPr/>
                <p:nvPr/>
              </p:nvGrpSpPr>
              <p:grpSpPr>
                <a:xfrm>
                  <a:off x="3606611" y="5193822"/>
                  <a:ext cx="3331801" cy="2048967"/>
                  <a:chOff x="3646027" y="5783455"/>
                  <a:chExt cx="3331801" cy="2048967"/>
                </a:xfrm>
              </p:grpSpPr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CA803848-4532-4F3E-85A4-74E4C5D8B09E}"/>
                      </a:ext>
                    </a:extLst>
                  </p:cNvPr>
                  <p:cNvSpPr txBox="1"/>
                  <p:nvPr/>
                </p:nvSpPr>
                <p:spPr>
                  <a:xfrm>
                    <a:off x="3646027" y="5783455"/>
                    <a:ext cx="556675" cy="407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</a:p>
                </p:txBody>
              </p:sp>
              <p:cxnSp>
                <p:nvCxnSpPr>
                  <p:cNvPr id="42" name="Straight Arrow Connector 41">
                    <a:extLst>
                      <a:ext uri="{FF2B5EF4-FFF2-40B4-BE49-F238E27FC236}">
                        <a16:creationId xmlns:a16="http://schemas.microsoft.com/office/drawing/2014/main" id="{42907840-5152-4011-98DB-1CAE696C61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93577" y="7832422"/>
                    <a:ext cx="2584251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21798F7E-D866-4864-98AF-B45DDACD1692}"/>
                    </a:ext>
                  </a:extLst>
                </p:cNvPr>
                <p:cNvSpPr txBox="1"/>
                <p:nvPr/>
              </p:nvSpPr>
              <p:spPr>
                <a:xfrm>
                  <a:off x="4578053" y="7267502"/>
                  <a:ext cx="2126015" cy="28518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1</a:t>
                  </a:r>
                </a:p>
              </p:txBody>
            </p:sp>
          </p:grpSp>
        </p:grp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5228187-CCE5-490B-9868-462795B046C8}"/>
                </a:ext>
              </a:extLst>
            </p:cNvPr>
            <p:cNvSpPr txBox="1"/>
            <p:nvPr/>
          </p:nvSpPr>
          <p:spPr>
            <a:xfrm rot="16200000">
              <a:off x="4567763" y="5525351"/>
              <a:ext cx="53299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299806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4A04ED7B-4097-477F-871E-1706AFD12AEA}"/>
              </a:ext>
            </a:extLst>
          </p:cNvPr>
          <p:cNvGrpSpPr/>
          <p:nvPr/>
        </p:nvGrpSpPr>
        <p:grpSpPr>
          <a:xfrm>
            <a:off x="311743" y="57144"/>
            <a:ext cx="6543462" cy="4215171"/>
            <a:chOff x="718436" y="669299"/>
            <a:chExt cx="6543462" cy="4215171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ADBA229-030F-4B28-AD25-9663BF7B5396}"/>
                </a:ext>
              </a:extLst>
            </p:cNvPr>
            <p:cNvGrpSpPr/>
            <p:nvPr/>
          </p:nvGrpSpPr>
          <p:grpSpPr>
            <a:xfrm>
              <a:off x="718436" y="669299"/>
              <a:ext cx="6543462" cy="4215171"/>
              <a:chOff x="718436" y="669299"/>
              <a:chExt cx="6543462" cy="4215171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2B49675F-9585-4EBB-90D6-A783DBA49E41}"/>
                  </a:ext>
                </a:extLst>
              </p:cNvPr>
              <p:cNvGrpSpPr/>
              <p:nvPr/>
            </p:nvGrpSpPr>
            <p:grpSpPr>
              <a:xfrm>
                <a:off x="718436" y="669299"/>
                <a:ext cx="6543462" cy="4215171"/>
                <a:chOff x="718436" y="669299"/>
                <a:chExt cx="6543462" cy="4215171"/>
              </a:xfrm>
            </p:grpSpPr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63590F08-21EA-4C95-8A49-D1226FF3750D}"/>
                    </a:ext>
                  </a:extLst>
                </p:cNvPr>
                <p:cNvSpPr txBox="1"/>
                <p:nvPr/>
              </p:nvSpPr>
              <p:spPr>
                <a:xfrm>
                  <a:off x="718436" y="669299"/>
                  <a:ext cx="38421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6B90CA5B-B5D1-47C1-9AA3-78AE05BF3FF0}"/>
                    </a:ext>
                  </a:extLst>
                </p:cNvPr>
                <p:cNvGrpSpPr/>
                <p:nvPr/>
              </p:nvGrpSpPr>
              <p:grpSpPr>
                <a:xfrm>
                  <a:off x="894436" y="682000"/>
                  <a:ext cx="6367462" cy="4202470"/>
                  <a:chOff x="308585" y="2165195"/>
                  <a:chExt cx="6367462" cy="4202470"/>
                </a:xfrm>
              </p:grpSpPr>
              <p:graphicFrame>
                <p:nvGraphicFramePr>
                  <p:cNvPr id="32" name="Object 31">
                    <a:extLst>
                      <a:ext uri="{FF2B5EF4-FFF2-40B4-BE49-F238E27FC236}">
                        <a16:creationId xmlns:a16="http://schemas.microsoft.com/office/drawing/2014/main" id="{14C08A63-159D-4D3C-B2FE-4B6376FCCDFC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57408741"/>
                      </p:ext>
                    </p:extLst>
                  </p:nvPr>
                </p:nvGraphicFramePr>
                <p:xfrm>
                  <a:off x="308585" y="2384628"/>
                  <a:ext cx="6367462" cy="3983037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3" imgW="6864688" imgH="3885786" progId="Prism9.Document">
                          <p:embed/>
                        </p:oleObj>
                      </mc:Choice>
                      <mc:Fallback>
                        <p:oleObj name="Prism 9" r:id="rId3" imgW="6864688" imgH="3885786" progId="Prism9.Document">
                          <p:embed/>
                          <p:pic>
                            <p:nvPicPr>
                              <p:cNvPr id="32" name="Object 31">
                                <a:extLst>
                                  <a:ext uri="{FF2B5EF4-FFF2-40B4-BE49-F238E27FC236}">
                                    <a16:creationId xmlns:a16="http://schemas.microsoft.com/office/drawing/2014/main" id="{14C08A63-159D-4D3C-B2FE-4B6376FCCDFC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08585" y="2384628"/>
                                <a:ext cx="6367462" cy="3983037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2" name="Object 1">
                    <a:extLst>
                      <a:ext uri="{FF2B5EF4-FFF2-40B4-BE49-F238E27FC236}">
                        <a16:creationId xmlns:a16="http://schemas.microsoft.com/office/drawing/2014/main" id="{4A49F2EA-1614-458F-8A36-E2C385F68A3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56493962"/>
                      </p:ext>
                    </p:extLst>
                  </p:nvPr>
                </p:nvGraphicFramePr>
                <p:xfrm>
                  <a:off x="3327733" y="2165195"/>
                  <a:ext cx="2940068" cy="3026089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5" imgW="3635898" imgH="3741081" progId="Prism9.Document">
                          <p:embed/>
                        </p:oleObj>
                      </mc:Choice>
                      <mc:Fallback>
                        <p:oleObj name="Prism 9" r:id="rId5" imgW="3635898" imgH="3741081" progId="Prism9.Document">
                          <p:embed/>
                          <p:pic>
                            <p:nvPicPr>
                              <p:cNvPr id="2" name="Object 1">
                                <a:extLst>
                                  <a:ext uri="{FF2B5EF4-FFF2-40B4-BE49-F238E27FC236}">
                                    <a16:creationId xmlns:a16="http://schemas.microsoft.com/office/drawing/2014/main" id="{4A49F2EA-1614-458F-8A36-E2C385F68A3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327733" y="2165195"/>
                                <a:ext cx="2940068" cy="3026089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</p:grp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B8482160-8791-44BD-B1CA-56D4DD2CD195}"/>
                  </a:ext>
                </a:extLst>
              </p:cNvPr>
              <p:cNvSpPr txBox="1"/>
              <p:nvPr/>
            </p:nvSpPr>
            <p:spPr>
              <a:xfrm>
                <a:off x="3688589" y="682000"/>
                <a:ext cx="38421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7108234-1D76-4C23-97A6-723868A7916F}"/>
                </a:ext>
              </a:extLst>
            </p:cNvPr>
            <p:cNvSpPr txBox="1"/>
            <p:nvPr/>
          </p:nvSpPr>
          <p:spPr>
            <a:xfrm>
              <a:off x="773154" y="3369535"/>
              <a:ext cx="4537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6F6D99E6-A25E-4EC4-98DE-1C06219257D7}"/>
              </a:ext>
            </a:extLst>
          </p:cNvPr>
          <p:cNvGrpSpPr/>
          <p:nvPr/>
        </p:nvGrpSpPr>
        <p:grpSpPr>
          <a:xfrm>
            <a:off x="356629" y="4524113"/>
            <a:ext cx="3829712" cy="2750091"/>
            <a:chOff x="200660" y="4349134"/>
            <a:chExt cx="3829712" cy="2750091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008BDFC-ECF7-45C8-8248-C8A63E5C9C7D}"/>
                </a:ext>
              </a:extLst>
            </p:cNvPr>
            <p:cNvGrpSpPr/>
            <p:nvPr/>
          </p:nvGrpSpPr>
          <p:grpSpPr>
            <a:xfrm>
              <a:off x="200660" y="4349134"/>
              <a:ext cx="3829712" cy="2750091"/>
              <a:chOff x="-17078" y="6514564"/>
              <a:chExt cx="4585556" cy="3342632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8DC46E3-073C-49E9-964B-7C0A6C9E527C}"/>
                  </a:ext>
                </a:extLst>
              </p:cNvPr>
              <p:cNvSpPr txBox="1"/>
              <p:nvPr/>
            </p:nvSpPr>
            <p:spPr>
              <a:xfrm rot="16200000">
                <a:off x="-291598" y="7297751"/>
                <a:ext cx="1824339" cy="2579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ticles/mL (10</a:t>
                </a:r>
                <a:r>
                  <a:rPr lang="en-US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CDF46759-67A7-4437-AE03-7437ECB4CBD2}"/>
                  </a:ext>
                </a:extLst>
              </p:cNvPr>
              <p:cNvGrpSpPr/>
              <p:nvPr/>
            </p:nvGrpSpPr>
            <p:grpSpPr>
              <a:xfrm>
                <a:off x="-17078" y="6918296"/>
                <a:ext cx="4585556" cy="2938900"/>
                <a:chOff x="-17078" y="6918296"/>
                <a:chExt cx="4585556" cy="2938900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DE17DDBE-7FDD-4947-A714-C84957B6FE8B}"/>
                    </a:ext>
                  </a:extLst>
                </p:cNvPr>
                <p:cNvSpPr txBox="1"/>
                <p:nvPr/>
              </p:nvSpPr>
              <p:spPr>
                <a:xfrm>
                  <a:off x="-17078" y="8778326"/>
                  <a:ext cx="604879" cy="261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R-</a:t>
                  </a:r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V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8F94F4BB-979C-4503-93DF-81C956D9A00B}"/>
                    </a:ext>
                  </a:extLst>
                </p:cNvPr>
                <p:cNvSpPr txBox="1"/>
                <p:nvPr/>
              </p:nvSpPr>
              <p:spPr>
                <a:xfrm>
                  <a:off x="61838" y="7607656"/>
                  <a:ext cx="541604" cy="261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V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2D70550F-DA37-4C70-A102-7FAAE2CA8B54}"/>
                    </a:ext>
                  </a:extLst>
                </p:cNvPr>
                <p:cNvGrpSpPr/>
                <p:nvPr/>
              </p:nvGrpSpPr>
              <p:grpSpPr>
                <a:xfrm>
                  <a:off x="495691" y="6918296"/>
                  <a:ext cx="4072786" cy="2934647"/>
                  <a:chOff x="495691" y="6918296"/>
                  <a:chExt cx="4072786" cy="2934647"/>
                </a:xfrm>
              </p:grpSpPr>
              <p:pic>
                <p:nvPicPr>
                  <p:cNvPr id="36" name="Picture 35">
                    <a:extLst>
                      <a:ext uri="{FF2B5EF4-FFF2-40B4-BE49-F238E27FC236}">
                        <a16:creationId xmlns:a16="http://schemas.microsoft.com/office/drawing/2014/main" id="{C575CA78-5C99-4B4E-9B50-6DC9DEFAA9A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3088369" y="7129434"/>
                    <a:ext cx="1279739" cy="1308128"/>
                  </a:xfrm>
                  <a:prstGeom prst="rect">
                    <a:avLst/>
                  </a:prstGeom>
                </p:spPr>
              </p:pic>
              <p:pic>
                <p:nvPicPr>
                  <p:cNvPr id="37" name="Picture 36">
                    <a:extLst>
                      <a:ext uri="{FF2B5EF4-FFF2-40B4-BE49-F238E27FC236}">
                        <a16:creationId xmlns:a16="http://schemas.microsoft.com/office/drawing/2014/main" id="{F3012564-0CE7-47C4-BCDD-4340C8808A4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3090522" y="8350276"/>
                    <a:ext cx="1267628" cy="1308128"/>
                  </a:xfrm>
                  <a:prstGeom prst="rect">
                    <a:avLst/>
                  </a:prstGeom>
                </p:spPr>
              </p:pic>
              <p:pic>
                <p:nvPicPr>
                  <p:cNvPr id="26" name="Picture 25">
                    <a:extLst>
                      <a:ext uri="{FF2B5EF4-FFF2-40B4-BE49-F238E27FC236}">
                        <a16:creationId xmlns:a16="http://schemas.microsoft.com/office/drawing/2014/main" id="{7E514C23-3ED9-4FF2-8B26-9077DA24A3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1839577" y="7146118"/>
                    <a:ext cx="1335774" cy="1308128"/>
                  </a:xfrm>
                  <a:prstGeom prst="rect">
                    <a:avLst/>
                  </a:prstGeom>
                </p:spPr>
              </p:pic>
              <p:pic>
                <p:nvPicPr>
                  <p:cNvPr id="31" name="Picture 30">
                    <a:extLst>
                      <a:ext uri="{FF2B5EF4-FFF2-40B4-BE49-F238E27FC236}">
                        <a16:creationId xmlns:a16="http://schemas.microsoft.com/office/drawing/2014/main" id="{57D8A535-C7CF-4246-B490-E8370C572E0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1863423" y="8366408"/>
                    <a:ext cx="1310960" cy="1308128"/>
                  </a:xfrm>
                  <a:prstGeom prst="rect">
                    <a:avLst/>
                  </a:prstGeom>
                </p:spPr>
              </p:pic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53EE4C19-B619-4B2C-8AA6-BC3B528C31CE}"/>
                      </a:ext>
                    </a:extLst>
                  </p:cNvPr>
                  <p:cNvSpPr txBox="1"/>
                  <p:nvPr/>
                </p:nvSpPr>
                <p:spPr>
                  <a:xfrm>
                    <a:off x="2355872" y="6951562"/>
                    <a:ext cx="639131" cy="3366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532C2F1F-036B-42FD-BC11-C5B958ECD446}"/>
                      </a:ext>
                    </a:extLst>
                  </p:cNvPr>
                  <p:cNvSpPr txBox="1"/>
                  <p:nvPr/>
                </p:nvSpPr>
                <p:spPr>
                  <a:xfrm>
                    <a:off x="3388303" y="6918296"/>
                    <a:ext cx="1180174" cy="3366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44 KO</a:t>
                    </a:r>
                  </a:p>
                </p:txBody>
              </p:sp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00461CE9-AA7D-4601-8395-748C787A2226}"/>
                      </a:ext>
                    </a:extLst>
                  </p:cNvPr>
                  <p:cNvGrpSpPr/>
                  <p:nvPr/>
                </p:nvGrpSpPr>
                <p:grpSpPr>
                  <a:xfrm>
                    <a:off x="605813" y="6918296"/>
                    <a:ext cx="1363870" cy="1536159"/>
                    <a:chOff x="295275" y="312102"/>
                    <a:chExt cx="3141286" cy="3523395"/>
                  </a:xfrm>
                </p:grpSpPr>
                <p:pic>
                  <p:nvPicPr>
                    <p:cNvPr id="22" name="Picture 21">
                      <a:extLst>
                        <a:ext uri="{FF2B5EF4-FFF2-40B4-BE49-F238E27FC236}">
                          <a16:creationId xmlns:a16="http://schemas.microsoft.com/office/drawing/2014/main" id="{311F5F4E-E949-4C09-893A-BEB98C4C681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295275" y="835122"/>
                      <a:ext cx="2990850" cy="300037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F468F3CD-CE93-4958-AD7F-83C6F18151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9425" y="312102"/>
                      <a:ext cx="2597136" cy="7293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Tumor</a:t>
                      </a:r>
                    </a:p>
                  </p:txBody>
                </p:sp>
              </p:grpSp>
              <p:grpSp>
                <p:nvGrpSpPr>
                  <p:cNvPr id="80" name="Group 79">
                    <a:extLst>
                      <a:ext uri="{FF2B5EF4-FFF2-40B4-BE49-F238E27FC236}">
                        <a16:creationId xmlns:a16="http://schemas.microsoft.com/office/drawing/2014/main" id="{E3C20581-F0C1-4F36-8A85-5BD098E6EDB0}"/>
                      </a:ext>
                    </a:extLst>
                  </p:cNvPr>
                  <p:cNvGrpSpPr/>
                  <p:nvPr/>
                </p:nvGrpSpPr>
                <p:grpSpPr>
                  <a:xfrm>
                    <a:off x="495691" y="8177609"/>
                    <a:ext cx="1643361" cy="1675334"/>
                    <a:chOff x="1857544" y="263285"/>
                    <a:chExt cx="1643361" cy="1675334"/>
                  </a:xfrm>
                </p:grpSpPr>
                <p:grpSp>
                  <p:nvGrpSpPr>
                    <p:cNvPr id="81" name="Group 80">
                      <a:extLst>
                        <a:ext uri="{FF2B5EF4-FFF2-40B4-BE49-F238E27FC236}">
                          <a16:creationId xmlns:a16="http://schemas.microsoft.com/office/drawing/2014/main" id="{C6CA1634-7145-4C77-954A-ADC9807AA85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57544" y="263285"/>
                      <a:ext cx="1428044" cy="1507390"/>
                      <a:chOff x="1004949" y="-161784"/>
                      <a:chExt cx="3117446" cy="3270084"/>
                    </a:xfrm>
                  </p:grpSpPr>
                  <p:pic>
                    <p:nvPicPr>
                      <p:cNvPr id="85" name="Picture 84">
                        <a:extLst>
                          <a:ext uri="{FF2B5EF4-FFF2-40B4-BE49-F238E27FC236}">
                            <a16:creationId xmlns:a16="http://schemas.microsoft.com/office/drawing/2014/main" id="{A68961F3-76DC-41C0-9A00-7207B6A313C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246804" y="250849"/>
                        <a:ext cx="2875591" cy="285745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4" name="TextBox 83">
                        <a:extLst>
                          <a:ext uri="{FF2B5EF4-FFF2-40B4-BE49-F238E27FC236}">
                            <a16:creationId xmlns:a16="http://schemas.microsoft.com/office/drawing/2014/main" id="{7840F915-824B-4E02-AB49-D7298849E16F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205970" y="1049135"/>
                        <a:ext cx="2984980" cy="56314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ticles/mL (10</a:t>
                        </a:r>
                        <a:r>
                          <a:rPr lang="en-US" sz="8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</p:grpSp>
                <p:sp>
                  <p:nvSpPr>
                    <p:cNvPr id="82" name="TextBox 81">
                      <a:extLst>
                        <a:ext uri="{FF2B5EF4-FFF2-40B4-BE49-F238E27FC236}">
                          <a16:creationId xmlns:a16="http://schemas.microsoft.com/office/drawing/2014/main" id="{7E587ED3-DA94-4823-94FB-E35A030138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64379" y="1676755"/>
                      <a:ext cx="1236526" cy="26186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 (nm)</a:t>
                      </a:r>
                    </a:p>
                  </p:txBody>
                </p:sp>
              </p:grpSp>
            </p:grp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ED305AD3-2A1D-4411-BF68-8D36CE2774C6}"/>
                    </a:ext>
                  </a:extLst>
                </p:cNvPr>
                <p:cNvSpPr txBox="1"/>
                <p:nvPr/>
              </p:nvSpPr>
              <p:spPr>
                <a:xfrm>
                  <a:off x="2184475" y="9590849"/>
                  <a:ext cx="1236526" cy="261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82A0D885-960E-4191-958B-801E39F9BC75}"/>
                    </a:ext>
                  </a:extLst>
                </p:cNvPr>
                <p:cNvSpPr txBox="1"/>
                <p:nvPr/>
              </p:nvSpPr>
              <p:spPr>
                <a:xfrm>
                  <a:off x="3331952" y="9595332"/>
                  <a:ext cx="1236526" cy="261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</p:grp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1ECA5FC-87CF-4746-B089-7DFE31EAF409}"/>
                </a:ext>
              </a:extLst>
            </p:cNvPr>
            <p:cNvSpPr txBox="1"/>
            <p:nvPr/>
          </p:nvSpPr>
          <p:spPr>
            <a:xfrm>
              <a:off x="224473" y="4377473"/>
              <a:ext cx="3789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46ED4EB-5314-4498-ACD1-B4FD38B04F71}"/>
              </a:ext>
            </a:extLst>
          </p:cNvPr>
          <p:cNvGrpSpPr/>
          <p:nvPr/>
        </p:nvGrpSpPr>
        <p:grpSpPr>
          <a:xfrm>
            <a:off x="4112145" y="4531046"/>
            <a:ext cx="3403804" cy="2743748"/>
            <a:chOff x="4112145" y="4531046"/>
            <a:chExt cx="3403804" cy="2743748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0BC55B0-08EF-439B-9308-0522F4890564}"/>
                </a:ext>
              </a:extLst>
            </p:cNvPr>
            <p:cNvGrpSpPr/>
            <p:nvPr/>
          </p:nvGrpSpPr>
          <p:grpSpPr>
            <a:xfrm>
              <a:off x="4217194" y="4531046"/>
              <a:ext cx="3298755" cy="2743748"/>
              <a:chOff x="3844875" y="4261473"/>
              <a:chExt cx="3298755" cy="2743748"/>
            </a:xfrm>
          </p:grpSpPr>
          <p:cxnSp>
            <p:nvCxnSpPr>
              <p:cNvPr id="114" name="Straight Arrow Connector 113">
                <a:extLst>
                  <a:ext uri="{FF2B5EF4-FFF2-40B4-BE49-F238E27FC236}">
                    <a16:creationId xmlns:a16="http://schemas.microsoft.com/office/drawing/2014/main" id="{06DC18A1-684D-4940-9540-C87AE505B1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14506" y="6783175"/>
                <a:ext cx="2810036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BBCE09B1-88F6-482E-997E-B6C4488A645E}"/>
                  </a:ext>
                </a:extLst>
              </p:cNvPr>
              <p:cNvGrpSpPr/>
              <p:nvPr/>
            </p:nvGrpSpPr>
            <p:grpSpPr>
              <a:xfrm>
                <a:off x="3844875" y="4261473"/>
                <a:ext cx="3298755" cy="2743748"/>
                <a:chOff x="4110409" y="4346178"/>
                <a:chExt cx="3298755" cy="2743748"/>
              </a:xfrm>
            </p:grpSpPr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0EA64261-567C-4D78-9807-FF5DC6676A84}"/>
                    </a:ext>
                  </a:extLst>
                </p:cNvPr>
                <p:cNvSpPr txBox="1"/>
                <p:nvPr/>
              </p:nvSpPr>
              <p:spPr>
                <a:xfrm>
                  <a:off x="5788925" y="4651656"/>
                  <a:ext cx="5337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25F60436-F9A0-44E6-AA70-BB14C56EF815}"/>
                    </a:ext>
                  </a:extLst>
                </p:cNvPr>
                <p:cNvSpPr txBox="1"/>
                <p:nvPr/>
              </p:nvSpPr>
              <p:spPr>
                <a:xfrm>
                  <a:off x="6518180" y="4619535"/>
                  <a:ext cx="8909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4 KO</a:t>
                  </a: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B044B2D8-F094-40C6-9C9E-EBCA8B243AFD}"/>
                    </a:ext>
                  </a:extLst>
                </p:cNvPr>
                <p:cNvSpPr txBox="1"/>
                <p:nvPr/>
              </p:nvSpPr>
              <p:spPr>
                <a:xfrm>
                  <a:off x="4524645" y="4674162"/>
                  <a:ext cx="94174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 Tumor</a:t>
                  </a:r>
                </a:p>
              </p:txBody>
            </p: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89A5F19A-AE6E-4225-A6C5-F910BEA6EAFA}"/>
                    </a:ext>
                  </a:extLst>
                </p:cNvPr>
                <p:cNvGrpSpPr/>
                <p:nvPr/>
              </p:nvGrpSpPr>
              <p:grpSpPr>
                <a:xfrm>
                  <a:off x="4110409" y="4346178"/>
                  <a:ext cx="3232661" cy="2743748"/>
                  <a:chOff x="4110409" y="3987602"/>
                  <a:chExt cx="3232661" cy="2743748"/>
                </a:xfrm>
              </p:grpSpPr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489EADEF-CD1F-4791-94B4-969AD33DEA8D}"/>
                      </a:ext>
                    </a:extLst>
                  </p:cNvPr>
                  <p:cNvGrpSpPr/>
                  <p:nvPr/>
                </p:nvGrpSpPr>
                <p:grpSpPr>
                  <a:xfrm>
                    <a:off x="4385142" y="4509781"/>
                    <a:ext cx="2957928" cy="2221569"/>
                    <a:chOff x="4385142" y="4509781"/>
                    <a:chExt cx="2957928" cy="2221569"/>
                  </a:xfrm>
                </p:grpSpPr>
                <p:grpSp>
                  <p:nvGrpSpPr>
                    <p:cNvPr id="101" name="Group 100">
                      <a:extLst>
                        <a:ext uri="{FF2B5EF4-FFF2-40B4-BE49-F238E27FC236}">
                          <a16:creationId xmlns:a16="http://schemas.microsoft.com/office/drawing/2014/main" id="{63456BB2-CACE-49FD-99FD-FB599BB3A6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385142" y="4509781"/>
                      <a:ext cx="2957928" cy="2058028"/>
                      <a:chOff x="2723839" y="645531"/>
                      <a:chExt cx="8730204" cy="5792722"/>
                    </a:xfrm>
                  </p:grpSpPr>
                  <p:grpSp>
                    <p:nvGrpSpPr>
                      <p:cNvPr id="102" name="Group 101">
                        <a:extLst>
                          <a:ext uri="{FF2B5EF4-FFF2-40B4-BE49-F238E27FC236}">
                            <a16:creationId xmlns:a16="http://schemas.microsoft.com/office/drawing/2014/main" id="{5BD23AC9-A5A3-481A-A885-2C0543C1132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406043" y="645531"/>
                        <a:ext cx="3048000" cy="5783844"/>
                        <a:chOff x="8406043" y="645531"/>
                        <a:chExt cx="3048000" cy="5783844"/>
                      </a:xfrm>
                    </p:grpSpPr>
                    <p:pic>
                      <p:nvPicPr>
                        <p:cNvPr id="109" name="Picture 108">
                          <a:extLst>
                            <a:ext uri="{FF2B5EF4-FFF2-40B4-BE49-F238E27FC236}">
                              <a16:creationId xmlns:a16="http://schemas.microsoft.com/office/drawing/2014/main" id="{9EA6C84D-AE52-4A5A-B519-42206B76D97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406043" y="645531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10" name="Picture 109">
                          <a:extLst>
                            <a:ext uri="{FF2B5EF4-FFF2-40B4-BE49-F238E27FC236}">
                              <a16:creationId xmlns:a16="http://schemas.microsoft.com/office/drawing/2014/main" id="{6F997035-D4ED-4AAB-A3F0-F7A91554A5F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8406043" y="3429000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</p:grpSp>
                  <p:grpSp>
                    <p:nvGrpSpPr>
                      <p:cNvPr id="103" name="Group 102">
                        <a:extLst>
                          <a:ext uri="{FF2B5EF4-FFF2-40B4-BE49-F238E27FC236}">
                            <a16:creationId xmlns:a16="http://schemas.microsoft.com/office/drawing/2014/main" id="{E278FEFB-AB50-4BE8-8E11-FB75AC95220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64941" y="646501"/>
                        <a:ext cx="3048000" cy="5787797"/>
                        <a:chOff x="5564941" y="646501"/>
                        <a:chExt cx="3048000" cy="5787797"/>
                      </a:xfrm>
                    </p:grpSpPr>
                    <p:pic>
                      <p:nvPicPr>
                        <p:cNvPr id="107" name="Picture 106">
                          <a:extLst>
                            <a:ext uri="{FF2B5EF4-FFF2-40B4-BE49-F238E27FC236}">
                              <a16:creationId xmlns:a16="http://schemas.microsoft.com/office/drawing/2014/main" id="{23B55A7E-35C4-404D-8B1F-AD00AA66632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564941" y="646501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8" name="Picture 107">
                          <a:extLst>
                            <a:ext uri="{FF2B5EF4-FFF2-40B4-BE49-F238E27FC236}">
                              <a16:creationId xmlns:a16="http://schemas.microsoft.com/office/drawing/2014/main" id="{6A0365DB-2618-4551-8F9D-546B9A72056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564941" y="3433923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</p:grpSp>
                  <p:grpSp>
                    <p:nvGrpSpPr>
                      <p:cNvPr id="104" name="Group 103">
                        <a:extLst>
                          <a:ext uri="{FF2B5EF4-FFF2-40B4-BE49-F238E27FC236}">
                            <a16:creationId xmlns:a16="http://schemas.microsoft.com/office/drawing/2014/main" id="{68D1480E-3493-45CF-8EBF-8B1E886CC81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23839" y="645531"/>
                        <a:ext cx="3048000" cy="5792722"/>
                        <a:chOff x="2723839" y="645531"/>
                        <a:chExt cx="3048000" cy="5792722"/>
                      </a:xfrm>
                    </p:grpSpPr>
                    <p:pic>
                      <p:nvPicPr>
                        <p:cNvPr id="105" name="Picture 104">
                          <a:extLst>
                            <a:ext uri="{FF2B5EF4-FFF2-40B4-BE49-F238E27FC236}">
                              <a16:creationId xmlns:a16="http://schemas.microsoft.com/office/drawing/2014/main" id="{F8FF12C1-4B5B-4A99-A832-2E81BA39604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723839" y="645531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6" name="Picture 105">
                          <a:extLst>
                            <a:ext uri="{FF2B5EF4-FFF2-40B4-BE49-F238E27FC236}">
                              <a16:creationId xmlns:a16="http://schemas.microsoft.com/office/drawing/2014/main" id="{31E17318-CCB0-4EEA-8EEB-B2EF66D02D4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723839" y="3437878"/>
                          <a:ext cx="3048000" cy="3000375"/>
                        </a:xfrm>
                        <a:prstGeom prst="rect">
                          <a:avLst/>
                        </a:prstGeom>
                      </p:spPr>
                    </p:pic>
                  </p:grpSp>
                </p:grp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9917E93B-3DA8-4488-8FDF-CC85A980142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29176" y="6515906"/>
                      <a:ext cx="2311764" cy="21544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</a:t>
                      </a:r>
                    </a:p>
                  </p:txBody>
                </p:sp>
              </p:grpSp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36D2547D-7E2C-4A31-B52A-042202C294EE}"/>
                      </a:ext>
                    </a:extLst>
                  </p:cNvPr>
                  <p:cNvSpPr txBox="1"/>
                  <p:nvPr/>
                </p:nvSpPr>
                <p:spPr>
                  <a:xfrm>
                    <a:off x="4110409" y="3987602"/>
                    <a:ext cx="37898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</p:grpSp>
          </p:grpSp>
        </p:grp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D32D38F-702B-4D56-BC28-12D9C187525D}"/>
                </a:ext>
              </a:extLst>
            </p:cNvPr>
            <p:cNvSpPr txBox="1"/>
            <p:nvPr/>
          </p:nvSpPr>
          <p:spPr>
            <a:xfrm>
              <a:off x="4190108" y="5304327"/>
              <a:ext cx="369104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EV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E345345-C320-49BF-89FB-B3D7BA41C028}"/>
                </a:ext>
              </a:extLst>
            </p:cNvPr>
            <p:cNvSpPr txBox="1"/>
            <p:nvPr/>
          </p:nvSpPr>
          <p:spPr>
            <a:xfrm>
              <a:off x="4112145" y="6279979"/>
              <a:ext cx="463811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R-tEV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8D5425A-CB8F-4B25-96BA-5558CABECAF2}"/>
                </a:ext>
              </a:extLst>
            </p:cNvPr>
            <p:cNvSpPr txBox="1"/>
            <p:nvPr/>
          </p:nvSpPr>
          <p:spPr>
            <a:xfrm rot="16200000">
              <a:off x="4271678" y="5850100"/>
              <a:ext cx="532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6AA3C876-21A1-4113-8A44-15EF2619F23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59212" y="5074195"/>
              <a:ext cx="16744" cy="185801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393953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EDECFC1B-3A9E-4F05-8FA5-B07A29AF2589}"/>
              </a:ext>
            </a:extLst>
          </p:cNvPr>
          <p:cNvGrpSpPr/>
          <p:nvPr/>
        </p:nvGrpSpPr>
        <p:grpSpPr>
          <a:xfrm>
            <a:off x="383575" y="4262515"/>
            <a:ext cx="4362119" cy="2332875"/>
            <a:chOff x="-99645" y="4159441"/>
            <a:chExt cx="6011876" cy="317586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3D82F35-4454-44D2-984B-ACED2779C9A9}"/>
                </a:ext>
              </a:extLst>
            </p:cNvPr>
            <p:cNvGrpSpPr/>
            <p:nvPr/>
          </p:nvGrpSpPr>
          <p:grpSpPr>
            <a:xfrm>
              <a:off x="-99645" y="4159441"/>
              <a:ext cx="6011876" cy="3160425"/>
              <a:chOff x="-99645" y="4159441"/>
              <a:chExt cx="6011876" cy="3160425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86AEF6BF-FB36-4ACD-990C-966EE83C421A}"/>
                  </a:ext>
                </a:extLst>
              </p:cNvPr>
              <p:cNvGrpSpPr/>
              <p:nvPr/>
            </p:nvGrpSpPr>
            <p:grpSpPr>
              <a:xfrm>
                <a:off x="4448654" y="4436990"/>
                <a:ext cx="1463577" cy="2882876"/>
                <a:chOff x="4448654" y="4436990"/>
                <a:chExt cx="1463577" cy="2882876"/>
              </a:xfrm>
            </p:grpSpPr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2709B54A-1244-451A-9505-A69FCB3F59DB}"/>
                    </a:ext>
                  </a:extLst>
                </p:cNvPr>
                <p:cNvGrpSpPr/>
                <p:nvPr/>
              </p:nvGrpSpPr>
              <p:grpSpPr>
                <a:xfrm>
                  <a:off x="4448654" y="4653266"/>
                  <a:ext cx="1299139" cy="2666600"/>
                  <a:chOff x="4448654" y="4653266"/>
                  <a:chExt cx="1299139" cy="2666600"/>
                </a:xfrm>
              </p:grpSpPr>
              <p:grpSp>
                <p:nvGrpSpPr>
                  <p:cNvPr id="61" name="Group 60">
                    <a:extLst>
                      <a:ext uri="{FF2B5EF4-FFF2-40B4-BE49-F238E27FC236}">
                        <a16:creationId xmlns:a16="http://schemas.microsoft.com/office/drawing/2014/main" id="{635F8645-24AC-4451-A3F6-E7586D12C96C}"/>
                      </a:ext>
                    </a:extLst>
                  </p:cNvPr>
                  <p:cNvGrpSpPr/>
                  <p:nvPr/>
                </p:nvGrpSpPr>
                <p:grpSpPr>
                  <a:xfrm>
                    <a:off x="4448654" y="4653266"/>
                    <a:ext cx="1257044" cy="2509703"/>
                    <a:chOff x="3773489" y="37554"/>
                    <a:chExt cx="3019426" cy="5717699"/>
                  </a:xfrm>
                </p:grpSpPr>
                <p:pic>
                  <p:nvPicPr>
                    <p:cNvPr id="62" name="Picture 61">
                      <a:extLst>
                        <a:ext uri="{FF2B5EF4-FFF2-40B4-BE49-F238E27FC236}">
                          <a16:creationId xmlns:a16="http://schemas.microsoft.com/office/drawing/2014/main" id="{057D8537-BC48-4AEE-BA40-BC2053D6ABF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3773490" y="37554"/>
                      <a:ext cx="3019425" cy="300037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63" name="Picture 62">
                      <a:extLst>
                        <a:ext uri="{FF2B5EF4-FFF2-40B4-BE49-F238E27FC236}">
                          <a16:creationId xmlns:a16="http://schemas.microsoft.com/office/drawing/2014/main" id="{22589B2F-4951-405B-ABFE-4C268BCED02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3773489" y="2754878"/>
                      <a:ext cx="3019425" cy="3000375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5647C939-2726-44F2-9A5F-A88A71A00B34}"/>
                      </a:ext>
                    </a:extLst>
                  </p:cNvPr>
                  <p:cNvSpPr txBox="1"/>
                  <p:nvPr/>
                </p:nvSpPr>
                <p:spPr>
                  <a:xfrm>
                    <a:off x="4624120" y="7047521"/>
                    <a:ext cx="1123673" cy="272345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ameter (nm)</a:t>
                    </a:r>
                  </a:p>
                </p:txBody>
              </p:sp>
            </p:grp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64A652AE-697C-4D46-B7C1-042E97B39C30}"/>
                    </a:ext>
                  </a:extLst>
                </p:cNvPr>
                <p:cNvSpPr txBox="1"/>
                <p:nvPr/>
              </p:nvSpPr>
              <p:spPr>
                <a:xfrm>
                  <a:off x="4605084" y="4436990"/>
                  <a:ext cx="1307147" cy="3142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  <a:r>
                    <a:rPr lang="en-US" sz="9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DZ1i</a:t>
                  </a:r>
                </a:p>
              </p:txBody>
            </p:sp>
          </p:grpSp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14EC5741-5BDD-4C6B-B09A-5F109C3F2F3D}"/>
                  </a:ext>
                </a:extLst>
              </p:cNvPr>
              <p:cNvGrpSpPr/>
              <p:nvPr/>
            </p:nvGrpSpPr>
            <p:grpSpPr>
              <a:xfrm>
                <a:off x="-99645" y="4159441"/>
                <a:ext cx="4786517" cy="2996803"/>
                <a:chOff x="-89556" y="4495828"/>
                <a:chExt cx="4786517" cy="2996803"/>
              </a:xfrm>
            </p:grpSpPr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FCC0E238-3517-4A7C-8FAD-B733A88B075D}"/>
                    </a:ext>
                  </a:extLst>
                </p:cNvPr>
                <p:cNvGrpSpPr/>
                <p:nvPr/>
              </p:nvGrpSpPr>
              <p:grpSpPr>
                <a:xfrm>
                  <a:off x="-89556" y="4783862"/>
                  <a:ext cx="4786517" cy="2708769"/>
                  <a:chOff x="-250981" y="4560826"/>
                  <a:chExt cx="5732861" cy="3329529"/>
                </a:xfrm>
              </p:grpSpPr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2FB1EF75-CC68-4A86-A295-F87D05D3909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5527" y="4578749"/>
                    <a:ext cx="1385826" cy="3862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DC2 </a:t>
                    </a:r>
                    <a:r>
                      <a:rPr lang="en-US" sz="9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</a:t>
                    </a:r>
                    <a:endPara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52FB5CD3-2382-4BA9-B336-A1E5B1A040A6}"/>
                      </a:ext>
                    </a:extLst>
                  </p:cNvPr>
                  <p:cNvSpPr txBox="1"/>
                  <p:nvPr/>
                </p:nvSpPr>
                <p:spPr>
                  <a:xfrm>
                    <a:off x="4078103" y="4560826"/>
                    <a:ext cx="1403777" cy="3862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DC4 </a:t>
                    </a:r>
                    <a:r>
                      <a:rPr lang="en-US" sz="9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</a:t>
                    </a:r>
                    <a:endPara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30" name="Group 29">
                    <a:extLst>
                      <a:ext uri="{FF2B5EF4-FFF2-40B4-BE49-F238E27FC236}">
                        <a16:creationId xmlns:a16="http://schemas.microsoft.com/office/drawing/2014/main" id="{0E8B7271-8428-4F9B-A271-79F76BE758AE}"/>
                      </a:ext>
                    </a:extLst>
                  </p:cNvPr>
                  <p:cNvGrpSpPr/>
                  <p:nvPr/>
                </p:nvGrpSpPr>
                <p:grpSpPr>
                  <a:xfrm>
                    <a:off x="-250981" y="4580835"/>
                    <a:ext cx="5571025" cy="3309520"/>
                    <a:chOff x="-250981" y="4580835"/>
                    <a:chExt cx="5571025" cy="3309520"/>
                  </a:xfrm>
                </p:grpSpPr>
                <p:sp>
                  <p:nvSpPr>
                    <p:cNvPr id="101" name="TextBox 100">
                      <a:extLst>
                        <a:ext uri="{FF2B5EF4-FFF2-40B4-BE49-F238E27FC236}">
                          <a16:creationId xmlns:a16="http://schemas.microsoft.com/office/drawing/2014/main" id="{C9AF2CD6-B554-4F19-8525-ADD8559398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50981" y="6841514"/>
                      <a:ext cx="969672" cy="38625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-</a:t>
                      </a:r>
                      <a:r>
                        <a:rPr lang="en-US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V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2" name="TextBox 101">
                      <a:extLst>
                        <a:ext uri="{FF2B5EF4-FFF2-40B4-BE49-F238E27FC236}">
                          <a16:creationId xmlns:a16="http://schemas.microsoft.com/office/drawing/2014/main" id="{84CB99CF-6D9B-4C75-B2A7-AB8F7E11E7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752" y="5367191"/>
                      <a:ext cx="790165" cy="38625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V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28" name="Group 27">
                      <a:extLst>
                        <a:ext uri="{FF2B5EF4-FFF2-40B4-BE49-F238E27FC236}">
                          <a16:creationId xmlns:a16="http://schemas.microsoft.com/office/drawing/2014/main" id="{90D091F5-6A14-4AB7-B532-D82868F5A7A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10803" y="4580835"/>
                      <a:ext cx="4809241" cy="3309520"/>
                      <a:chOff x="510803" y="4580835"/>
                      <a:chExt cx="4809241" cy="3309520"/>
                    </a:xfrm>
                  </p:grpSpPr>
                  <p:grpSp>
                    <p:nvGrpSpPr>
                      <p:cNvPr id="20" name="Group 19">
                        <a:extLst>
                          <a:ext uri="{FF2B5EF4-FFF2-40B4-BE49-F238E27FC236}">
                            <a16:creationId xmlns:a16="http://schemas.microsoft.com/office/drawing/2014/main" id="{C9C6FB6B-8B13-4CF4-B400-3AA032B309E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55413" y="4580835"/>
                        <a:ext cx="4664631" cy="3309520"/>
                        <a:chOff x="655413" y="4580835"/>
                        <a:chExt cx="4664631" cy="3309520"/>
                      </a:xfrm>
                    </p:grpSpPr>
                    <p:grpSp>
                      <p:nvGrpSpPr>
                        <p:cNvPr id="18" name="Group 17">
                          <a:extLst>
                            <a:ext uri="{FF2B5EF4-FFF2-40B4-BE49-F238E27FC236}">
                              <a16:creationId xmlns:a16="http://schemas.microsoft.com/office/drawing/2014/main" id="{51A2FDC4-D3AC-48A3-A9E8-77E2D4AEEE9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748367" y="4822198"/>
                          <a:ext cx="1571677" cy="3041040"/>
                          <a:chOff x="3778847" y="4822198"/>
                          <a:chExt cx="1571677" cy="3041040"/>
                        </a:xfrm>
                      </p:grpSpPr>
                      <p:pic>
                        <p:nvPicPr>
                          <p:cNvPr id="89" name="Picture 88">
                            <a:extLst>
                              <a:ext uri="{FF2B5EF4-FFF2-40B4-BE49-F238E27FC236}">
                                <a16:creationId xmlns:a16="http://schemas.microsoft.com/office/drawing/2014/main" id="{C644F9F7-E593-4A7F-A403-3C0EF3C388BA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778847" y="4822198"/>
                            <a:ext cx="1565584" cy="1572762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92" name="Picture 91">
                            <a:extLst>
                              <a:ext uri="{FF2B5EF4-FFF2-40B4-BE49-F238E27FC236}">
                                <a16:creationId xmlns:a16="http://schemas.microsoft.com/office/drawing/2014/main" id="{FD9D6B00-DC90-47CF-A3EB-DE02EF6B9813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784940" y="6288749"/>
                            <a:ext cx="1565584" cy="1574489"/>
                          </a:xfrm>
                          <a:prstGeom prst="rect">
                            <a:avLst/>
                          </a:prstGeom>
                        </p:spPr>
                      </p:pic>
                    </p:grpSp>
                    <p:grpSp>
                      <p:nvGrpSpPr>
                        <p:cNvPr id="16" name="Group 15">
                          <a:extLst>
                            <a:ext uri="{FF2B5EF4-FFF2-40B4-BE49-F238E27FC236}">
                              <a16:creationId xmlns:a16="http://schemas.microsoft.com/office/drawing/2014/main" id="{54A732EA-FA83-49BC-A016-AC1D322FAC4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194635" y="4848569"/>
                          <a:ext cx="1631587" cy="3041786"/>
                          <a:chOff x="2194634" y="4900123"/>
                          <a:chExt cx="1631587" cy="3041786"/>
                        </a:xfrm>
                      </p:grpSpPr>
                      <p:pic>
                        <p:nvPicPr>
                          <p:cNvPr id="97" name="Picture 96">
                            <a:extLst>
                              <a:ext uri="{FF2B5EF4-FFF2-40B4-BE49-F238E27FC236}">
                                <a16:creationId xmlns:a16="http://schemas.microsoft.com/office/drawing/2014/main" id="{E244F77F-4206-4475-938A-30DD29808CE0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2194634" y="4900123"/>
                            <a:ext cx="1610574" cy="1574489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72" name="Picture 71">
                            <a:extLst>
                              <a:ext uri="{FF2B5EF4-FFF2-40B4-BE49-F238E27FC236}">
                                <a16:creationId xmlns:a16="http://schemas.microsoft.com/office/drawing/2014/main" id="{DCF3C3DB-8A41-48E7-83A5-51B76860230D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2229504" y="6341497"/>
                            <a:ext cx="1596717" cy="1600412"/>
                          </a:xfrm>
                          <a:prstGeom prst="rect">
                            <a:avLst/>
                          </a:prstGeom>
                        </p:spPr>
                      </p:pic>
                    </p:grpSp>
                    <p:grpSp>
                      <p:nvGrpSpPr>
                        <p:cNvPr id="14" name="Group 13">
                          <a:extLst>
                            <a:ext uri="{FF2B5EF4-FFF2-40B4-BE49-F238E27FC236}">
                              <a16:creationId xmlns:a16="http://schemas.microsoft.com/office/drawing/2014/main" id="{6B3179D9-D38D-4DD9-99C7-9459F73B51C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55413" y="4580835"/>
                          <a:ext cx="2024734" cy="3309520"/>
                          <a:chOff x="655413" y="4580835"/>
                          <a:chExt cx="2024734" cy="3309520"/>
                        </a:xfrm>
                      </p:grpSpPr>
                      <p:grpSp>
                        <p:nvGrpSpPr>
                          <p:cNvPr id="94" name="Group 93">
                            <a:extLst>
                              <a:ext uri="{FF2B5EF4-FFF2-40B4-BE49-F238E27FC236}">
                                <a16:creationId xmlns:a16="http://schemas.microsoft.com/office/drawing/2014/main" id="{C1B9663A-3A88-42C1-BC74-C9747C333ACB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55413" y="4580835"/>
                            <a:ext cx="2024734" cy="1816001"/>
                            <a:chOff x="1246187" y="534166"/>
                            <a:chExt cx="3678018" cy="3531421"/>
                          </a:xfrm>
                        </p:grpSpPr>
                        <p:pic>
                          <p:nvPicPr>
                            <p:cNvPr id="95" name="Picture 94">
                              <a:extLst>
                                <a:ext uri="{FF2B5EF4-FFF2-40B4-BE49-F238E27FC236}">
                                  <a16:creationId xmlns:a16="http://schemas.microsoft.com/office/drawing/2014/main" id="{F66574B2-3785-4A65-8419-F6BA7B271957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246187" y="1065212"/>
                              <a:ext cx="3019425" cy="3000375"/>
                            </a:xfrm>
                            <a:prstGeom prst="rect">
                              <a:avLst/>
                            </a:prstGeom>
                          </p:spPr>
                        </p:pic>
                        <p:sp>
                          <p:nvSpPr>
                            <p:cNvPr id="96" name="TextBox 95">
                              <a:extLst>
                                <a:ext uri="{FF2B5EF4-FFF2-40B4-BE49-F238E27FC236}">
                                  <a16:creationId xmlns:a16="http://schemas.microsoft.com/office/drawing/2014/main" id="{54201F8A-FBF0-4CBF-9B24-4E32119B5FFA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956113" y="534166"/>
                              <a:ext cx="2968092" cy="751123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900" b="1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SDC1 </a:t>
                              </a:r>
                              <a:r>
                                <a:rPr lang="en-US" sz="900" b="1" dirty="0" err="1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kd</a:t>
                              </a:r>
                              <a:endParaRPr lang="en-US" sz="900" b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pic>
                        <p:nvPicPr>
                          <p:cNvPr id="98" name="Picture 97">
                            <a:extLst>
                              <a:ext uri="{FF2B5EF4-FFF2-40B4-BE49-F238E27FC236}">
                                <a16:creationId xmlns:a16="http://schemas.microsoft.com/office/drawing/2014/main" id="{CB98F03B-ACC0-4AB7-B1D1-FF3414A5E9E2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685252" y="6299356"/>
                            <a:ext cx="1632343" cy="1590999"/>
                          </a:xfrm>
                          <a:prstGeom prst="rect">
                            <a:avLst/>
                          </a:prstGeom>
                        </p:spPr>
                      </p:pic>
                    </p:grpSp>
                  </p:grpSp>
                  <p:sp>
                    <p:nvSpPr>
                      <p:cNvPr id="103" name="TextBox 102">
                        <a:extLst>
                          <a:ext uri="{FF2B5EF4-FFF2-40B4-BE49-F238E27FC236}">
                            <a16:creationId xmlns:a16="http://schemas.microsoft.com/office/drawing/2014/main" id="{7889AE60-793A-4484-9665-260920EF81D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41643" y="5358929"/>
                        <a:ext cx="1409718" cy="304825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ticles/mL (10</a:t>
                        </a:r>
                        <a:r>
                          <a:rPr lang="en-US" sz="6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r>
                          <a:rPr lang="en-US" sz="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  <p:sp>
                    <p:nvSpPr>
                      <p:cNvPr id="104" name="TextBox 103">
                        <a:extLst>
                          <a:ext uri="{FF2B5EF4-FFF2-40B4-BE49-F238E27FC236}">
                            <a16:creationId xmlns:a16="http://schemas.microsoft.com/office/drawing/2014/main" id="{DA7AEB28-EFBB-4AD9-A7AB-79A50B5A6BC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17188" y="6857958"/>
                        <a:ext cx="1409718" cy="304825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ticles/mL (10</a:t>
                        </a:r>
                        <a:r>
                          <a:rPr lang="en-US" sz="6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r>
                          <a:rPr lang="en-US" sz="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</p:grpSp>
              </p:grpSp>
            </p:grp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E55BDEB0-7E36-42B1-B7D6-49928EA3F7F6}"/>
                    </a:ext>
                  </a:extLst>
                </p:cNvPr>
                <p:cNvSpPr txBox="1"/>
                <p:nvPr/>
              </p:nvSpPr>
              <p:spPr>
                <a:xfrm>
                  <a:off x="16378" y="4495828"/>
                  <a:ext cx="677421" cy="4189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</p:grpSp>
        </p:grp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BAF5225A-AF3E-4B35-90A7-BF45B7ECB38C}"/>
                </a:ext>
              </a:extLst>
            </p:cNvPr>
            <p:cNvSpPr txBox="1"/>
            <p:nvPr/>
          </p:nvSpPr>
          <p:spPr>
            <a:xfrm>
              <a:off x="925618" y="7053499"/>
              <a:ext cx="1123673" cy="2723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iameter (nm)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1A82CCD9-69D3-4938-ACA2-B82E4984DC3B}"/>
                </a:ext>
              </a:extLst>
            </p:cNvPr>
            <p:cNvSpPr txBox="1"/>
            <p:nvPr/>
          </p:nvSpPr>
          <p:spPr>
            <a:xfrm>
              <a:off x="2198222" y="7062960"/>
              <a:ext cx="1123673" cy="2723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iameter (nm)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0AB9C7DE-607F-4334-B1A2-0ED7478006FF}"/>
                </a:ext>
              </a:extLst>
            </p:cNvPr>
            <p:cNvSpPr txBox="1"/>
            <p:nvPr/>
          </p:nvSpPr>
          <p:spPr>
            <a:xfrm>
              <a:off x="3443162" y="7046340"/>
              <a:ext cx="1123673" cy="2723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iameter (nm)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FA369F47-044D-4992-BBF4-7370D137DFEB}"/>
              </a:ext>
            </a:extLst>
          </p:cNvPr>
          <p:cNvGrpSpPr/>
          <p:nvPr/>
        </p:nvGrpSpPr>
        <p:grpSpPr>
          <a:xfrm>
            <a:off x="4918096" y="4235249"/>
            <a:ext cx="2731206" cy="1938014"/>
            <a:chOff x="4982235" y="561040"/>
            <a:chExt cx="2989679" cy="1926663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E3D4D74-5DD9-47DC-80E9-8AC141E2D786}"/>
                </a:ext>
              </a:extLst>
            </p:cNvPr>
            <p:cNvSpPr txBox="1"/>
            <p:nvPr/>
          </p:nvSpPr>
          <p:spPr>
            <a:xfrm>
              <a:off x="4982235" y="561040"/>
              <a:ext cx="506938" cy="305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aphicFrame>
          <p:nvGraphicFramePr>
            <p:cNvPr id="80" name="Object 79">
              <a:extLst>
                <a:ext uri="{FF2B5EF4-FFF2-40B4-BE49-F238E27FC236}">
                  <a16:creationId xmlns:a16="http://schemas.microsoft.com/office/drawing/2014/main" id="{D30C3B22-5208-43A6-A63F-1658F7CCCDC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52026868"/>
                </p:ext>
              </p:extLst>
            </p:nvPr>
          </p:nvGraphicFramePr>
          <p:xfrm>
            <a:off x="5310092" y="677640"/>
            <a:ext cx="2661822" cy="18100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4016730" imgH="2730669" progId="Prism9.Document">
                    <p:embed/>
                  </p:oleObj>
                </mc:Choice>
                <mc:Fallback>
                  <p:oleObj name="Prism 9" r:id="rId10" imgW="4016730" imgH="2730669" progId="Prism9.Document">
                    <p:embed/>
                    <p:pic>
                      <p:nvPicPr>
                        <p:cNvPr id="80" name="Object 79">
                          <a:extLst>
                            <a:ext uri="{FF2B5EF4-FFF2-40B4-BE49-F238E27FC236}">
                              <a16:creationId xmlns:a16="http://schemas.microsoft.com/office/drawing/2014/main" id="{D30C3B22-5208-43A6-A63F-1658F7CCCDC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310092" y="677640"/>
                          <a:ext cx="2661822" cy="18100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C9B74E54-4075-4070-93A7-731EF141E6D8}"/>
              </a:ext>
            </a:extLst>
          </p:cNvPr>
          <p:cNvGrpSpPr/>
          <p:nvPr/>
        </p:nvGrpSpPr>
        <p:grpSpPr>
          <a:xfrm>
            <a:off x="360287" y="505289"/>
            <a:ext cx="5967616" cy="3527496"/>
            <a:chOff x="270644" y="396694"/>
            <a:chExt cx="7022927" cy="4133908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6998FF23-3785-4A16-93AE-24A715E69B77}"/>
                </a:ext>
              </a:extLst>
            </p:cNvPr>
            <p:cNvGrpSpPr/>
            <p:nvPr/>
          </p:nvGrpSpPr>
          <p:grpSpPr>
            <a:xfrm>
              <a:off x="270644" y="396694"/>
              <a:ext cx="7022927" cy="4133908"/>
              <a:chOff x="268916" y="940293"/>
              <a:chExt cx="5771134" cy="3265909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2EFA27B-5629-4379-93C2-7DB9AD4A9F20}"/>
                  </a:ext>
                </a:extLst>
              </p:cNvPr>
              <p:cNvGrpSpPr/>
              <p:nvPr/>
            </p:nvGrpSpPr>
            <p:grpSpPr>
              <a:xfrm>
                <a:off x="3110715" y="940293"/>
                <a:ext cx="2929335" cy="2134115"/>
                <a:chOff x="5125430" y="3154184"/>
                <a:chExt cx="2610408" cy="2011232"/>
              </a:xfrm>
            </p:grpSpPr>
            <p:graphicFrame>
              <p:nvGraphicFramePr>
                <p:cNvPr id="26" name="Object 25">
                  <a:extLst>
                    <a:ext uri="{FF2B5EF4-FFF2-40B4-BE49-F238E27FC236}">
                      <a16:creationId xmlns:a16="http://schemas.microsoft.com/office/drawing/2014/main" id="{F5113492-C989-424F-A7D2-47909872715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51569727"/>
                    </p:ext>
                  </p:extLst>
                </p:nvPr>
              </p:nvGraphicFramePr>
              <p:xfrm>
                <a:off x="5285596" y="3154184"/>
                <a:ext cx="2450242" cy="201123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2" imgW="4364086" imgH="3579458" progId="Prism9.Document">
                        <p:embed/>
                      </p:oleObj>
                    </mc:Choice>
                    <mc:Fallback>
                      <p:oleObj name="Prism 9" r:id="rId12" imgW="4364086" imgH="3579458" progId="Prism9.Document">
                        <p:embed/>
                        <p:pic>
                          <p:nvPicPr>
                            <p:cNvPr id="26" name="Object 25">
                              <a:extLst>
                                <a:ext uri="{FF2B5EF4-FFF2-40B4-BE49-F238E27FC236}">
                                  <a16:creationId xmlns:a16="http://schemas.microsoft.com/office/drawing/2014/main" id="{F5113492-C989-424F-A7D2-47909872715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285596" y="3154184"/>
                              <a:ext cx="2450242" cy="201123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F7168551-02BB-46DC-BC5D-62E8A567EB0E}"/>
                    </a:ext>
                  </a:extLst>
                </p:cNvPr>
                <p:cNvSpPr txBox="1"/>
                <p:nvPr/>
              </p:nvSpPr>
              <p:spPr>
                <a:xfrm>
                  <a:off x="5125430" y="3235973"/>
                  <a:ext cx="510235" cy="2685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5F6C8E9B-E0ED-4FB2-8F50-69E96288DCEF}"/>
                  </a:ext>
                </a:extLst>
              </p:cNvPr>
              <p:cNvGrpSpPr/>
              <p:nvPr/>
            </p:nvGrpSpPr>
            <p:grpSpPr>
              <a:xfrm>
                <a:off x="268916" y="982250"/>
                <a:ext cx="5250928" cy="3223952"/>
                <a:chOff x="2978346" y="2900450"/>
                <a:chExt cx="5250928" cy="3223952"/>
              </a:xfrm>
            </p:grpSpPr>
            <p:graphicFrame>
              <p:nvGraphicFramePr>
                <p:cNvPr id="86" name="Object 85">
                  <a:extLst>
                    <a:ext uri="{FF2B5EF4-FFF2-40B4-BE49-F238E27FC236}">
                      <a16:creationId xmlns:a16="http://schemas.microsoft.com/office/drawing/2014/main" id="{324803BF-E8F1-47D1-9DC5-642B6CC23A7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978405437"/>
                    </p:ext>
                  </p:extLst>
                </p:nvPr>
              </p:nvGraphicFramePr>
              <p:xfrm>
                <a:off x="3065519" y="2900450"/>
                <a:ext cx="5163755" cy="322395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4" imgW="6930200" imgH="4321699" progId="Prism9.Document">
                        <p:embed/>
                      </p:oleObj>
                    </mc:Choice>
                    <mc:Fallback>
                      <p:oleObj name="Prism 9" r:id="rId14" imgW="6930200" imgH="4321699" progId="Prism9.Document">
                        <p:embed/>
                        <p:pic>
                          <p:nvPicPr>
                            <p:cNvPr id="86" name="Object 85">
                              <a:extLst>
                                <a:ext uri="{FF2B5EF4-FFF2-40B4-BE49-F238E27FC236}">
                                  <a16:creationId xmlns:a16="http://schemas.microsoft.com/office/drawing/2014/main" id="{324803BF-E8F1-47D1-9DC5-642B6CC23A7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065519" y="2900450"/>
                              <a:ext cx="5163755" cy="322395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59B65692-1B40-4923-B41D-0A60C0167C2F}"/>
                    </a:ext>
                  </a:extLst>
                </p:cNvPr>
                <p:cNvSpPr txBox="1"/>
                <p:nvPr/>
              </p:nvSpPr>
              <p:spPr>
                <a:xfrm>
                  <a:off x="2978346" y="2969700"/>
                  <a:ext cx="556675" cy="2849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</p:grpSp>
        </p:grp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9B81567-1AA8-45C2-AE16-B19EFBA2828E}"/>
                </a:ext>
              </a:extLst>
            </p:cNvPr>
            <p:cNvSpPr txBox="1"/>
            <p:nvPr/>
          </p:nvSpPr>
          <p:spPr>
            <a:xfrm>
              <a:off x="376725" y="3200462"/>
              <a:ext cx="578447" cy="360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D779827B-E4DE-4253-B869-F0B52E0D3F9E}"/>
              </a:ext>
            </a:extLst>
          </p:cNvPr>
          <p:cNvGrpSpPr/>
          <p:nvPr/>
        </p:nvGrpSpPr>
        <p:grpSpPr>
          <a:xfrm>
            <a:off x="4800887" y="6726263"/>
            <a:ext cx="2288107" cy="2376599"/>
            <a:chOff x="4852674" y="7478753"/>
            <a:chExt cx="2692735" cy="2785161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0DCFD28-B76A-46C7-9A16-5CBF475A9F6F}"/>
                </a:ext>
              </a:extLst>
            </p:cNvPr>
            <p:cNvSpPr txBox="1"/>
            <p:nvPr/>
          </p:nvSpPr>
          <p:spPr>
            <a:xfrm>
              <a:off x="4976723" y="7478753"/>
              <a:ext cx="423982" cy="360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326C5C0E-70F5-4343-896A-B4414629B8B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67352718"/>
                </p:ext>
              </p:extLst>
            </p:nvPr>
          </p:nvGraphicFramePr>
          <p:xfrm>
            <a:off x="4852674" y="7659151"/>
            <a:ext cx="2692735" cy="26047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6" imgW="3352254" imgH="3242894" progId="Prism9.Document">
                    <p:embed/>
                  </p:oleObj>
                </mc:Choice>
                <mc:Fallback>
                  <p:oleObj name="Prism 9" r:id="rId16" imgW="3352254" imgH="3242894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326C5C0E-70F5-4343-896A-B4414629B8B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852674" y="7659151"/>
                          <a:ext cx="2692735" cy="26047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255A963-1037-4389-9E0E-91145637D462}"/>
              </a:ext>
            </a:extLst>
          </p:cNvPr>
          <p:cNvGrpSpPr/>
          <p:nvPr/>
        </p:nvGrpSpPr>
        <p:grpSpPr>
          <a:xfrm>
            <a:off x="412962" y="6742966"/>
            <a:ext cx="4383311" cy="2436994"/>
            <a:chOff x="412962" y="6742966"/>
            <a:chExt cx="4383311" cy="2436994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C192E1BE-F86E-4E16-B281-0613C06D76A5}"/>
                </a:ext>
              </a:extLst>
            </p:cNvPr>
            <p:cNvGrpSpPr/>
            <p:nvPr/>
          </p:nvGrpSpPr>
          <p:grpSpPr>
            <a:xfrm>
              <a:off x="412962" y="6742966"/>
              <a:ext cx="4383311" cy="2436994"/>
              <a:chOff x="114141" y="6970049"/>
              <a:chExt cx="4383311" cy="2436994"/>
            </a:xfrm>
          </p:grpSpPr>
          <p:cxnSp>
            <p:nvCxnSpPr>
              <p:cNvPr id="77" name="Straight Arrow Connector 76">
                <a:extLst>
                  <a:ext uri="{FF2B5EF4-FFF2-40B4-BE49-F238E27FC236}">
                    <a16:creationId xmlns:a16="http://schemas.microsoft.com/office/drawing/2014/main" id="{65F35D0A-F7B1-4F54-B306-C453EF67C9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4457" y="9153893"/>
                <a:ext cx="3582122" cy="2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B60F7398-1E7C-4173-974A-1A26A3674B2C}"/>
                  </a:ext>
                </a:extLst>
              </p:cNvPr>
              <p:cNvGrpSpPr/>
              <p:nvPr/>
            </p:nvGrpSpPr>
            <p:grpSpPr>
              <a:xfrm>
                <a:off x="114141" y="6970049"/>
                <a:ext cx="4383311" cy="2436994"/>
                <a:chOff x="-22522" y="6637044"/>
                <a:chExt cx="5915461" cy="3315829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ABEA79A6-64FF-468E-BA7A-28E0FF667A59}"/>
                    </a:ext>
                  </a:extLst>
                </p:cNvPr>
                <p:cNvGrpSpPr/>
                <p:nvPr/>
              </p:nvGrpSpPr>
              <p:grpSpPr>
                <a:xfrm>
                  <a:off x="-22522" y="6637044"/>
                  <a:ext cx="5712878" cy="3315829"/>
                  <a:chOff x="-22522" y="6637044"/>
                  <a:chExt cx="5712878" cy="3315829"/>
                </a:xfrm>
              </p:grpSpPr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6D25D1E6-6648-41DE-A689-0D9010843D64}"/>
                      </a:ext>
                    </a:extLst>
                  </p:cNvPr>
                  <p:cNvSpPr txBox="1"/>
                  <p:nvPr/>
                </p:nvSpPr>
                <p:spPr>
                  <a:xfrm>
                    <a:off x="49772" y="6637044"/>
                    <a:ext cx="556675" cy="4187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</a:t>
                    </a:r>
                  </a:p>
                </p:txBody>
              </p:sp>
              <p:grpSp>
                <p:nvGrpSpPr>
                  <p:cNvPr id="7" name="Group 6">
                    <a:extLst>
                      <a:ext uri="{FF2B5EF4-FFF2-40B4-BE49-F238E27FC236}">
                        <a16:creationId xmlns:a16="http://schemas.microsoft.com/office/drawing/2014/main" id="{8FBA595F-FD0D-418F-9404-D57502EDF309}"/>
                      </a:ext>
                    </a:extLst>
                  </p:cNvPr>
                  <p:cNvGrpSpPr/>
                  <p:nvPr/>
                </p:nvGrpSpPr>
                <p:grpSpPr>
                  <a:xfrm>
                    <a:off x="-22522" y="6967237"/>
                    <a:ext cx="5712878" cy="2985636"/>
                    <a:chOff x="38303" y="7305918"/>
                    <a:chExt cx="5712878" cy="2985636"/>
                  </a:xfrm>
                </p:grpSpPr>
                <p:grpSp>
                  <p:nvGrpSpPr>
                    <p:cNvPr id="69" name="Group 68">
                      <a:extLst>
                        <a:ext uri="{FF2B5EF4-FFF2-40B4-BE49-F238E27FC236}">
                          <a16:creationId xmlns:a16="http://schemas.microsoft.com/office/drawing/2014/main" id="{B06A4358-C5E9-43AE-9DB6-7AFCEFC458C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27563" y="7519926"/>
                      <a:ext cx="1284366" cy="2504320"/>
                      <a:chOff x="520700" y="402348"/>
                      <a:chExt cx="2941592" cy="5554548"/>
                    </a:xfrm>
                  </p:grpSpPr>
                  <p:pic>
                    <p:nvPicPr>
                      <p:cNvPr id="70" name="Picture 69">
                        <a:extLst>
                          <a:ext uri="{FF2B5EF4-FFF2-40B4-BE49-F238E27FC236}">
                            <a16:creationId xmlns:a16="http://schemas.microsoft.com/office/drawing/2014/main" id="{EC225FBB-8DED-4CE9-8C53-4432BCF9911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46103" y="402348"/>
                        <a:ext cx="2916189" cy="2870622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71" name="Picture 70">
                        <a:extLst>
                          <a:ext uri="{FF2B5EF4-FFF2-40B4-BE49-F238E27FC236}">
                            <a16:creationId xmlns:a16="http://schemas.microsoft.com/office/drawing/2014/main" id="{D2AC7B96-CE2A-4701-9DBA-756A41768D5B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20700" y="3086275"/>
                        <a:ext cx="2916189" cy="2870621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29" name="Group 28">
                      <a:extLst>
                        <a:ext uri="{FF2B5EF4-FFF2-40B4-BE49-F238E27FC236}">
                          <a16:creationId xmlns:a16="http://schemas.microsoft.com/office/drawing/2014/main" id="{431ED054-FEB2-4D71-93B8-4F56E60BAFF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303" y="7305918"/>
                      <a:ext cx="5712878" cy="2985636"/>
                      <a:chOff x="33628" y="7246263"/>
                      <a:chExt cx="5712878" cy="2985636"/>
                    </a:xfrm>
                  </p:grpSpPr>
                  <p:sp>
                    <p:nvSpPr>
                      <p:cNvPr id="41" name="TextBox 40">
                        <a:extLst>
                          <a:ext uri="{FF2B5EF4-FFF2-40B4-BE49-F238E27FC236}">
                            <a16:creationId xmlns:a16="http://schemas.microsoft.com/office/drawing/2014/main" id="{C6A89713-FE85-4E2D-91DC-EA4050E5F6D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73944" y="7246263"/>
                        <a:ext cx="805990" cy="502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DC2 </a:t>
                        </a:r>
                        <a:r>
                          <a:rPr lang="en-US" sz="9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</a:t>
                        </a:r>
                        <a:endPara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2" name="TextBox 41">
                        <a:extLst>
                          <a:ext uri="{FF2B5EF4-FFF2-40B4-BE49-F238E27FC236}">
                            <a16:creationId xmlns:a16="http://schemas.microsoft.com/office/drawing/2014/main" id="{E36D19D8-B188-44C9-A4F7-05AAE597BB0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627991" y="7246263"/>
                        <a:ext cx="805990" cy="502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DC4 </a:t>
                        </a:r>
                        <a:r>
                          <a:rPr lang="en-US" sz="9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</a:t>
                        </a:r>
                        <a:endPara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6" name="TextBox 55">
                        <a:extLst>
                          <a:ext uri="{FF2B5EF4-FFF2-40B4-BE49-F238E27FC236}">
                            <a16:creationId xmlns:a16="http://schemas.microsoft.com/office/drawing/2014/main" id="{8641EB75-C60C-4130-A8EA-F54A205143D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33213" y="7246264"/>
                        <a:ext cx="805990" cy="502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DC1 </a:t>
                        </a:r>
                        <a:r>
                          <a:rPr lang="en-US" sz="9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</a:t>
                        </a:r>
                        <a:endPara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21" name="Group 20">
                        <a:extLst>
                          <a:ext uri="{FF2B5EF4-FFF2-40B4-BE49-F238E27FC236}">
                            <a16:creationId xmlns:a16="http://schemas.microsoft.com/office/drawing/2014/main" id="{408FF995-41D3-4FFE-BF0E-BFFDA03EA3E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3628" y="7443537"/>
                        <a:ext cx="5712878" cy="2788362"/>
                        <a:chOff x="33628" y="7443537"/>
                        <a:chExt cx="5712878" cy="2788362"/>
                      </a:xfrm>
                    </p:grpSpPr>
                    <p:grpSp>
                      <p:nvGrpSpPr>
                        <p:cNvPr id="19" name="Group 18">
                          <a:extLst>
                            <a:ext uri="{FF2B5EF4-FFF2-40B4-BE49-F238E27FC236}">
                              <a16:creationId xmlns:a16="http://schemas.microsoft.com/office/drawing/2014/main" id="{45A53153-A471-45BC-BFB2-6C276FC2A72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57126" y="7443537"/>
                          <a:ext cx="5089380" cy="2788362"/>
                          <a:chOff x="665479" y="7455413"/>
                          <a:chExt cx="5089380" cy="2788362"/>
                        </a:xfrm>
                      </p:grpSpPr>
                      <p:grpSp>
                        <p:nvGrpSpPr>
                          <p:cNvPr id="17" name="Group 16">
                            <a:extLst>
                              <a:ext uri="{FF2B5EF4-FFF2-40B4-BE49-F238E27FC236}">
                                <a16:creationId xmlns:a16="http://schemas.microsoft.com/office/drawing/2014/main" id="{1057FB4D-ECB4-4AB4-83E1-A8B6ABF393B3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65479" y="7455413"/>
                            <a:ext cx="3841501" cy="2524480"/>
                            <a:chOff x="665479" y="7455413"/>
                            <a:chExt cx="3841501" cy="2524480"/>
                          </a:xfrm>
                        </p:grpSpPr>
                        <p:grpSp>
                          <p:nvGrpSpPr>
                            <p:cNvPr id="12" name="Group 11">
                              <a:extLst>
                                <a:ext uri="{FF2B5EF4-FFF2-40B4-BE49-F238E27FC236}">
                                  <a16:creationId xmlns:a16="http://schemas.microsoft.com/office/drawing/2014/main" id="{F6A37476-0FC6-4A0E-B6B8-F179FBBEBA7F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165065" y="7471632"/>
                              <a:ext cx="1341915" cy="2508261"/>
                              <a:chOff x="3165065" y="7471632"/>
                              <a:chExt cx="1341915" cy="2508261"/>
                            </a:xfrm>
                          </p:grpSpPr>
                          <p:pic>
                            <p:nvPicPr>
                              <p:cNvPr id="67" name="Picture 66">
                                <a:extLst>
                                  <a:ext uri="{FF2B5EF4-FFF2-40B4-BE49-F238E27FC236}">
                                    <a16:creationId xmlns:a16="http://schemas.microsoft.com/office/drawing/2014/main" id="{B348D0BC-7271-42A4-9475-E0D7C0D4689A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0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182275" y="7471632"/>
                                <a:ext cx="1292601" cy="12724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  <p:pic>
                            <p:nvPicPr>
                              <p:cNvPr id="83" name="Picture 82">
                                <a:extLst>
                                  <a:ext uri="{FF2B5EF4-FFF2-40B4-BE49-F238E27FC236}">
                                    <a16:creationId xmlns:a16="http://schemas.microsoft.com/office/drawing/2014/main" id="{1D96522A-33A9-44F7-92C3-BEB89DD206DF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165065" y="8658944"/>
                                <a:ext cx="1341915" cy="1320949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grpSp>
                        <p:grpSp>
                          <p:nvGrpSpPr>
                            <p:cNvPr id="13" name="Group 12">
                              <a:extLst>
                                <a:ext uri="{FF2B5EF4-FFF2-40B4-BE49-F238E27FC236}">
                                  <a16:creationId xmlns:a16="http://schemas.microsoft.com/office/drawing/2014/main" id="{9972087A-2D3B-401D-BCCE-0F6EB5217247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906086" y="7455413"/>
                              <a:ext cx="1341915" cy="2512182"/>
                              <a:chOff x="1906086" y="7455413"/>
                              <a:chExt cx="1341915" cy="2512182"/>
                            </a:xfrm>
                          </p:grpSpPr>
                          <p:pic>
                            <p:nvPicPr>
                              <p:cNvPr id="82" name="Picture 81">
                                <a:extLst>
                                  <a:ext uri="{FF2B5EF4-FFF2-40B4-BE49-F238E27FC236}">
                                    <a16:creationId xmlns:a16="http://schemas.microsoft.com/office/drawing/2014/main" id="{9188C92B-702D-4239-9DB0-341D95C12B53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2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921092" y="7455413"/>
                                <a:ext cx="1318734" cy="1298129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  <p:pic>
                            <p:nvPicPr>
                              <p:cNvPr id="66" name="Picture 65">
                                <a:extLst>
                                  <a:ext uri="{FF2B5EF4-FFF2-40B4-BE49-F238E27FC236}">
                                    <a16:creationId xmlns:a16="http://schemas.microsoft.com/office/drawing/2014/main" id="{3A96D8D0-252C-466D-8CA6-48B8E9CBDA39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906086" y="8646647"/>
                                <a:ext cx="1341915" cy="1320948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grpSp>
                        <p:grpSp>
                          <p:nvGrpSpPr>
                            <p:cNvPr id="15" name="Group 14">
                              <a:extLst>
                                <a:ext uri="{FF2B5EF4-FFF2-40B4-BE49-F238E27FC236}">
                                  <a16:creationId xmlns:a16="http://schemas.microsoft.com/office/drawing/2014/main" id="{C7553AC3-059B-4739-AAA8-DFCEDC138BF0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65479" y="7455414"/>
                              <a:ext cx="1347471" cy="2521860"/>
                              <a:chOff x="665479" y="7455414"/>
                              <a:chExt cx="1347471" cy="2521860"/>
                            </a:xfrm>
                          </p:grpSpPr>
                          <p:pic>
                            <p:nvPicPr>
                              <p:cNvPr id="81" name="Picture 80">
                                <a:extLst>
                                  <a:ext uri="{FF2B5EF4-FFF2-40B4-BE49-F238E27FC236}">
                                    <a16:creationId xmlns:a16="http://schemas.microsoft.com/office/drawing/2014/main" id="{C6CD0198-385B-44F0-9288-E1310DDE6209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694216" y="7455414"/>
                                <a:ext cx="1318734" cy="1298129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  <p:pic>
                            <p:nvPicPr>
                              <p:cNvPr id="64" name="Picture 63">
                                <a:extLst>
                                  <a:ext uri="{FF2B5EF4-FFF2-40B4-BE49-F238E27FC236}">
                                    <a16:creationId xmlns:a16="http://schemas.microsoft.com/office/drawing/2014/main" id="{449CDF7A-C30B-4CD5-A17A-8F3F42775A34}"/>
                                  </a:ext>
                                </a:extLst>
                              </p:cNvPr>
                              <p:cNvPicPr>
                                <a:picLocks noChangeAspect="1"/>
                              </p:cNvPicPr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665479" y="8656326"/>
                                <a:ext cx="1341915" cy="1320948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grpSp>
                      </p:grpSp>
                      <p:sp>
                        <p:nvSpPr>
                          <p:cNvPr id="88" name="TextBox 87">
                            <a:extLst>
                              <a:ext uri="{FF2B5EF4-FFF2-40B4-BE49-F238E27FC236}">
                                <a16:creationId xmlns:a16="http://schemas.microsoft.com/office/drawing/2014/main" id="{C834F703-3AA1-40BB-97E7-ECAD3D59D50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72629" y="9929700"/>
                            <a:ext cx="4982230" cy="314075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 CD81</a:t>
                            </a:r>
                          </a:p>
                        </p:txBody>
                      </p:sp>
                    </p:grpSp>
                    <p:sp>
                      <p:nvSpPr>
                        <p:cNvPr id="90" name="TextBox 89">
                          <a:extLst>
                            <a:ext uri="{FF2B5EF4-FFF2-40B4-BE49-F238E27FC236}">
                              <a16:creationId xmlns:a16="http://schemas.microsoft.com/office/drawing/2014/main" id="{8C543334-A21C-408B-B6A3-7D1240D3FFD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3628" y="8929261"/>
                          <a:ext cx="792769" cy="879412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  <a:p>
                          <a:r>
                            <a:rPr lang="en-US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R-tEV</a:t>
                          </a:r>
                        </a:p>
                        <a:p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  <a:p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91" name="TextBox 90">
                          <a:extLst>
                            <a:ext uri="{FF2B5EF4-FFF2-40B4-BE49-F238E27FC236}">
                              <a16:creationId xmlns:a16="http://schemas.microsoft.com/office/drawing/2014/main" id="{E295D718-C13A-4724-8F1B-17A8C0C7299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66231" y="7698377"/>
                          <a:ext cx="633471" cy="879412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  <a:p>
                          <a:pPr algn="ctr"/>
                          <a:r>
                            <a:rPr lang="en-US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EV</a:t>
                          </a:r>
                        </a:p>
                        <a:p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  <a:p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</p:grpSp>
              </p:grpSp>
            </p:grp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96E2A4E9-6556-40A0-8DC2-8FDD523DDEE3}"/>
                    </a:ext>
                  </a:extLst>
                </p:cNvPr>
                <p:cNvSpPr txBox="1"/>
                <p:nvPr/>
              </p:nvSpPr>
              <p:spPr>
                <a:xfrm>
                  <a:off x="4622502" y="6950955"/>
                  <a:ext cx="1270437" cy="3140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  <a:r>
                    <a:rPr lang="en-US" sz="9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DZ1</a:t>
                  </a:r>
                </a:p>
              </p:txBody>
            </p:sp>
          </p:grpSp>
        </p:grp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D2BAE0B-A644-43EB-88D7-1016336BD34F}"/>
                </a:ext>
              </a:extLst>
            </p:cNvPr>
            <p:cNvSpPr txBox="1"/>
            <p:nvPr/>
          </p:nvSpPr>
          <p:spPr>
            <a:xfrm rot="16200000">
              <a:off x="653397" y="7846047"/>
              <a:ext cx="532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Straight Arrow Connector 111">
              <a:extLst>
                <a:ext uri="{FF2B5EF4-FFF2-40B4-BE49-F238E27FC236}">
                  <a16:creationId xmlns:a16="http://schemas.microsoft.com/office/drawing/2014/main" id="{3A9E07C5-D713-482D-90E7-0056FD1669A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40931" y="7129136"/>
              <a:ext cx="9823" cy="165107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42788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34785424-3CCA-44D9-A54C-11CE9B834155}"/>
              </a:ext>
            </a:extLst>
          </p:cNvPr>
          <p:cNvGrpSpPr/>
          <p:nvPr/>
        </p:nvGrpSpPr>
        <p:grpSpPr>
          <a:xfrm>
            <a:off x="2438053" y="254814"/>
            <a:ext cx="2147418" cy="2454275"/>
            <a:chOff x="311757" y="3112212"/>
            <a:chExt cx="1935700" cy="2271058"/>
          </a:xfrm>
        </p:grpSpPr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5E483FD7-C6F0-49BB-9A3B-8F3958E90A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689363"/>
                </p:ext>
              </p:extLst>
            </p:nvPr>
          </p:nvGraphicFramePr>
          <p:xfrm>
            <a:off x="342816" y="3112212"/>
            <a:ext cx="1904641" cy="22710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029375" imgH="3611495" progId="Prism9.Document">
                    <p:embed/>
                  </p:oleObj>
                </mc:Choice>
                <mc:Fallback>
                  <p:oleObj name="Prism 9" r:id="rId3" imgW="3029375" imgH="3611495" progId="Prism9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5E483FD7-C6F0-49BB-9A3B-8F3958E90A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2816" y="3112212"/>
                          <a:ext cx="1904641" cy="22710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2A8C5FA-E3CD-4C54-BBC0-4F47A7F7F9CC}"/>
                </a:ext>
              </a:extLst>
            </p:cNvPr>
            <p:cNvSpPr txBox="1"/>
            <p:nvPr/>
          </p:nvSpPr>
          <p:spPr>
            <a:xfrm>
              <a:off x="311757" y="3136353"/>
              <a:ext cx="556675" cy="284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F06963B-C5F4-407D-A992-A36575A4B61C}"/>
              </a:ext>
            </a:extLst>
          </p:cNvPr>
          <p:cNvGrpSpPr/>
          <p:nvPr/>
        </p:nvGrpSpPr>
        <p:grpSpPr>
          <a:xfrm>
            <a:off x="343491" y="284274"/>
            <a:ext cx="2238282" cy="2461051"/>
            <a:chOff x="2143664" y="3163848"/>
            <a:chExt cx="2017605" cy="2277328"/>
          </a:xfrm>
        </p:grpSpPr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033D995F-22B6-435E-A73D-C3D3734DD53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77842"/>
                </p:ext>
              </p:extLst>
            </p:nvPr>
          </p:nvGraphicFramePr>
          <p:xfrm>
            <a:off x="2256353" y="3163848"/>
            <a:ext cx="1904916" cy="22773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963864" imgH="3543102" progId="Prism9.Document">
                    <p:embed/>
                  </p:oleObj>
                </mc:Choice>
                <mc:Fallback>
                  <p:oleObj name="Prism 9" r:id="rId5" imgW="2963864" imgH="3543102" progId="Prism9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033D995F-22B6-435E-A73D-C3D3734DD53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256353" y="3163848"/>
                          <a:ext cx="1904916" cy="22773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22EC9EF-889E-415D-AF81-FC9040CBDA62}"/>
                </a:ext>
              </a:extLst>
            </p:cNvPr>
            <p:cNvSpPr txBox="1"/>
            <p:nvPr/>
          </p:nvSpPr>
          <p:spPr>
            <a:xfrm>
              <a:off x="2143664" y="3172333"/>
              <a:ext cx="556675" cy="284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D7141FFA-D2C8-4C94-9879-0AFE25F23E81}"/>
              </a:ext>
            </a:extLst>
          </p:cNvPr>
          <p:cNvGrpSpPr/>
          <p:nvPr/>
        </p:nvGrpSpPr>
        <p:grpSpPr>
          <a:xfrm>
            <a:off x="250102" y="5867755"/>
            <a:ext cx="3037851" cy="2937590"/>
            <a:chOff x="108153" y="5361493"/>
            <a:chExt cx="3413586" cy="3171558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D39A9C2-282D-43B9-9082-3C4B4A2BC783}"/>
                </a:ext>
              </a:extLst>
            </p:cNvPr>
            <p:cNvSpPr txBox="1"/>
            <p:nvPr/>
          </p:nvSpPr>
          <p:spPr>
            <a:xfrm>
              <a:off x="280577" y="5361493"/>
              <a:ext cx="556676" cy="332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1FD04095-D281-419C-A101-DEC2397525D5}"/>
                </a:ext>
              </a:extLst>
            </p:cNvPr>
            <p:cNvGrpSpPr/>
            <p:nvPr/>
          </p:nvGrpSpPr>
          <p:grpSpPr>
            <a:xfrm>
              <a:off x="108153" y="5514648"/>
              <a:ext cx="3413586" cy="3018403"/>
              <a:chOff x="-42042" y="5822961"/>
              <a:chExt cx="3413586" cy="3018403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7C9F1A5F-F649-4AA5-B428-1609935E6CF7}"/>
                  </a:ext>
                </a:extLst>
              </p:cNvPr>
              <p:cNvGrpSpPr/>
              <p:nvPr/>
            </p:nvGrpSpPr>
            <p:grpSpPr>
              <a:xfrm>
                <a:off x="-42042" y="5890605"/>
                <a:ext cx="3413586" cy="2950759"/>
                <a:chOff x="-42042" y="5890605"/>
                <a:chExt cx="3413586" cy="2950759"/>
              </a:xfrm>
            </p:grpSpPr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4B23D309-E8C8-43F8-9E11-291C385B0E81}"/>
                    </a:ext>
                  </a:extLst>
                </p:cNvPr>
                <p:cNvGrpSpPr/>
                <p:nvPr/>
              </p:nvGrpSpPr>
              <p:grpSpPr>
                <a:xfrm>
                  <a:off x="-42042" y="5890605"/>
                  <a:ext cx="3413586" cy="2950759"/>
                  <a:chOff x="-42042" y="5890605"/>
                  <a:chExt cx="3413586" cy="2950759"/>
                </a:xfrm>
              </p:grpSpPr>
              <p:grpSp>
                <p:nvGrpSpPr>
                  <p:cNvPr id="72" name="Group 71">
                    <a:extLst>
                      <a:ext uri="{FF2B5EF4-FFF2-40B4-BE49-F238E27FC236}">
                        <a16:creationId xmlns:a16="http://schemas.microsoft.com/office/drawing/2014/main" id="{BBB05548-1550-4EF2-80A5-08D6F5D77638}"/>
                      </a:ext>
                    </a:extLst>
                  </p:cNvPr>
                  <p:cNvGrpSpPr/>
                  <p:nvPr/>
                </p:nvGrpSpPr>
                <p:grpSpPr>
                  <a:xfrm>
                    <a:off x="-42042" y="5890605"/>
                    <a:ext cx="3413586" cy="2947825"/>
                    <a:chOff x="-42042" y="5890605"/>
                    <a:chExt cx="3413586" cy="2947825"/>
                  </a:xfrm>
                </p:grpSpPr>
                <p:grpSp>
                  <p:nvGrpSpPr>
                    <p:cNvPr id="54" name="Group 53">
                      <a:extLst>
                        <a:ext uri="{FF2B5EF4-FFF2-40B4-BE49-F238E27FC236}">
                          <a16:creationId xmlns:a16="http://schemas.microsoft.com/office/drawing/2014/main" id="{367065AA-F4B6-4B19-B7E8-8B4B8F3D52F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18576" y="5982378"/>
                      <a:ext cx="1452968" cy="2856052"/>
                      <a:chOff x="1746080" y="976496"/>
                      <a:chExt cx="1452968" cy="2856052"/>
                    </a:xfrm>
                  </p:grpSpPr>
                  <p:grpSp>
                    <p:nvGrpSpPr>
                      <p:cNvPr id="38" name="Group 37">
                        <a:extLst>
                          <a:ext uri="{FF2B5EF4-FFF2-40B4-BE49-F238E27FC236}">
                            <a16:creationId xmlns:a16="http://schemas.microsoft.com/office/drawing/2014/main" id="{2A0A15A4-DA39-4430-A95A-6E6193078BD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746080" y="976496"/>
                        <a:ext cx="1434192" cy="2708487"/>
                        <a:chOff x="1997886" y="15921"/>
                        <a:chExt cx="1557895" cy="2976978"/>
                      </a:xfrm>
                    </p:grpSpPr>
                    <p:pic>
                      <p:nvPicPr>
                        <p:cNvPr id="30" name="Picture 29">
                          <a:extLst>
                            <a:ext uri="{FF2B5EF4-FFF2-40B4-BE49-F238E27FC236}">
                              <a16:creationId xmlns:a16="http://schemas.microsoft.com/office/drawing/2014/main" id="{4E8A8EB4-0693-42F8-B7E3-F5CB52F22134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004709" y="15921"/>
                          <a:ext cx="1551072" cy="154551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7" name="Picture 26">
                          <a:extLst>
                            <a:ext uri="{FF2B5EF4-FFF2-40B4-BE49-F238E27FC236}">
                              <a16:creationId xmlns:a16="http://schemas.microsoft.com/office/drawing/2014/main" id="{8378DD7E-28CA-44CF-BD91-AB002A5F312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997886" y="1447380"/>
                          <a:ext cx="1551072" cy="1545519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43290F75-DAA7-484F-90D3-852B9ADD8CB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69045" y="3599945"/>
                        <a:ext cx="1030003" cy="23260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iameter (nm)</a:t>
                        </a:r>
                      </a:p>
                    </p:txBody>
                  </p:sp>
                </p:grpSp>
                <p:grpSp>
                  <p:nvGrpSpPr>
                    <p:cNvPr id="67" name="Group 66">
                      <a:extLst>
                        <a:ext uri="{FF2B5EF4-FFF2-40B4-BE49-F238E27FC236}">
                          <a16:creationId xmlns:a16="http://schemas.microsoft.com/office/drawing/2014/main" id="{ADB62774-CC0C-489B-BA40-4854C0F9E09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42042" y="5890605"/>
                      <a:ext cx="2041525" cy="2814948"/>
                      <a:chOff x="-109612" y="489721"/>
                      <a:chExt cx="2041525" cy="2814948"/>
                    </a:xfrm>
                  </p:grpSpPr>
                  <p:grpSp>
                    <p:nvGrpSpPr>
                      <p:cNvPr id="39" name="Group 38">
                        <a:extLst>
                          <a:ext uri="{FF2B5EF4-FFF2-40B4-BE49-F238E27FC236}">
                            <a16:creationId xmlns:a16="http://schemas.microsoft.com/office/drawing/2014/main" id="{A01F651B-862A-4D22-B6A1-AB7CAC740E2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12250" y="587470"/>
                        <a:ext cx="1419663" cy="2717199"/>
                        <a:chOff x="481408" y="182116"/>
                        <a:chExt cx="1555439" cy="2986552"/>
                      </a:xfrm>
                    </p:grpSpPr>
                    <p:pic>
                      <p:nvPicPr>
                        <p:cNvPr id="33" name="Picture 32">
                          <a:extLst>
                            <a:ext uri="{FF2B5EF4-FFF2-40B4-BE49-F238E27FC236}">
                              <a16:creationId xmlns:a16="http://schemas.microsoft.com/office/drawing/2014/main" id="{C62ABC90-A917-4495-994F-B93F6E7B83F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85775" y="182116"/>
                          <a:ext cx="1551072" cy="154551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6" name="Picture 35">
                          <a:extLst>
                            <a:ext uri="{FF2B5EF4-FFF2-40B4-BE49-F238E27FC236}">
                              <a16:creationId xmlns:a16="http://schemas.microsoft.com/office/drawing/2014/main" id="{49C2DFF8-979B-456B-9529-6525A75B3B8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81408" y="1623150"/>
                          <a:ext cx="1551072" cy="1545519"/>
                        </a:xfrm>
                        <a:prstGeom prst="rect">
                          <a:avLst/>
                        </a:prstGeom>
                      </p:spPr>
                    </p:pic>
                  </p:grpSp>
                  <p:grpSp>
                    <p:nvGrpSpPr>
                      <p:cNvPr id="58" name="Group 57">
                        <a:extLst>
                          <a:ext uri="{FF2B5EF4-FFF2-40B4-BE49-F238E27FC236}">
                            <a16:creationId xmlns:a16="http://schemas.microsoft.com/office/drawing/2014/main" id="{AFC228A6-2484-4BC8-B9D7-54EC96A7F6D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09612" y="489721"/>
                        <a:ext cx="778831" cy="2129352"/>
                        <a:chOff x="203357" y="3756783"/>
                        <a:chExt cx="1412840" cy="4609280"/>
                      </a:xfrm>
                    </p:grpSpPr>
                    <p:grpSp>
                      <p:nvGrpSpPr>
                        <p:cNvPr id="61" name="Group 60">
                          <a:extLst>
                            <a:ext uri="{FF2B5EF4-FFF2-40B4-BE49-F238E27FC236}">
                              <a16:creationId xmlns:a16="http://schemas.microsoft.com/office/drawing/2014/main" id="{7F7FA80F-B530-4CA4-966F-2A08B0DAE09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03357" y="4992403"/>
                          <a:ext cx="1270437" cy="3373660"/>
                          <a:chOff x="203357" y="4992403"/>
                          <a:chExt cx="1270437" cy="3373660"/>
                        </a:xfrm>
                      </p:grpSpPr>
                      <p:sp>
                        <p:nvSpPr>
                          <p:cNvPr id="63" name="TextBox 62">
                            <a:extLst>
                              <a:ext uri="{FF2B5EF4-FFF2-40B4-BE49-F238E27FC236}">
                                <a16:creationId xmlns:a16="http://schemas.microsoft.com/office/drawing/2014/main" id="{C71147A4-79FB-4533-9335-66B904DB4D1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03357" y="7862560"/>
                            <a:ext cx="1270437" cy="50350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 b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R-</a:t>
                            </a:r>
                            <a:r>
                              <a:rPr lang="en-US" sz="800" b="1" dirty="0" err="1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EV</a:t>
                            </a:r>
                            <a:endParaRPr lang="en-US" sz="8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4" name="TextBox 63">
                            <a:extLst>
                              <a:ext uri="{FF2B5EF4-FFF2-40B4-BE49-F238E27FC236}">
                                <a16:creationId xmlns:a16="http://schemas.microsoft.com/office/drawing/2014/main" id="{ABA65964-A560-47CC-B5FF-FCE287CE707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26328" y="4992403"/>
                            <a:ext cx="891670" cy="50350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800" b="1" dirty="0" err="1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EV</a:t>
                            </a:r>
                            <a:endParaRPr lang="en-US" sz="8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62" name="TextBox 61">
                          <a:extLst>
                            <a:ext uri="{FF2B5EF4-FFF2-40B4-BE49-F238E27FC236}">
                              <a16:creationId xmlns:a16="http://schemas.microsoft.com/office/drawing/2014/main" id="{39AB1E37-9E02-407D-B545-B94997F98C2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58014" y="4875799"/>
                          <a:ext cx="2677199" cy="439167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8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articles/mL (10</a:t>
                          </a:r>
                          <a:r>
                            <a:rPr lang="en-US" sz="800" b="1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</a:t>
                          </a:r>
                          <a:r>
                            <a:rPr lang="en-US" sz="8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)</a:t>
                          </a:r>
                        </a:p>
                      </p:txBody>
                    </p:sp>
                  </p:grpSp>
                </p:grpSp>
              </p:grp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853AFF6E-A5FA-4DD6-AE50-6F8157C3207E}"/>
                      </a:ext>
                    </a:extLst>
                  </p:cNvPr>
                  <p:cNvSpPr txBox="1"/>
                  <p:nvPr/>
                </p:nvSpPr>
                <p:spPr>
                  <a:xfrm>
                    <a:off x="911323" y="8608761"/>
                    <a:ext cx="1030003" cy="232603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ameter (nm)</a:t>
                    </a:r>
                  </a:p>
                </p:txBody>
              </p:sp>
            </p:grp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A7A92825-626F-4CFC-801E-0DCDF8370E08}"/>
                    </a:ext>
                  </a:extLst>
                </p:cNvPr>
                <p:cNvSpPr txBox="1"/>
                <p:nvPr/>
              </p:nvSpPr>
              <p:spPr>
                <a:xfrm rot="16200000">
                  <a:off x="1989" y="7699024"/>
                  <a:ext cx="1236787" cy="24209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ticles/mL (10</a:t>
                  </a:r>
                  <a:r>
                    <a:rPr lang="en-US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9A910115-C231-4BBF-A468-64F3F5520883}"/>
                  </a:ext>
                </a:extLst>
              </p:cNvPr>
              <p:cNvSpPr txBox="1"/>
              <p:nvPr/>
            </p:nvSpPr>
            <p:spPr>
              <a:xfrm>
                <a:off x="1231789" y="5835952"/>
                <a:ext cx="491534" cy="2326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1834E72B-57A7-4294-8AE8-EA5D89647BDD}"/>
                  </a:ext>
                </a:extLst>
              </p:cNvPr>
              <p:cNvSpPr txBox="1"/>
              <p:nvPr/>
            </p:nvSpPr>
            <p:spPr>
              <a:xfrm>
                <a:off x="2367915" y="5822961"/>
                <a:ext cx="811749" cy="2326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DC1 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813D75A3-18D8-4E86-9D7D-2E81EB89D01B}"/>
              </a:ext>
            </a:extLst>
          </p:cNvPr>
          <p:cNvGrpSpPr/>
          <p:nvPr/>
        </p:nvGrpSpPr>
        <p:grpSpPr>
          <a:xfrm>
            <a:off x="377269" y="2457653"/>
            <a:ext cx="4862622" cy="3306393"/>
            <a:chOff x="187658" y="2721658"/>
            <a:chExt cx="5939752" cy="369409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ACB82A2-677C-43A0-8B95-EAEE1660D2C8}"/>
                </a:ext>
              </a:extLst>
            </p:cNvPr>
            <p:cNvGrpSpPr/>
            <p:nvPr/>
          </p:nvGrpSpPr>
          <p:grpSpPr>
            <a:xfrm>
              <a:off x="187658" y="2721658"/>
              <a:ext cx="5939752" cy="3694095"/>
              <a:chOff x="273220" y="152761"/>
              <a:chExt cx="6881924" cy="4365583"/>
            </a:xfrm>
          </p:grpSpPr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9DCE7073-15EA-4270-8685-7ED604A4070A}"/>
                  </a:ext>
                </a:extLst>
              </p:cNvPr>
              <p:cNvGrpSpPr/>
              <p:nvPr/>
            </p:nvGrpSpPr>
            <p:grpSpPr>
              <a:xfrm>
                <a:off x="273220" y="152761"/>
                <a:ext cx="5824675" cy="4365583"/>
                <a:chOff x="253407" y="422946"/>
                <a:chExt cx="5824675" cy="4365583"/>
              </a:xfrm>
            </p:grpSpPr>
            <p:grpSp>
              <p:nvGrpSpPr>
                <p:cNvPr id="106" name="Group 105">
                  <a:extLst>
                    <a:ext uri="{FF2B5EF4-FFF2-40B4-BE49-F238E27FC236}">
                      <a16:creationId xmlns:a16="http://schemas.microsoft.com/office/drawing/2014/main" id="{EAC545DA-1747-4CE0-B2D2-DB607A89A4A5}"/>
                    </a:ext>
                  </a:extLst>
                </p:cNvPr>
                <p:cNvGrpSpPr/>
                <p:nvPr/>
              </p:nvGrpSpPr>
              <p:grpSpPr>
                <a:xfrm>
                  <a:off x="253407" y="422946"/>
                  <a:ext cx="5824675" cy="4365583"/>
                  <a:chOff x="253407" y="422946"/>
                  <a:chExt cx="5824675" cy="4365583"/>
                </a:xfrm>
              </p:grpSpPr>
              <p:graphicFrame>
                <p:nvGraphicFramePr>
                  <p:cNvPr id="24" name="Object 23">
                    <a:extLst>
                      <a:ext uri="{FF2B5EF4-FFF2-40B4-BE49-F238E27FC236}">
                        <a16:creationId xmlns:a16="http://schemas.microsoft.com/office/drawing/2014/main" id="{F0480657-1ADF-4715-9F7C-E2FD6BF413F8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227131651"/>
                      </p:ext>
                    </p:extLst>
                  </p:nvPr>
                </p:nvGraphicFramePr>
                <p:xfrm>
                  <a:off x="567508" y="664938"/>
                  <a:ext cx="5510574" cy="4123591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11" imgW="5441429" imgH="4071526" progId="Prism9.Document">
                          <p:embed/>
                        </p:oleObj>
                      </mc:Choice>
                      <mc:Fallback>
                        <p:oleObj name="Prism 9" r:id="rId11" imgW="5441429" imgH="4071526" progId="Prism9.Document">
                          <p:embed/>
                          <p:pic>
                            <p:nvPicPr>
                              <p:cNvPr id="24" name="Object 23">
                                <a:extLst>
                                  <a:ext uri="{FF2B5EF4-FFF2-40B4-BE49-F238E27FC236}">
                                    <a16:creationId xmlns:a16="http://schemas.microsoft.com/office/drawing/2014/main" id="{F0480657-1ADF-4715-9F7C-E2FD6BF413F8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2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67508" y="664938"/>
                                <a:ext cx="5510574" cy="4123591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A78BBE33-9DCF-4940-AF23-E2AE220164CD}"/>
                      </a:ext>
                    </a:extLst>
                  </p:cNvPr>
                  <p:cNvSpPr txBox="1"/>
                  <p:nvPr/>
                </p:nvSpPr>
                <p:spPr>
                  <a:xfrm>
                    <a:off x="253407" y="422946"/>
                    <a:ext cx="622123" cy="40637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</p:grp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1F937434-F8DF-43E3-9685-FBFFAA7FE960}"/>
                    </a:ext>
                  </a:extLst>
                </p:cNvPr>
                <p:cNvSpPr txBox="1"/>
                <p:nvPr/>
              </p:nvSpPr>
              <p:spPr>
                <a:xfrm>
                  <a:off x="3203811" y="431079"/>
                  <a:ext cx="556675" cy="4063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</p:grpSp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FC7CA235-263E-4B3E-B591-E4DF3EC6BAD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47052071"/>
                  </p:ext>
                </p:extLst>
              </p:nvPr>
            </p:nvGraphicFramePr>
            <p:xfrm>
              <a:off x="3481669" y="402543"/>
              <a:ext cx="3673475" cy="25273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3" imgW="3674053" imgH="2528010" progId="Prism9.Document">
                      <p:embed/>
                    </p:oleObj>
                  </mc:Choice>
                  <mc:Fallback>
                    <p:oleObj name="Prism 9" r:id="rId13" imgW="3674053" imgH="2528010" progId="Prism9.Document">
                      <p:embed/>
                      <p:pic>
                        <p:nvPicPr>
                          <p:cNvPr id="2" name="Object 1">
                            <a:extLst>
                              <a:ext uri="{FF2B5EF4-FFF2-40B4-BE49-F238E27FC236}">
                                <a16:creationId xmlns:a16="http://schemas.microsoft.com/office/drawing/2014/main" id="{FC7CA235-263E-4B3E-B591-E4DF3EC6BAD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3481669" y="402543"/>
                            <a:ext cx="3673475" cy="25273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D97C6BD5-E97C-4C5E-926C-4D0CB90A4C28}"/>
                </a:ext>
              </a:extLst>
            </p:cNvPr>
            <p:cNvSpPr txBox="1"/>
            <p:nvPr/>
          </p:nvSpPr>
          <p:spPr>
            <a:xfrm>
              <a:off x="212904" y="5117176"/>
              <a:ext cx="556675" cy="34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9F90E865-6B9D-4FB4-9B0C-96BF3E686F7F}"/>
              </a:ext>
            </a:extLst>
          </p:cNvPr>
          <p:cNvGrpSpPr/>
          <p:nvPr/>
        </p:nvGrpSpPr>
        <p:grpSpPr>
          <a:xfrm>
            <a:off x="3570023" y="5841931"/>
            <a:ext cx="2140672" cy="3041056"/>
            <a:chOff x="3053837" y="6038591"/>
            <a:chExt cx="2140672" cy="3041056"/>
          </a:xfrm>
        </p:grpSpPr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6071F8CB-94B9-4712-80CA-6F34D737C8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97986" y="6445426"/>
              <a:ext cx="0" cy="220451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35BDB295-EDFC-4959-8576-BFE6567A6108}"/>
                </a:ext>
              </a:extLst>
            </p:cNvPr>
            <p:cNvGrpSpPr/>
            <p:nvPr/>
          </p:nvGrpSpPr>
          <p:grpSpPr>
            <a:xfrm>
              <a:off x="3053837" y="6038591"/>
              <a:ext cx="2140672" cy="3041056"/>
              <a:chOff x="5092595" y="5761572"/>
              <a:chExt cx="2140672" cy="3041056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45AFBCE4-3FA8-427E-BFC0-30FE7D115985}"/>
                  </a:ext>
                </a:extLst>
              </p:cNvPr>
              <p:cNvSpPr txBox="1"/>
              <p:nvPr/>
            </p:nvSpPr>
            <p:spPr>
              <a:xfrm>
                <a:off x="5092595" y="5761572"/>
                <a:ext cx="4954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F2B241D6-F382-4871-9457-E3771E1AC852}"/>
                  </a:ext>
                </a:extLst>
              </p:cNvPr>
              <p:cNvGrpSpPr/>
              <p:nvPr/>
            </p:nvGrpSpPr>
            <p:grpSpPr>
              <a:xfrm>
                <a:off x="5317187" y="6072266"/>
                <a:ext cx="1916080" cy="2730362"/>
                <a:chOff x="5502190" y="6117334"/>
                <a:chExt cx="1916080" cy="2730362"/>
              </a:xfrm>
            </p:grpSpPr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BA8648AD-DE49-4F12-AEA6-93888B506958}"/>
                    </a:ext>
                  </a:extLst>
                </p:cNvPr>
                <p:cNvGrpSpPr/>
                <p:nvPr/>
              </p:nvGrpSpPr>
              <p:grpSpPr>
                <a:xfrm>
                  <a:off x="5510192" y="6117334"/>
                  <a:ext cx="1908078" cy="2730362"/>
                  <a:chOff x="5510192" y="6117334"/>
                  <a:chExt cx="1908078" cy="2730362"/>
                </a:xfrm>
              </p:grpSpPr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ABC1AFA9-DDF3-4441-B9CA-3F89657AD993}"/>
                      </a:ext>
                    </a:extLst>
                  </p:cNvPr>
                  <p:cNvGrpSpPr/>
                  <p:nvPr/>
                </p:nvGrpSpPr>
                <p:grpSpPr>
                  <a:xfrm>
                    <a:off x="5629628" y="6117334"/>
                    <a:ext cx="1520713" cy="2558818"/>
                    <a:chOff x="5629628" y="6117334"/>
                    <a:chExt cx="1520713" cy="2558818"/>
                  </a:xfrm>
                </p:grpSpPr>
                <p:cxnSp>
                  <p:nvCxnSpPr>
                    <p:cNvPr id="7" name="Straight Arrow Connector 6">
                      <a:extLst>
                        <a:ext uri="{FF2B5EF4-FFF2-40B4-BE49-F238E27FC236}">
                          <a16:creationId xmlns:a16="http://schemas.microsoft.com/office/drawing/2014/main" id="{AEFD8464-0FC6-461E-AE43-7DB51BBCD09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071778" y="8610188"/>
                      <a:ext cx="78490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0" name="Group 19">
                      <a:extLst>
                        <a:ext uri="{FF2B5EF4-FFF2-40B4-BE49-F238E27FC236}">
                          <a16:creationId xmlns:a16="http://schemas.microsoft.com/office/drawing/2014/main" id="{9F3783FD-7A6B-422C-9143-46D9B1AAC14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629628" y="6117334"/>
                      <a:ext cx="1520713" cy="2558818"/>
                      <a:chOff x="5629628" y="6117334"/>
                      <a:chExt cx="1520713" cy="2558818"/>
                    </a:xfrm>
                  </p:grpSpPr>
                  <p:sp>
                    <p:nvSpPr>
                      <p:cNvPr id="85" name="TextBox 84">
                        <a:extLst>
                          <a:ext uri="{FF2B5EF4-FFF2-40B4-BE49-F238E27FC236}">
                            <a16:creationId xmlns:a16="http://schemas.microsoft.com/office/drawing/2014/main" id="{C8A512D1-7ED2-4918-BD1E-8D060F36348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071778" y="6117334"/>
                        <a:ext cx="1078563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DC1 </a:t>
                        </a:r>
                        <a:r>
                          <a:rPr lang="en-US" sz="8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</a:t>
                        </a:r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</a:p>
                    </p:txBody>
                  </p:sp>
                  <p:grpSp>
                    <p:nvGrpSpPr>
                      <p:cNvPr id="12" name="Group 11">
                        <a:extLst>
                          <a:ext uri="{FF2B5EF4-FFF2-40B4-BE49-F238E27FC236}">
                            <a16:creationId xmlns:a16="http://schemas.microsoft.com/office/drawing/2014/main" id="{AF50FFBE-34AE-4AE3-A980-1AAEE50C459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629628" y="6252584"/>
                        <a:ext cx="1279743" cy="2423568"/>
                        <a:chOff x="5266146" y="6218865"/>
                        <a:chExt cx="1279743" cy="2423568"/>
                      </a:xfrm>
                    </p:grpSpPr>
                    <p:pic>
                      <p:nvPicPr>
                        <p:cNvPr id="81" name="Picture 80">
                          <a:extLst>
                            <a:ext uri="{FF2B5EF4-FFF2-40B4-BE49-F238E27FC236}">
                              <a16:creationId xmlns:a16="http://schemas.microsoft.com/office/drawing/2014/main" id="{A4D59E67-9541-4A82-AD01-A0E52D4BBFA0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266146" y="6218865"/>
                          <a:ext cx="1270741" cy="126068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84" name="Picture 83">
                          <a:extLst>
                            <a:ext uri="{FF2B5EF4-FFF2-40B4-BE49-F238E27FC236}">
                              <a16:creationId xmlns:a16="http://schemas.microsoft.com/office/drawing/2014/main" id="{7760DFFF-6459-46F9-BEEE-CAEA801B807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275148" y="7381748"/>
                          <a:ext cx="1270741" cy="1260685"/>
                        </a:xfrm>
                        <a:prstGeom prst="rect">
                          <a:avLst/>
                        </a:prstGeom>
                      </p:spPr>
                    </p:pic>
                  </p:grpSp>
                </p:grpSp>
              </p:grp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BADE51E7-7C04-4DF3-B5B9-2CD8A07E8C2E}"/>
                      </a:ext>
                    </a:extLst>
                  </p:cNvPr>
                  <p:cNvSpPr txBox="1"/>
                  <p:nvPr/>
                </p:nvSpPr>
                <p:spPr>
                  <a:xfrm>
                    <a:off x="5510192" y="8632252"/>
                    <a:ext cx="1908078" cy="21544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81</a:t>
                    </a:r>
                  </a:p>
                </p:txBody>
              </p: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D1DD1A4D-997B-4B13-B36F-E7D1A2E5E59A}"/>
                    </a:ext>
                  </a:extLst>
                </p:cNvPr>
                <p:cNvSpPr txBox="1"/>
                <p:nvPr/>
              </p:nvSpPr>
              <p:spPr>
                <a:xfrm rot="16200000">
                  <a:off x="4754888" y="7294380"/>
                  <a:ext cx="1694660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531490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oup 107">
            <a:extLst>
              <a:ext uri="{FF2B5EF4-FFF2-40B4-BE49-F238E27FC236}">
                <a16:creationId xmlns:a16="http://schemas.microsoft.com/office/drawing/2014/main" id="{38F65064-D990-44E7-AB01-478D4DB1A3DD}"/>
              </a:ext>
            </a:extLst>
          </p:cNvPr>
          <p:cNvGrpSpPr/>
          <p:nvPr/>
        </p:nvGrpSpPr>
        <p:grpSpPr>
          <a:xfrm>
            <a:off x="515054" y="7697908"/>
            <a:ext cx="2035964" cy="1869075"/>
            <a:chOff x="5488963" y="5044840"/>
            <a:chExt cx="2111208" cy="1908380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DF40A422-8FA4-406A-A6BA-BD5B6C4E0F2F}"/>
                </a:ext>
              </a:extLst>
            </p:cNvPr>
            <p:cNvGrpSpPr/>
            <p:nvPr/>
          </p:nvGrpSpPr>
          <p:grpSpPr>
            <a:xfrm>
              <a:off x="5708969" y="5279898"/>
              <a:ext cx="1891202" cy="1673322"/>
              <a:chOff x="4517311" y="7851389"/>
              <a:chExt cx="1689056" cy="1543499"/>
            </a:xfrm>
          </p:grpSpPr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6A1083C0-50DA-4122-B145-6BE0257C287E}"/>
                  </a:ext>
                </a:extLst>
              </p:cNvPr>
              <p:cNvGrpSpPr/>
              <p:nvPr/>
            </p:nvGrpSpPr>
            <p:grpSpPr>
              <a:xfrm>
                <a:off x="4517311" y="7851389"/>
                <a:ext cx="1689056" cy="1543499"/>
                <a:chOff x="4517311" y="7851389"/>
                <a:chExt cx="1689056" cy="1543499"/>
              </a:xfrm>
            </p:grpSpPr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A66B38C1-5E7C-423B-B9B0-D639B10F004C}"/>
                    </a:ext>
                  </a:extLst>
                </p:cNvPr>
                <p:cNvGrpSpPr/>
                <p:nvPr/>
              </p:nvGrpSpPr>
              <p:grpSpPr>
                <a:xfrm>
                  <a:off x="4517311" y="7851389"/>
                  <a:ext cx="1689056" cy="1462351"/>
                  <a:chOff x="6820254" y="2124227"/>
                  <a:chExt cx="1689056" cy="1462351"/>
                </a:xfrm>
              </p:grpSpPr>
              <p:pic>
                <p:nvPicPr>
                  <p:cNvPr id="41" name="Picture 40">
                    <a:extLst>
                      <a:ext uri="{FF2B5EF4-FFF2-40B4-BE49-F238E27FC236}">
                        <a16:creationId xmlns:a16="http://schemas.microsoft.com/office/drawing/2014/main" id="{F601ADF9-E00D-4E5A-AC90-26601D3A17D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6820254" y="2291104"/>
                    <a:ext cx="1316037" cy="1295474"/>
                  </a:xfrm>
                  <a:prstGeom prst="rect">
                    <a:avLst/>
                  </a:prstGeom>
                </p:spPr>
              </p:pic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415C7CD3-728A-405D-932B-BB834523AFE5}"/>
                      </a:ext>
                    </a:extLst>
                  </p:cNvPr>
                  <p:cNvSpPr txBox="1"/>
                  <p:nvPr/>
                </p:nvSpPr>
                <p:spPr>
                  <a:xfrm>
                    <a:off x="7193273" y="2124227"/>
                    <a:ext cx="1316037" cy="26088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0771 SDC1</a:t>
                    </a:r>
                  </a:p>
                </p:txBody>
              </p:sp>
            </p:grp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511930F4-6C1D-4583-B082-6448ED66AFFE}"/>
                    </a:ext>
                  </a:extLst>
                </p:cNvPr>
                <p:cNvSpPr txBox="1"/>
                <p:nvPr/>
              </p:nvSpPr>
              <p:spPr>
                <a:xfrm>
                  <a:off x="5164225" y="9220967"/>
                  <a:ext cx="384897" cy="1739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DC1</a:t>
                  </a:r>
                </a:p>
              </p:txBody>
            </p:sp>
          </p:grp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5FE443D3-83AF-4EB3-B872-1F73511CD9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86219" y="9250877"/>
                <a:ext cx="104455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5883AC76-F7E4-4213-A207-EC386BA627BE}"/>
                </a:ext>
              </a:extLst>
            </p:cNvPr>
            <p:cNvSpPr txBox="1"/>
            <p:nvPr/>
          </p:nvSpPr>
          <p:spPr>
            <a:xfrm>
              <a:off x="5488963" y="5044840"/>
              <a:ext cx="664295" cy="282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701E3BFC-06E6-43DF-93C8-0110E8A734F1}"/>
              </a:ext>
            </a:extLst>
          </p:cNvPr>
          <p:cNvGrpSpPr/>
          <p:nvPr/>
        </p:nvGrpSpPr>
        <p:grpSpPr>
          <a:xfrm>
            <a:off x="453241" y="362070"/>
            <a:ext cx="6670820" cy="4279205"/>
            <a:chOff x="-111122" y="450583"/>
            <a:chExt cx="6917355" cy="4369192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363236CE-A4F3-474C-88B9-A8E6CDD16481}"/>
                </a:ext>
              </a:extLst>
            </p:cNvPr>
            <p:cNvGrpSpPr/>
            <p:nvPr/>
          </p:nvGrpSpPr>
          <p:grpSpPr>
            <a:xfrm>
              <a:off x="-111122" y="450583"/>
              <a:ext cx="6917355" cy="4369192"/>
              <a:chOff x="184164" y="665451"/>
              <a:chExt cx="4689995" cy="3080825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3F721D01-B6BB-44AE-A834-752AF578F6EC}"/>
                  </a:ext>
                </a:extLst>
              </p:cNvPr>
              <p:cNvGrpSpPr/>
              <p:nvPr/>
            </p:nvGrpSpPr>
            <p:grpSpPr>
              <a:xfrm>
                <a:off x="2611466" y="665451"/>
                <a:ext cx="2217356" cy="2061003"/>
                <a:chOff x="7898350" y="2519352"/>
                <a:chExt cx="2217356" cy="2061003"/>
              </a:xfrm>
            </p:grpSpPr>
            <p:graphicFrame>
              <p:nvGraphicFramePr>
                <p:cNvPr id="31" name="Object 30">
                  <a:extLst>
                    <a:ext uri="{FF2B5EF4-FFF2-40B4-BE49-F238E27FC236}">
                      <a16:creationId xmlns:a16="http://schemas.microsoft.com/office/drawing/2014/main" id="{1378BE6E-0D70-44AA-838F-791338A891A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26989166"/>
                    </p:ext>
                  </p:extLst>
                </p:nvPr>
              </p:nvGraphicFramePr>
              <p:xfrm>
                <a:off x="8063864" y="2519352"/>
                <a:ext cx="2051842" cy="206100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4" imgW="3750004" imgH="3765558" progId="Prism9.Document">
                        <p:embed/>
                      </p:oleObj>
                    </mc:Choice>
                    <mc:Fallback>
                      <p:oleObj name="Prism 9" r:id="rId4" imgW="3750004" imgH="3765558" progId="Prism9.Document">
                        <p:embed/>
                        <p:pic>
                          <p:nvPicPr>
                            <p:cNvPr id="31" name="Object 30">
                              <a:extLst>
                                <a:ext uri="{FF2B5EF4-FFF2-40B4-BE49-F238E27FC236}">
                                  <a16:creationId xmlns:a16="http://schemas.microsoft.com/office/drawing/2014/main" id="{1378BE6E-0D70-44AA-838F-791338A891A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063864" y="2519352"/>
                              <a:ext cx="2051842" cy="206100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1E38CFA7-C099-4F1F-A07C-5E6527C52845}"/>
                    </a:ext>
                  </a:extLst>
                </p:cNvPr>
                <p:cNvSpPr txBox="1"/>
                <p:nvPr/>
              </p:nvSpPr>
              <p:spPr>
                <a:xfrm>
                  <a:off x="7898350" y="2747858"/>
                  <a:ext cx="450395" cy="1994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B91EA5F1-73C4-4731-9F01-155CAAA4F88A}"/>
                  </a:ext>
                </a:extLst>
              </p:cNvPr>
              <p:cNvGrpSpPr/>
              <p:nvPr/>
            </p:nvGrpSpPr>
            <p:grpSpPr>
              <a:xfrm>
                <a:off x="184164" y="900485"/>
                <a:ext cx="4689995" cy="2845791"/>
                <a:chOff x="5765197" y="3005288"/>
                <a:chExt cx="4689995" cy="2845791"/>
              </a:xfrm>
            </p:grpSpPr>
            <p:graphicFrame>
              <p:nvGraphicFramePr>
                <p:cNvPr id="34" name="Object 33">
                  <a:extLst>
                    <a:ext uri="{FF2B5EF4-FFF2-40B4-BE49-F238E27FC236}">
                      <a16:creationId xmlns:a16="http://schemas.microsoft.com/office/drawing/2014/main" id="{64AE82BE-B27E-46F0-AA14-DE06EF8DEBD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53344247"/>
                    </p:ext>
                  </p:extLst>
                </p:nvPr>
              </p:nvGraphicFramePr>
              <p:xfrm>
                <a:off x="6012096" y="3040303"/>
                <a:ext cx="4443096" cy="281077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6" imgW="7664867" imgH="4853362" progId="Prism9.Document">
                        <p:embed/>
                      </p:oleObj>
                    </mc:Choice>
                    <mc:Fallback>
                      <p:oleObj name="Prism 9" r:id="rId6" imgW="7664867" imgH="4853362" progId="Prism9.Document">
                        <p:embed/>
                        <p:pic>
                          <p:nvPicPr>
                            <p:cNvPr id="34" name="Object 33">
                              <a:extLst>
                                <a:ext uri="{FF2B5EF4-FFF2-40B4-BE49-F238E27FC236}">
                                  <a16:creationId xmlns:a16="http://schemas.microsoft.com/office/drawing/2014/main" id="{64AE82BE-B27E-46F0-AA14-DE06EF8DEBD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012096" y="3040303"/>
                              <a:ext cx="4443096" cy="281077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B6D785BB-BC6B-499A-ABD7-F649FC9649AF}"/>
                    </a:ext>
                  </a:extLst>
                </p:cNvPr>
                <p:cNvSpPr txBox="1"/>
                <p:nvPr/>
              </p:nvSpPr>
              <p:spPr>
                <a:xfrm>
                  <a:off x="5765197" y="3005288"/>
                  <a:ext cx="450395" cy="1994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</p:grpSp>
        </p:grp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EF0552C-59C5-44F1-A8BE-9F65A5801744}"/>
                </a:ext>
              </a:extLst>
            </p:cNvPr>
            <p:cNvSpPr txBox="1"/>
            <p:nvPr/>
          </p:nvSpPr>
          <p:spPr>
            <a:xfrm>
              <a:off x="-74880" y="3400052"/>
              <a:ext cx="462520" cy="282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9D8F9CA0-A443-492D-A07A-4B29301DC00E}"/>
              </a:ext>
            </a:extLst>
          </p:cNvPr>
          <p:cNvGrpSpPr/>
          <p:nvPr/>
        </p:nvGrpSpPr>
        <p:grpSpPr>
          <a:xfrm>
            <a:off x="357914" y="4902381"/>
            <a:ext cx="3868113" cy="2635031"/>
            <a:chOff x="-397934" y="5033465"/>
            <a:chExt cx="5760903" cy="3402375"/>
          </a:xfrm>
        </p:grpSpPr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411FB7FA-0078-4558-9153-E0938AA85F84}"/>
                </a:ext>
              </a:extLst>
            </p:cNvPr>
            <p:cNvGrpSpPr/>
            <p:nvPr/>
          </p:nvGrpSpPr>
          <p:grpSpPr>
            <a:xfrm>
              <a:off x="-397934" y="5033465"/>
              <a:ext cx="5760903" cy="3402375"/>
              <a:chOff x="505788" y="2246345"/>
              <a:chExt cx="5760903" cy="3402375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30F7D208-452D-4DE7-8EF6-BEFC42667D69}"/>
                  </a:ext>
                </a:extLst>
              </p:cNvPr>
              <p:cNvGrpSpPr/>
              <p:nvPr/>
            </p:nvGrpSpPr>
            <p:grpSpPr>
              <a:xfrm>
                <a:off x="505788" y="2246345"/>
                <a:ext cx="5760903" cy="3402375"/>
                <a:chOff x="552559" y="803056"/>
                <a:chExt cx="5760903" cy="3402375"/>
              </a:xfrm>
            </p:grpSpPr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431CC07C-BF55-4970-9B94-3CDABCD7CFF1}"/>
                    </a:ext>
                  </a:extLst>
                </p:cNvPr>
                <p:cNvGrpSpPr/>
                <p:nvPr/>
              </p:nvGrpSpPr>
              <p:grpSpPr>
                <a:xfrm>
                  <a:off x="4448137" y="1185456"/>
                  <a:ext cx="1865325" cy="3019975"/>
                  <a:chOff x="4789729" y="1289493"/>
                  <a:chExt cx="1842344" cy="2917836"/>
                </a:xfrm>
              </p:grpSpPr>
              <p:pic>
                <p:nvPicPr>
                  <p:cNvPr id="20" name="Picture 19">
                    <a:extLst>
                      <a:ext uri="{FF2B5EF4-FFF2-40B4-BE49-F238E27FC236}">
                        <a16:creationId xmlns:a16="http://schemas.microsoft.com/office/drawing/2014/main" id="{669EE29A-71E8-4A88-83B1-C408258FE02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4820974" y="1289493"/>
                    <a:ext cx="1567091" cy="1453557"/>
                  </a:xfrm>
                  <a:prstGeom prst="rect">
                    <a:avLst/>
                  </a:prstGeom>
                </p:spPr>
              </p:pic>
              <p:grpSp>
                <p:nvGrpSpPr>
                  <p:cNvPr id="22" name="Group 21">
                    <a:extLst>
                      <a:ext uri="{FF2B5EF4-FFF2-40B4-BE49-F238E27FC236}">
                        <a16:creationId xmlns:a16="http://schemas.microsoft.com/office/drawing/2014/main" id="{1C49A514-2522-4D4A-B225-2C097E47B83C}"/>
                      </a:ext>
                    </a:extLst>
                  </p:cNvPr>
                  <p:cNvGrpSpPr/>
                  <p:nvPr/>
                </p:nvGrpSpPr>
                <p:grpSpPr>
                  <a:xfrm>
                    <a:off x="4789729" y="2614346"/>
                    <a:ext cx="1842344" cy="1592983"/>
                    <a:chOff x="5022852" y="3603320"/>
                    <a:chExt cx="3516181" cy="3288173"/>
                  </a:xfrm>
                </p:grpSpPr>
                <p:pic>
                  <p:nvPicPr>
                    <p:cNvPr id="24" name="Picture 23">
                      <a:extLst>
                        <a:ext uri="{FF2B5EF4-FFF2-40B4-BE49-F238E27FC236}">
                          <a16:creationId xmlns:a16="http://schemas.microsoft.com/office/drawing/2014/main" id="{F858EDA4-64E8-4F87-B5A5-1CCC99AFB51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5022852" y="3603320"/>
                      <a:ext cx="3019425" cy="300037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79653ACB-12FF-4732-AB86-B1E356C31E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63799" y="6336699"/>
                      <a:ext cx="2775234" cy="55479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 (nm)</a:t>
                      </a:r>
                    </a:p>
                  </p:txBody>
                </p:sp>
              </p:grpSp>
            </p:grpSp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E2E4F610-BAF8-40BD-B2E4-F512A3F0F13F}"/>
                    </a:ext>
                  </a:extLst>
                </p:cNvPr>
                <p:cNvGrpSpPr/>
                <p:nvPr/>
              </p:nvGrpSpPr>
              <p:grpSpPr>
                <a:xfrm>
                  <a:off x="2986984" y="1185456"/>
                  <a:ext cx="1900033" cy="3019510"/>
                  <a:chOff x="769375" y="1139133"/>
                  <a:chExt cx="1861932" cy="3039224"/>
                </a:xfrm>
              </p:grpSpPr>
              <p:pic>
                <p:nvPicPr>
                  <p:cNvPr id="50" name="Picture 49">
                    <a:extLst>
                      <a:ext uri="{FF2B5EF4-FFF2-40B4-BE49-F238E27FC236}">
                        <a16:creationId xmlns:a16="http://schemas.microsoft.com/office/drawing/2014/main" id="{229DC077-2EE9-4FDD-A10C-7FE55DC7A36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774787" y="1139133"/>
                    <a:ext cx="1527780" cy="1525897"/>
                  </a:xfrm>
                  <a:prstGeom prst="rect">
                    <a:avLst/>
                  </a:prstGeom>
                </p:spPr>
              </p:pic>
              <p:grpSp>
                <p:nvGrpSpPr>
                  <p:cNvPr id="52" name="Group 51">
                    <a:extLst>
                      <a:ext uri="{FF2B5EF4-FFF2-40B4-BE49-F238E27FC236}">
                        <a16:creationId xmlns:a16="http://schemas.microsoft.com/office/drawing/2014/main" id="{F29E8E0C-B7DF-40FF-9458-92F4E32409D5}"/>
                      </a:ext>
                    </a:extLst>
                  </p:cNvPr>
                  <p:cNvGrpSpPr/>
                  <p:nvPr/>
                </p:nvGrpSpPr>
                <p:grpSpPr>
                  <a:xfrm>
                    <a:off x="769375" y="2509708"/>
                    <a:ext cx="1861932" cy="1668649"/>
                    <a:chOff x="2328091" y="2895010"/>
                    <a:chExt cx="3815278" cy="3434342"/>
                  </a:xfrm>
                </p:grpSpPr>
                <p:pic>
                  <p:nvPicPr>
                    <p:cNvPr id="54" name="Picture 53">
                      <a:extLst>
                        <a:ext uri="{FF2B5EF4-FFF2-40B4-BE49-F238E27FC236}">
                          <a16:creationId xmlns:a16="http://schemas.microsoft.com/office/drawing/2014/main" id="{67249431-95EE-4940-B3E2-56E43E7AF85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2328091" y="2895010"/>
                      <a:ext cx="3160477" cy="314053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86AD6788-5508-49EB-BA9A-A4B01AE8DB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6040" y="5753069"/>
                      <a:ext cx="3017329" cy="57628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 (nm)</a:t>
                      </a:r>
                    </a:p>
                  </p:txBody>
                </p:sp>
              </p:grpSp>
            </p:grpSp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193B5500-B755-4B1E-8E8D-CFD143EE6AF3}"/>
                    </a:ext>
                  </a:extLst>
                </p:cNvPr>
                <p:cNvGrpSpPr/>
                <p:nvPr/>
              </p:nvGrpSpPr>
              <p:grpSpPr>
                <a:xfrm>
                  <a:off x="552559" y="803056"/>
                  <a:ext cx="2758991" cy="3400599"/>
                  <a:chOff x="552559" y="803056"/>
                  <a:chExt cx="2758991" cy="3400599"/>
                </a:xfrm>
              </p:grpSpPr>
              <p:grpSp>
                <p:nvGrpSpPr>
                  <p:cNvPr id="92" name="Group 91">
                    <a:extLst>
                      <a:ext uri="{FF2B5EF4-FFF2-40B4-BE49-F238E27FC236}">
                        <a16:creationId xmlns:a16="http://schemas.microsoft.com/office/drawing/2014/main" id="{F1A29E37-B699-476A-BD98-03619506DF53}"/>
                      </a:ext>
                    </a:extLst>
                  </p:cNvPr>
                  <p:cNvGrpSpPr/>
                  <p:nvPr/>
                </p:nvGrpSpPr>
                <p:grpSpPr>
                  <a:xfrm>
                    <a:off x="552559" y="803056"/>
                    <a:ext cx="2758991" cy="3400599"/>
                    <a:chOff x="3254275" y="368238"/>
                    <a:chExt cx="2758991" cy="3400599"/>
                  </a:xfrm>
                </p:grpSpPr>
                <p:grpSp>
                  <p:nvGrpSpPr>
                    <p:cNvPr id="70" name="Group 69">
                      <a:extLst>
                        <a:ext uri="{FF2B5EF4-FFF2-40B4-BE49-F238E27FC236}">
                          <a16:creationId xmlns:a16="http://schemas.microsoft.com/office/drawing/2014/main" id="{8EF2D877-3318-47B4-8EF2-F3F622CC78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95126" y="368238"/>
                      <a:ext cx="2260345" cy="1883305"/>
                      <a:chOff x="-214030" y="737819"/>
                      <a:chExt cx="2119113" cy="1755887"/>
                    </a:xfrm>
                  </p:grpSpPr>
                  <p:grpSp>
                    <p:nvGrpSpPr>
                      <p:cNvPr id="71" name="Group 70">
                        <a:extLst>
                          <a:ext uri="{FF2B5EF4-FFF2-40B4-BE49-F238E27FC236}">
                            <a16:creationId xmlns:a16="http://schemas.microsoft.com/office/drawing/2014/main" id="{D992F96B-07D2-4AA1-8E00-3C1D65CAF79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14030" y="1094347"/>
                        <a:ext cx="2119113" cy="1399359"/>
                        <a:chOff x="-204504" y="1279082"/>
                        <a:chExt cx="2119113" cy="1399359"/>
                      </a:xfrm>
                    </p:grpSpPr>
                    <p:pic>
                      <p:nvPicPr>
                        <p:cNvPr id="74" name="Picture 73">
                          <a:extLst>
                            <a:ext uri="{FF2B5EF4-FFF2-40B4-BE49-F238E27FC236}">
                              <a16:creationId xmlns:a16="http://schemas.microsoft.com/office/drawing/2014/main" id="{FF30178B-145C-44CE-81B4-127239CFEDA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06365" y="1279082"/>
                          <a:ext cx="1408244" cy="139935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75" name="TextBox 74">
                          <a:extLst>
                            <a:ext uri="{FF2B5EF4-FFF2-40B4-BE49-F238E27FC236}">
                              <a16:creationId xmlns:a16="http://schemas.microsoft.com/office/drawing/2014/main" id="{7CDBBCC1-2D9B-413D-8E26-2E6792F1AB7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204504" y="1793920"/>
                          <a:ext cx="534988" cy="27788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EV</a:t>
                          </a:r>
                          <a:endPara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73" name="TextBox 72">
                        <a:extLst>
                          <a:ext uri="{FF2B5EF4-FFF2-40B4-BE49-F238E27FC236}">
                            <a16:creationId xmlns:a16="http://schemas.microsoft.com/office/drawing/2014/main" id="{DD6B2B15-0914-44C5-B529-AD06CAF837E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345781" y="1370531"/>
                        <a:ext cx="1566243" cy="300819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ticles/mL (10</a:t>
                        </a:r>
                        <a:r>
                          <a:rPr lang="en-US" sz="8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r>
                          <a:rPr lang="en-US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</p:grpSp>
                <p:grpSp>
                  <p:nvGrpSpPr>
                    <p:cNvPr id="69" name="Group 68">
                      <a:extLst>
                        <a:ext uri="{FF2B5EF4-FFF2-40B4-BE49-F238E27FC236}">
                          <a16:creationId xmlns:a16="http://schemas.microsoft.com/office/drawing/2014/main" id="{B9FBC2A4-810D-45A1-B963-926FD5FCB37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254275" y="2123317"/>
                      <a:ext cx="2501196" cy="1500905"/>
                      <a:chOff x="1309152" y="2149303"/>
                      <a:chExt cx="2344915" cy="1399359"/>
                    </a:xfrm>
                  </p:grpSpPr>
                  <p:pic>
                    <p:nvPicPr>
                      <p:cNvPr id="76" name="Picture 75">
                        <a:extLst>
                          <a:ext uri="{FF2B5EF4-FFF2-40B4-BE49-F238E27FC236}">
                            <a16:creationId xmlns:a16="http://schemas.microsoft.com/office/drawing/2014/main" id="{1EBB1CF5-76B1-467F-9E4E-65940F81BFB1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245823" y="2149303"/>
                        <a:ext cx="1408244" cy="139935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77" name="TextBox 76">
                        <a:extLst>
                          <a:ext uri="{FF2B5EF4-FFF2-40B4-BE49-F238E27FC236}">
                            <a16:creationId xmlns:a16="http://schemas.microsoft.com/office/drawing/2014/main" id="{465DAE5D-5E8B-4DA3-8618-C6AC2182613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09152" y="2714452"/>
                        <a:ext cx="894480" cy="27788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R-</a:t>
                        </a:r>
                        <a:r>
                          <a:rPr lang="en-US" sz="9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EV</a:t>
                        </a:r>
                        <a:endPara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9B242D9A-29FA-4BA9-97EE-E4C17A77CC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38956" y="3490654"/>
                      <a:ext cx="1474310" cy="27818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 (nm)</a:t>
                      </a:r>
                    </a:p>
                  </p:txBody>
                </p: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98DB220B-D9AA-49B4-AF29-5D34995558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74175" y="559574"/>
                      <a:ext cx="694264" cy="3278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p:txBody>
                </p:sp>
              </p:grp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B5C4C6BF-5004-4086-BB8A-EB16D25810E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779370" y="2962654"/>
                    <a:ext cx="1515998" cy="320868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ticles/mL (10</a:t>
                    </a:r>
                    <a:r>
                      <a:rPr lang="en-US" sz="8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</p:grp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6F8A3A92-7370-47C5-83C9-CCAC3D01421C}"/>
                  </a:ext>
                </a:extLst>
              </p:cNvPr>
              <p:cNvSpPr txBox="1"/>
              <p:nvPr/>
            </p:nvSpPr>
            <p:spPr>
              <a:xfrm>
                <a:off x="3329780" y="2423297"/>
                <a:ext cx="1370560" cy="3278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DC1 </a:t>
                </a:r>
                <a:r>
                  <a:rPr lang="en-US" sz="105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3150500E-355F-4CD1-BFB5-68CD109698C3}"/>
                  </a:ext>
                </a:extLst>
              </p:cNvPr>
              <p:cNvSpPr txBox="1"/>
              <p:nvPr/>
            </p:nvSpPr>
            <p:spPr>
              <a:xfrm>
                <a:off x="4733536" y="2427397"/>
                <a:ext cx="1472255" cy="3278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 </a:t>
                </a:r>
                <a:r>
                  <a:rPr lang="en-US" sz="105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PDZ1i</a:t>
                </a:r>
              </a:p>
            </p:txBody>
          </p:sp>
        </p:grp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DF8E4342-7B0B-4731-9CD7-F27B7CC1C239}"/>
                </a:ext>
              </a:extLst>
            </p:cNvPr>
            <p:cNvSpPr txBox="1"/>
            <p:nvPr/>
          </p:nvSpPr>
          <p:spPr>
            <a:xfrm>
              <a:off x="-211729" y="5081785"/>
              <a:ext cx="664296" cy="357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E66D87D-3DDE-4AFF-AE5A-8C7A28817D92}"/>
              </a:ext>
            </a:extLst>
          </p:cNvPr>
          <p:cNvGrpSpPr/>
          <p:nvPr/>
        </p:nvGrpSpPr>
        <p:grpSpPr>
          <a:xfrm>
            <a:off x="2543830" y="7692471"/>
            <a:ext cx="2002507" cy="2512937"/>
            <a:chOff x="1915144" y="7812936"/>
            <a:chExt cx="2045107" cy="2221971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31ED184D-61A4-46E5-BEA5-AC82934F04C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3396204"/>
                </p:ext>
              </p:extLst>
            </p:nvPr>
          </p:nvGraphicFramePr>
          <p:xfrm>
            <a:off x="2220180" y="7941706"/>
            <a:ext cx="1740071" cy="20932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2808363" imgH="3378240" progId="Prism9.Document">
                    <p:embed/>
                  </p:oleObj>
                </mc:Choice>
                <mc:Fallback>
                  <p:oleObj name="Prism 9" r:id="rId14" imgW="2808363" imgH="3378240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31ED184D-61A4-46E5-BEA5-AC82934F04C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220180" y="7941706"/>
                          <a:ext cx="1740071" cy="20932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368392E-D903-4047-BB6B-A2F130241E20}"/>
                </a:ext>
              </a:extLst>
            </p:cNvPr>
            <p:cNvSpPr txBox="1"/>
            <p:nvPr/>
          </p:nvSpPr>
          <p:spPr>
            <a:xfrm>
              <a:off x="1915144" y="7812936"/>
              <a:ext cx="537028" cy="2449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16A5E61C-B435-451C-8FBD-BE004A743940}"/>
              </a:ext>
            </a:extLst>
          </p:cNvPr>
          <p:cNvGrpSpPr/>
          <p:nvPr/>
        </p:nvGrpSpPr>
        <p:grpSpPr>
          <a:xfrm>
            <a:off x="4447021" y="4911665"/>
            <a:ext cx="2655358" cy="2767374"/>
            <a:chOff x="4447021" y="4911665"/>
            <a:chExt cx="2655358" cy="276737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32C35E6-4030-45B9-98B4-31FB22FF2862}"/>
                </a:ext>
              </a:extLst>
            </p:cNvPr>
            <p:cNvGrpSpPr/>
            <p:nvPr/>
          </p:nvGrpSpPr>
          <p:grpSpPr>
            <a:xfrm>
              <a:off x="4456556" y="4911665"/>
              <a:ext cx="2645823" cy="2767374"/>
              <a:chOff x="3878511" y="5033443"/>
              <a:chExt cx="2743605" cy="2825569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22D0B6D0-BC28-4185-A222-43E59294D132}"/>
                  </a:ext>
                </a:extLst>
              </p:cNvPr>
              <p:cNvGrpSpPr/>
              <p:nvPr/>
            </p:nvGrpSpPr>
            <p:grpSpPr>
              <a:xfrm>
                <a:off x="4278873" y="5144783"/>
                <a:ext cx="2343243" cy="2714229"/>
                <a:chOff x="4278873" y="4916181"/>
                <a:chExt cx="2343243" cy="2714229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52FE73A8-E661-47B9-A5B8-D8387D44AD17}"/>
                    </a:ext>
                  </a:extLst>
                </p:cNvPr>
                <p:cNvGrpSpPr/>
                <p:nvPr/>
              </p:nvGrpSpPr>
              <p:grpSpPr>
                <a:xfrm>
                  <a:off x="4278873" y="4916181"/>
                  <a:ext cx="2343243" cy="2535647"/>
                  <a:chOff x="4278873" y="4823545"/>
                  <a:chExt cx="2343243" cy="2535647"/>
                </a:xfrm>
              </p:grpSpPr>
              <p:grpSp>
                <p:nvGrpSpPr>
                  <p:cNvPr id="2" name="Group 1">
                    <a:extLst>
                      <a:ext uri="{FF2B5EF4-FFF2-40B4-BE49-F238E27FC236}">
                        <a16:creationId xmlns:a16="http://schemas.microsoft.com/office/drawing/2014/main" id="{F789B3AC-A8FB-4CAB-BBEC-189C81A17406}"/>
                      </a:ext>
                    </a:extLst>
                  </p:cNvPr>
                  <p:cNvGrpSpPr/>
                  <p:nvPr/>
                </p:nvGrpSpPr>
                <p:grpSpPr>
                  <a:xfrm>
                    <a:off x="4278873" y="4998871"/>
                    <a:ext cx="2250731" cy="2360321"/>
                    <a:chOff x="5863535" y="361622"/>
                    <a:chExt cx="5891419" cy="5756057"/>
                  </a:xfrm>
                </p:grpSpPr>
                <p:pic>
                  <p:nvPicPr>
                    <p:cNvPr id="51" name="Picture 50">
                      <a:extLst>
                        <a:ext uri="{FF2B5EF4-FFF2-40B4-BE49-F238E27FC236}">
                          <a16:creationId xmlns:a16="http://schemas.microsoft.com/office/drawing/2014/main" id="{06FEFF82-E8BC-4D5B-BF76-9F4771E6BEF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8706954" y="361622"/>
                      <a:ext cx="3048000" cy="292598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3" name="Picture 52">
                      <a:extLst>
                        <a:ext uri="{FF2B5EF4-FFF2-40B4-BE49-F238E27FC236}">
                          <a16:creationId xmlns:a16="http://schemas.microsoft.com/office/drawing/2014/main" id="{7E1047BA-D109-40E4-ABBD-05795454E41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8692982" y="3107434"/>
                      <a:ext cx="3048000" cy="300037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6" name="Picture 55">
                      <a:extLst>
                        <a:ext uri="{FF2B5EF4-FFF2-40B4-BE49-F238E27FC236}">
                          <a16:creationId xmlns:a16="http://schemas.microsoft.com/office/drawing/2014/main" id="{D5CC0778-3032-45C2-83C6-BFDD84EF45E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5863535" y="361623"/>
                      <a:ext cx="3048000" cy="300037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7" name="Picture 56">
                      <a:extLst>
                        <a:ext uri="{FF2B5EF4-FFF2-40B4-BE49-F238E27FC236}">
                          <a16:creationId xmlns:a16="http://schemas.microsoft.com/office/drawing/2014/main" id="{11688CC7-023A-4940-9766-D8C31A5E552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5919718" y="3117305"/>
                      <a:ext cx="3048000" cy="3000374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57682945-6C8F-4F44-BAA0-93787B3009A4}"/>
                      </a:ext>
                    </a:extLst>
                  </p:cNvPr>
                  <p:cNvSpPr txBox="1"/>
                  <p:nvPr/>
                </p:nvSpPr>
                <p:spPr>
                  <a:xfrm>
                    <a:off x="4619674" y="4823545"/>
                    <a:ext cx="954262" cy="2592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DC1 </a:t>
                    </a:r>
                    <a:r>
                      <a:rPr lang="en-US" sz="105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</a:t>
                    </a:r>
                    <a:endPara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8624E5E8-FC23-4805-849D-C67DAC9E72B7}"/>
                      </a:ext>
                    </a:extLst>
                  </p:cNvPr>
                  <p:cNvSpPr txBox="1"/>
                  <p:nvPr/>
                </p:nvSpPr>
                <p:spPr>
                  <a:xfrm>
                    <a:off x="5597049" y="4826786"/>
                    <a:ext cx="1025067" cy="2592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</a:t>
                    </a:r>
                    <a:r>
                      <a:rPr lang="en-US" sz="105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PDZ1i</a:t>
                    </a:r>
                  </a:p>
                </p:txBody>
              </p:sp>
            </p:grp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9B5C0EE7-AC62-420E-9723-6C2C02985205}"/>
                    </a:ext>
                  </a:extLst>
                </p:cNvPr>
                <p:cNvSpPr txBox="1"/>
                <p:nvPr/>
              </p:nvSpPr>
              <p:spPr>
                <a:xfrm>
                  <a:off x="4541119" y="7410435"/>
                  <a:ext cx="2012633" cy="21997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1</a:t>
                  </a:r>
                </a:p>
              </p:txBody>
            </p:sp>
            <p:cxnSp>
              <p:nvCxnSpPr>
                <p:cNvPr id="61" name="Straight Arrow Connector 60">
                  <a:extLst>
                    <a:ext uri="{FF2B5EF4-FFF2-40B4-BE49-F238E27FC236}">
                      <a16:creationId xmlns:a16="http://schemas.microsoft.com/office/drawing/2014/main" id="{72AE7A32-1EF6-4383-BEEA-7E854F2BE7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541119" y="7398256"/>
                  <a:ext cx="1983147" cy="455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44FE6369-E2F5-4641-9E1F-B5287EBD5966}"/>
                  </a:ext>
                </a:extLst>
              </p:cNvPr>
              <p:cNvSpPr txBox="1"/>
              <p:nvPr/>
            </p:nvSpPr>
            <p:spPr>
              <a:xfrm>
                <a:off x="3878511" y="5033443"/>
                <a:ext cx="664297" cy="2828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04B6E11-BCE3-4023-9B54-3AD0258810AD}"/>
                </a:ext>
              </a:extLst>
            </p:cNvPr>
            <p:cNvSpPr txBox="1"/>
            <p:nvPr/>
          </p:nvSpPr>
          <p:spPr>
            <a:xfrm>
              <a:off x="4533356" y="5540611"/>
              <a:ext cx="369104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EV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20D05D0B-AA4A-4DA8-AD7E-D1D861A93D75}"/>
                </a:ext>
              </a:extLst>
            </p:cNvPr>
            <p:cNvSpPr txBox="1"/>
            <p:nvPr/>
          </p:nvSpPr>
          <p:spPr>
            <a:xfrm>
              <a:off x="4447021" y="6557027"/>
              <a:ext cx="463811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R-tEV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E103340-FBEE-4A74-98EC-1D0F104EB7F9}"/>
                </a:ext>
              </a:extLst>
            </p:cNvPr>
            <p:cNvSpPr txBox="1"/>
            <p:nvPr/>
          </p:nvSpPr>
          <p:spPr>
            <a:xfrm rot="16200000">
              <a:off x="4614926" y="6086384"/>
              <a:ext cx="532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  <a:p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9E575490-FE8F-4EBE-9CEA-8B5336DA04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902460" y="5310479"/>
              <a:ext cx="16744" cy="185801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312623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9FE4497-7521-4E26-AD67-FD860FD430C4}"/>
              </a:ext>
            </a:extLst>
          </p:cNvPr>
          <p:cNvGrpSpPr/>
          <p:nvPr/>
        </p:nvGrpSpPr>
        <p:grpSpPr>
          <a:xfrm>
            <a:off x="3376987" y="292473"/>
            <a:ext cx="3323332" cy="2646666"/>
            <a:chOff x="2565414" y="6650835"/>
            <a:chExt cx="1530677" cy="1343793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F0D47EE2-ACCC-4BE7-8EEF-F926A00672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83678338"/>
                </p:ext>
              </p:extLst>
            </p:nvPr>
          </p:nvGraphicFramePr>
          <p:xfrm>
            <a:off x="2666857" y="6834735"/>
            <a:ext cx="1429234" cy="11598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666134" imgH="2730669" progId="Prism9.Document">
                    <p:embed/>
                  </p:oleObj>
                </mc:Choice>
                <mc:Fallback>
                  <p:oleObj name="Prism 9" r:id="rId3" imgW="3666134" imgH="2730669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F0D47EE2-ACCC-4BE7-8EEF-F926A00672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666857" y="6834735"/>
                          <a:ext cx="1429234" cy="11598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AD7FF0A-240A-4A0C-BFE2-1468361FC635}"/>
                </a:ext>
              </a:extLst>
            </p:cNvPr>
            <p:cNvSpPr txBox="1"/>
            <p:nvPr/>
          </p:nvSpPr>
          <p:spPr>
            <a:xfrm>
              <a:off x="2565414" y="6650835"/>
              <a:ext cx="314478" cy="1562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6EE3DCCF-F479-4F0F-81D4-A9AC6407221A}"/>
              </a:ext>
            </a:extLst>
          </p:cNvPr>
          <p:cNvGrpSpPr/>
          <p:nvPr/>
        </p:nvGrpSpPr>
        <p:grpSpPr>
          <a:xfrm>
            <a:off x="3416731" y="2854112"/>
            <a:ext cx="2885917" cy="1991954"/>
            <a:chOff x="3789661" y="2668251"/>
            <a:chExt cx="3245209" cy="211838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8D25E4D4-8732-4CE8-9725-5BF7CCD1E835}"/>
                </a:ext>
              </a:extLst>
            </p:cNvPr>
            <p:cNvGrpSpPr/>
            <p:nvPr/>
          </p:nvGrpSpPr>
          <p:grpSpPr>
            <a:xfrm>
              <a:off x="4150620" y="3095118"/>
              <a:ext cx="2884250" cy="1691520"/>
              <a:chOff x="465167" y="7801464"/>
              <a:chExt cx="2680229" cy="1489247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73D27454-F09D-4B1B-AEAE-28B1DF34071D}"/>
                  </a:ext>
                </a:extLst>
              </p:cNvPr>
              <p:cNvGrpSpPr/>
              <p:nvPr/>
            </p:nvGrpSpPr>
            <p:grpSpPr>
              <a:xfrm>
                <a:off x="553184" y="7990382"/>
                <a:ext cx="2429132" cy="1156025"/>
                <a:chOff x="783401" y="5958459"/>
                <a:chExt cx="2545611" cy="1395276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45554F9B-BBBB-4A8F-80A5-0D802ACBD1B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023818" y="5969770"/>
                  <a:ext cx="1305194" cy="1383965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85318A4F-B842-4B85-9C6C-208F4AD1FA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783401" y="5958459"/>
                  <a:ext cx="1317664" cy="1383965"/>
                </a:xfrm>
                <a:prstGeom prst="rect">
                  <a:avLst/>
                </a:prstGeom>
              </p:spPr>
            </p:pic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C6E9B067-D619-4E2B-9749-80A26C42BEB0}"/>
                  </a:ext>
                </a:extLst>
              </p:cNvPr>
              <p:cNvGrpSpPr/>
              <p:nvPr/>
            </p:nvGrpSpPr>
            <p:grpSpPr>
              <a:xfrm>
                <a:off x="465167" y="7801464"/>
                <a:ext cx="2680229" cy="1489247"/>
                <a:chOff x="662758" y="3256502"/>
                <a:chExt cx="6363288" cy="3789066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B28069FE-DD85-477C-BDC3-C7E91DAE1690}"/>
                    </a:ext>
                  </a:extLst>
                </p:cNvPr>
                <p:cNvGrpSpPr/>
                <p:nvPr/>
              </p:nvGrpSpPr>
              <p:grpSpPr>
                <a:xfrm>
                  <a:off x="662758" y="3256502"/>
                  <a:ext cx="5601798" cy="3143791"/>
                  <a:chOff x="796833" y="3472304"/>
                  <a:chExt cx="5601798" cy="3143791"/>
                </a:xfrm>
              </p:grpSpPr>
              <p:grpSp>
                <p:nvGrpSpPr>
                  <p:cNvPr id="11" name="Group 10">
                    <a:extLst>
                      <a:ext uri="{FF2B5EF4-FFF2-40B4-BE49-F238E27FC236}">
                        <a16:creationId xmlns:a16="http://schemas.microsoft.com/office/drawing/2014/main" id="{192724A3-F6FC-4972-81FA-7DA088F1158F}"/>
                      </a:ext>
                    </a:extLst>
                  </p:cNvPr>
                  <p:cNvGrpSpPr/>
                  <p:nvPr/>
                </p:nvGrpSpPr>
                <p:grpSpPr>
                  <a:xfrm>
                    <a:off x="2324286" y="3558111"/>
                    <a:ext cx="4074345" cy="607221"/>
                    <a:chOff x="2324286" y="3558111"/>
                    <a:chExt cx="4074345" cy="607221"/>
                  </a:xfrm>
                </p:grpSpPr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2BA39E67-DC51-4FAD-9E7E-754F91ABC1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97783" y="3578781"/>
                      <a:ext cx="1400848" cy="58655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-</a:t>
                      </a:r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V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B480F2EE-06CC-4B1A-81BC-0A63A1A7AE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24286" y="3558111"/>
                      <a:ext cx="1050925" cy="58655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V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2709B903-F6EE-4F47-8CDD-C22AECD1CC32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469639" y="4738776"/>
                    <a:ext cx="3143791" cy="61084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ticles/mL (10</a:t>
                    </a:r>
                    <a:r>
                      <a:rPr lang="en-US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3BA97E3C-D434-4852-9FB7-912C06469FB4}"/>
                    </a:ext>
                  </a:extLst>
                </p:cNvPr>
                <p:cNvSpPr txBox="1"/>
                <p:nvPr/>
              </p:nvSpPr>
              <p:spPr>
                <a:xfrm>
                  <a:off x="4312304" y="6459016"/>
                  <a:ext cx="2713742" cy="58655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41A73DF9-9E57-4429-AB18-46F433F353C5}"/>
                    </a:ext>
                  </a:extLst>
                </p:cNvPr>
                <p:cNvSpPr txBox="1"/>
                <p:nvPr/>
              </p:nvSpPr>
              <p:spPr>
                <a:xfrm>
                  <a:off x="1461701" y="6431321"/>
                  <a:ext cx="2713744" cy="58655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</p:grp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E50CA00-9818-4AC6-AB9F-6CA6D90EF295}"/>
                </a:ext>
              </a:extLst>
            </p:cNvPr>
            <p:cNvSpPr txBox="1"/>
            <p:nvPr/>
          </p:nvSpPr>
          <p:spPr>
            <a:xfrm>
              <a:off x="3789661" y="2668251"/>
              <a:ext cx="456663" cy="5564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C602910D-3AA0-4FC1-A4D9-1CE1616AD619}"/>
              </a:ext>
            </a:extLst>
          </p:cNvPr>
          <p:cNvGrpSpPr/>
          <p:nvPr/>
        </p:nvGrpSpPr>
        <p:grpSpPr>
          <a:xfrm>
            <a:off x="130932" y="281299"/>
            <a:ext cx="3307229" cy="4307633"/>
            <a:chOff x="97365" y="6801"/>
            <a:chExt cx="3718975" cy="4581045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0DC6328A-E64A-438F-9DED-ABF37276D54D}"/>
                </a:ext>
              </a:extLst>
            </p:cNvPr>
            <p:cNvGrpSpPr/>
            <p:nvPr/>
          </p:nvGrpSpPr>
          <p:grpSpPr>
            <a:xfrm>
              <a:off x="128220" y="6801"/>
              <a:ext cx="3688120" cy="4581045"/>
              <a:chOff x="128220" y="6801"/>
              <a:chExt cx="3688120" cy="4581045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09086AD-8578-476E-8CBA-A418979079A0}"/>
                  </a:ext>
                </a:extLst>
              </p:cNvPr>
              <p:cNvSpPr txBox="1"/>
              <p:nvPr/>
            </p:nvSpPr>
            <p:spPr>
              <a:xfrm>
                <a:off x="128220" y="6801"/>
                <a:ext cx="837186" cy="3273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aphicFrame>
            <p:nvGraphicFramePr>
              <p:cNvPr id="29" name="Object 28">
                <a:extLst>
                  <a:ext uri="{FF2B5EF4-FFF2-40B4-BE49-F238E27FC236}">
                    <a16:creationId xmlns:a16="http://schemas.microsoft.com/office/drawing/2014/main" id="{F3E24123-F890-4CA1-B108-5483B051B7A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82405713"/>
                  </p:ext>
                </p:extLst>
              </p:nvPr>
            </p:nvGraphicFramePr>
            <p:xfrm>
              <a:off x="514340" y="193646"/>
              <a:ext cx="3302000" cy="4394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3302221" imgH="4394771" progId="Prism9.Document">
                      <p:embed/>
                    </p:oleObj>
                  </mc:Choice>
                  <mc:Fallback>
                    <p:oleObj name="Prism 9" r:id="rId7" imgW="3302221" imgH="4394771" progId="Prism9.Document">
                      <p:embed/>
                      <p:pic>
                        <p:nvPicPr>
                          <p:cNvPr id="29" name="Object 28">
                            <a:extLst>
                              <a:ext uri="{FF2B5EF4-FFF2-40B4-BE49-F238E27FC236}">
                                <a16:creationId xmlns:a16="http://schemas.microsoft.com/office/drawing/2014/main" id="{F3E24123-F890-4CA1-B108-5483B051B7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14340" y="193646"/>
                            <a:ext cx="3302000" cy="43942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03FFD24-4EE1-4676-B35B-7D724CBE4DA0}"/>
                </a:ext>
              </a:extLst>
            </p:cNvPr>
            <p:cNvSpPr txBox="1"/>
            <p:nvPr/>
          </p:nvSpPr>
          <p:spPr>
            <a:xfrm>
              <a:off x="97365" y="2842063"/>
              <a:ext cx="767784" cy="327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1C0E8D3B-2DD7-4167-9D6C-AE7C69B208E3}"/>
              </a:ext>
            </a:extLst>
          </p:cNvPr>
          <p:cNvGrpSpPr/>
          <p:nvPr/>
        </p:nvGrpSpPr>
        <p:grpSpPr>
          <a:xfrm>
            <a:off x="3227999" y="6771746"/>
            <a:ext cx="2304439" cy="2248427"/>
            <a:chOff x="4379020" y="7714359"/>
            <a:chExt cx="2389604" cy="2295711"/>
          </a:xfrm>
        </p:grpSpPr>
        <p:graphicFrame>
          <p:nvGraphicFramePr>
            <p:cNvPr id="40" name="Object 39">
              <a:extLst>
                <a:ext uri="{FF2B5EF4-FFF2-40B4-BE49-F238E27FC236}">
                  <a16:creationId xmlns:a16="http://schemas.microsoft.com/office/drawing/2014/main" id="{50FEC2B0-2898-45C8-924E-86460F54EA8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5213119"/>
                </p:ext>
              </p:extLst>
            </p:nvPr>
          </p:nvGraphicFramePr>
          <p:xfrm>
            <a:off x="4510080" y="7808909"/>
            <a:ext cx="2258544" cy="2201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3722647" imgH="3625173" progId="Prism9.Document">
                    <p:embed/>
                  </p:oleObj>
                </mc:Choice>
                <mc:Fallback>
                  <p:oleObj name="Prism 9" r:id="rId9" imgW="3722647" imgH="3625173" progId="Prism9.Document">
                    <p:embed/>
                    <p:pic>
                      <p:nvPicPr>
                        <p:cNvPr id="40" name="Object 39">
                          <a:extLst>
                            <a:ext uri="{FF2B5EF4-FFF2-40B4-BE49-F238E27FC236}">
                              <a16:creationId xmlns:a16="http://schemas.microsoft.com/office/drawing/2014/main" id="{50FEC2B0-2898-45C8-924E-86460F54EA8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510080" y="7808909"/>
                          <a:ext cx="2258544" cy="2201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B688392-234D-41C1-A509-6A8927FD610A}"/>
                </a:ext>
              </a:extLst>
            </p:cNvPr>
            <p:cNvSpPr txBox="1"/>
            <p:nvPr/>
          </p:nvSpPr>
          <p:spPr>
            <a:xfrm>
              <a:off x="4379020" y="7714359"/>
              <a:ext cx="435858" cy="53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G)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5499A44-C95B-4835-8921-D857055B3544}"/>
              </a:ext>
            </a:extLst>
          </p:cNvPr>
          <p:cNvGrpSpPr/>
          <p:nvPr/>
        </p:nvGrpSpPr>
        <p:grpSpPr>
          <a:xfrm>
            <a:off x="159711" y="6647025"/>
            <a:ext cx="2484877" cy="2459087"/>
            <a:chOff x="3338331" y="6597971"/>
            <a:chExt cx="2484877" cy="2459087"/>
          </a:xfrm>
        </p:grpSpPr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12E24960-D729-4CE4-B441-C2E9DCC7C0C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71882286"/>
                </p:ext>
              </p:extLst>
            </p:nvPr>
          </p:nvGraphicFramePr>
          <p:xfrm>
            <a:off x="3547533" y="6641580"/>
            <a:ext cx="2275675" cy="24154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3721207" imgH="3949859" progId="Prism9.Document">
                    <p:embed/>
                  </p:oleObj>
                </mc:Choice>
                <mc:Fallback>
                  <p:oleObj name="Prism 9" r:id="rId11" imgW="3721207" imgH="3949859" progId="Prism9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12E24960-D729-4CE4-B441-C2E9DCC7C0C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547533" y="6641580"/>
                          <a:ext cx="2275675" cy="24154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B00EBE6-A985-4FDC-BA2B-1542F5824EDE}"/>
                </a:ext>
              </a:extLst>
            </p:cNvPr>
            <p:cNvSpPr txBox="1"/>
            <p:nvPr/>
          </p:nvSpPr>
          <p:spPr>
            <a:xfrm>
              <a:off x="3338331" y="6597971"/>
              <a:ext cx="6406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0E095463-6A4D-4CF4-B124-3948F2611838}"/>
              </a:ext>
            </a:extLst>
          </p:cNvPr>
          <p:cNvGrpSpPr/>
          <p:nvPr/>
        </p:nvGrpSpPr>
        <p:grpSpPr>
          <a:xfrm>
            <a:off x="122171" y="4711329"/>
            <a:ext cx="2769158" cy="1845802"/>
            <a:chOff x="118668" y="4686491"/>
            <a:chExt cx="2769158" cy="184580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BECBCB46-BF61-4D6E-9B57-A94DB5753FC0}"/>
                </a:ext>
              </a:extLst>
            </p:cNvPr>
            <p:cNvGrpSpPr/>
            <p:nvPr/>
          </p:nvGrpSpPr>
          <p:grpSpPr>
            <a:xfrm>
              <a:off x="118668" y="4686491"/>
              <a:ext cx="2769158" cy="1845802"/>
              <a:chOff x="277702" y="4877314"/>
              <a:chExt cx="3113914" cy="1962956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EB83C89F-B8A3-443A-B2E9-CDA17C2FB130}"/>
                  </a:ext>
                </a:extLst>
              </p:cNvPr>
              <p:cNvGrpSpPr/>
              <p:nvPr/>
            </p:nvGrpSpPr>
            <p:grpSpPr>
              <a:xfrm>
                <a:off x="788829" y="5169196"/>
                <a:ext cx="2602787" cy="1671074"/>
                <a:chOff x="788829" y="5169196"/>
                <a:chExt cx="2602787" cy="1671074"/>
              </a:xfrm>
            </p:grpSpPr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12543125-B60C-4643-A511-43F829248454}"/>
                    </a:ext>
                  </a:extLst>
                </p:cNvPr>
                <p:cNvGrpSpPr/>
                <p:nvPr/>
              </p:nvGrpSpPr>
              <p:grpSpPr>
                <a:xfrm>
                  <a:off x="788829" y="5362780"/>
                  <a:ext cx="2602787" cy="1477490"/>
                  <a:chOff x="4197044" y="4157435"/>
                  <a:chExt cx="2602787" cy="1477490"/>
                </a:xfrm>
              </p:grpSpPr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15C6C095-3590-4FC8-BB64-7F5B4D7C777C}"/>
                      </a:ext>
                    </a:extLst>
                  </p:cNvPr>
                  <p:cNvGrpSpPr/>
                  <p:nvPr/>
                </p:nvGrpSpPr>
                <p:grpSpPr>
                  <a:xfrm>
                    <a:off x="4197044" y="4157435"/>
                    <a:ext cx="2602787" cy="1477490"/>
                    <a:chOff x="4097309" y="4159792"/>
                    <a:chExt cx="2602787" cy="1477490"/>
                  </a:xfrm>
                </p:grpSpPr>
                <p:pic>
                  <p:nvPicPr>
                    <p:cNvPr id="18" name="Picture 17">
                      <a:extLst>
                        <a:ext uri="{FF2B5EF4-FFF2-40B4-BE49-F238E27FC236}">
                          <a16:creationId xmlns:a16="http://schemas.microsoft.com/office/drawing/2014/main" id="{203A9912-8A09-4AC6-B288-AA09279D266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/>
                    <a:stretch>
                      <a:fillRect/>
                    </a:stretch>
                  </p:blipFill>
                  <p:spPr>
                    <a:xfrm>
                      <a:off x="5359818" y="4159792"/>
                      <a:ext cx="1340278" cy="131933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7" name="Picture 16">
                      <a:extLst>
                        <a:ext uri="{FF2B5EF4-FFF2-40B4-BE49-F238E27FC236}">
                          <a16:creationId xmlns:a16="http://schemas.microsoft.com/office/drawing/2014/main" id="{73120626-5D73-470C-BC4C-2780D52825D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/>
                    <a:stretch>
                      <a:fillRect/>
                    </a:stretch>
                  </p:blipFill>
                  <p:spPr>
                    <a:xfrm>
                      <a:off x="4097309" y="4159792"/>
                      <a:ext cx="1340278" cy="131933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DA8C3449-ABE6-4778-B4E7-228A556AE6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34046" y="5408164"/>
                      <a:ext cx="1666755" cy="22911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</a:t>
                      </a:r>
                    </a:p>
                  </p:txBody>
                </p:sp>
              </p:grpSp>
              <p:cxnSp>
                <p:nvCxnSpPr>
                  <p:cNvPr id="20" name="Straight Arrow Connector 19">
                    <a:extLst>
                      <a:ext uri="{FF2B5EF4-FFF2-40B4-BE49-F238E27FC236}">
                        <a16:creationId xmlns:a16="http://schemas.microsoft.com/office/drawing/2014/main" id="{A30D5DB3-7CC1-45F6-BEB2-997C12E93C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67749" y="5423417"/>
                    <a:ext cx="2225675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FE22408A-EC59-4492-92C3-9DFC9B0061C9}"/>
                    </a:ext>
                  </a:extLst>
                </p:cNvPr>
                <p:cNvSpPr txBox="1"/>
                <p:nvPr/>
              </p:nvSpPr>
              <p:spPr>
                <a:xfrm>
                  <a:off x="2593768" y="5178424"/>
                  <a:ext cx="634954" cy="2618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R-</a:t>
                  </a:r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V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7937192C-8878-40D1-94A4-499BA7CDE7F5}"/>
                    </a:ext>
                  </a:extLst>
                </p:cNvPr>
                <p:cNvSpPr txBox="1"/>
                <p:nvPr/>
              </p:nvSpPr>
              <p:spPr>
                <a:xfrm>
                  <a:off x="1409678" y="5169196"/>
                  <a:ext cx="476347" cy="2618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V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16355AE-F360-4AD1-98E1-0DA1ADE4C58F}"/>
                  </a:ext>
                </a:extLst>
              </p:cNvPr>
              <p:cNvSpPr txBox="1"/>
              <p:nvPr/>
            </p:nvSpPr>
            <p:spPr>
              <a:xfrm>
                <a:off x="277702" y="4877314"/>
                <a:ext cx="812682" cy="3273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E)</a:t>
                </a:r>
              </a:p>
            </p:txBody>
          </p: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A3C8A61-5F7A-4985-8988-9A8AD0F7F224}"/>
                </a:ext>
              </a:extLst>
            </p:cNvPr>
            <p:cNvSpPr txBox="1"/>
            <p:nvPr/>
          </p:nvSpPr>
          <p:spPr>
            <a:xfrm rot="16200000">
              <a:off x="313551" y="5572901"/>
              <a:ext cx="532996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E8AE8DDA-1703-4634-A9BA-38D17ACDF66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7920" y="5270579"/>
              <a:ext cx="0" cy="86932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49452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7679</TotalTime>
  <Words>1767</Words>
  <Application>Microsoft Office PowerPoint</Application>
  <PresentationFormat>Custom</PresentationFormat>
  <Paragraphs>190</Paragraphs>
  <Slides>9</Slides>
  <Notes>8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9</vt:lpstr>
      <vt:lpstr>Radiation Induces ESCRT-pathway Mediated CD44v3+ Extracellular Vesicle Production Stimulating Pro-Tumor Fibroblast Activity in Breast Cancer- Supple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e Clark</dc:creator>
  <cp:lastModifiedBy>Gene Clark</cp:lastModifiedBy>
  <cp:revision>767</cp:revision>
  <dcterms:created xsi:type="dcterms:W3CDTF">2021-04-29T17:50:43Z</dcterms:created>
  <dcterms:modified xsi:type="dcterms:W3CDTF">2022-07-20T15:06:29Z</dcterms:modified>
</cp:coreProperties>
</file>